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3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4958" autoAdjust="0"/>
  </p:normalViewPr>
  <p:slideViewPr>
    <p:cSldViewPr>
      <p:cViewPr>
        <p:scale>
          <a:sx n="100" d="100"/>
          <a:sy n="100" d="100"/>
        </p:scale>
        <p:origin x="-267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52A397-EF6F-4D69-A79D-76BFD6401429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8FED78-2406-49FA-B34C-C2669110F7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1033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563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5410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0041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293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0085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171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3336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055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1562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0705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8206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D25A3-1994-4C7F-A6A4-40884765A6F7}" type="datetimeFigureOut">
              <a:rPr lang="de-DE" smtClean="0"/>
              <a:t>28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C1959-67AD-4753-8217-9EDC1AD5A1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113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908720" y="2099134"/>
            <a:ext cx="5164542" cy="2536672"/>
            <a:chOff x="513947" y="597053"/>
            <a:chExt cx="5164542" cy="2536672"/>
          </a:xfrm>
        </p:grpSpPr>
        <p:sp>
          <p:nvSpPr>
            <p:cNvPr id="7" name="Textfeld 6"/>
            <p:cNvSpPr txBox="1"/>
            <p:nvPr/>
          </p:nvSpPr>
          <p:spPr>
            <a:xfrm>
              <a:off x="513947" y="597053"/>
              <a:ext cx="47105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be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ts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ssociated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arly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etastasis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Freeform 5"/>
            <p:cNvSpPr>
              <a:spLocks/>
            </p:cNvSpPr>
            <p:nvPr/>
          </p:nvSpPr>
          <p:spPr bwMode="auto">
            <a:xfrm>
              <a:off x="1277938" y="1385888"/>
              <a:ext cx="968375" cy="971550"/>
            </a:xfrm>
            <a:custGeom>
              <a:avLst/>
              <a:gdLst>
                <a:gd name="T0" fmla="*/ 200 w 200"/>
                <a:gd name="T1" fmla="*/ 92 h 201"/>
                <a:gd name="T2" fmla="*/ 198 w 200"/>
                <a:gd name="T3" fmla="*/ 81 h 201"/>
                <a:gd name="T4" fmla="*/ 196 w 200"/>
                <a:gd name="T5" fmla="*/ 71 h 201"/>
                <a:gd name="T6" fmla="*/ 192 w 200"/>
                <a:gd name="T7" fmla="*/ 61 h 201"/>
                <a:gd name="T8" fmla="*/ 188 w 200"/>
                <a:gd name="T9" fmla="*/ 52 h 201"/>
                <a:gd name="T10" fmla="*/ 182 w 200"/>
                <a:gd name="T11" fmla="*/ 43 h 201"/>
                <a:gd name="T12" fmla="*/ 176 w 200"/>
                <a:gd name="T13" fmla="*/ 35 h 201"/>
                <a:gd name="T14" fmla="*/ 168 w 200"/>
                <a:gd name="T15" fmla="*/ 27 h 201"/>
                <a:gd name="T16" fmla="*/ 160 w 200"/>
                <a:gd name="T17" fmla="*/ 20 h 201"/>
                <a:gd name="T18" fmla="*/ 152 w 200"/>
                <a:gd name="T19" fmla="*/ 15 h 201"/>
                <a:gd name="T20" fmla="*/ 142 w 200"/>
                <a:gd name="T21" fmla="*/ 10 h 201"/>
                <a:gd name="T22" fmla="*/ 133 w 200"/>
                <a:gd name="T23" fmla="*/ 6 h 201"/>
                <a:gd name="T24" fmla="*/ 123 w 200"/>
                <a:gd name="T25" fmla="*/ 3 h 201"/>
                <a:gd name="T26" fmla="*/ 112 w 200"/>
                <a:gd name="T27" fmla="*/ 1 h 201"/>
                <a:gd name="T28" fmla="*/ 102 w 200"/>
                <a:gd name="T29" fmla="*/ 0 h 201"/>
                <a:gd name="T30" fmla="*/ 91 w 200"/>
                <a:gd name="T31" fmla="*/ 1 h 201"/>
                <a:gd name="T32" fmla="*/ 81 w 200"/>
                <a:gd name="T33" fmla="*/ 2 h 201"/>
                <a:gd name="T34" fmla="*/ 71 w 200"/>
                <a:gd name="T35" fmla="*/ 5 h 201"/>
                <a:gd name="T36" fmla="*/ 61 w 200"/>
                <a:gd name="T37" fmla="*/ 8 h 201"/>
                <a:gd name="T38" fmla="*/ 52 w 200"/>
                <a:gd name="T39" fmla="*/ 13 h 201"/>
                <a:gd name="T40" fmla="*/ 43 w 200"/>
                <a:gd name="T41" fmla="*/ 18 h 201"/>
                <a:gd name="T42" fmla="*/ 34 w 200"/>
                <a:gd name="T43" fmla="*/ 25 h 201"/>
                <a:gd name="T44" fmla="*/ 27 w 200"/>
                <a:gd name="T45" fmla="*/ 32 h 201"/>
                <a:gd name="T46" fmla="*/ 20 w 200"/>
                <a:gd name="T47" fmla="*/ 40 h 201"/>
                <a:gd name="T48" fmla="*/ 14 w 200"/>
                <a:gd name="T49" fmla="*/ 49 h 201"/>
                <a:gd name="T50" fmla="*/ 9 w 200"/>
                <a:gd name="T51" fmla="*/ 58 h 201"/>
                <a:gd name="T52" fmla="*/ 5 w 200"/>
                <a:gd name="T53" fmla="*/ 68 h 201"/>
                <a:gd name="T54" fmla="*/ 3 w 200"/>
                <a:gd name="T55" fmla="*/ 78 h 201"/>
                <a:gd name="T56" fmla="*/ 1 w 200"/>
                <a:gd name="T57" fmla="*/ 88 h 201"/>
                <a:gd name="T58" fmla="*/ 0 w 200"/>
                <a:gd name="T59" fmla="*/ 99 h 201"/>
                <a:gd name="T60" fmla="*/ 0 w 200"/>
                <a:gd name="T61" fmla="*/ 109 h 201"/>
                <a:gd name="T62" fmla="*/ 2 w 200"/>
                <a:gd name="T63" fmla="*/ 120 h 201"/>
                <a:gd name="T64" fmla="*/ 4 w 200"/>
                <a:gd name="T65" fmla="*/ 130 h 201"/>
                <a:gd name="T66" fmla="*/ 8 w 200"/>
                <a:gd name="T67" fmla="*/ 140 h 201"/>
                <a:gd name="T68" fmla="*/ 12 w 200"/>
                <a:gd name="T69" fmla="*/ 149 h 201"/>
                <a:gd name="T70" fmla="*/ 18 w 200"/>
                <a:gd name="T71" fmla="*/ 158 h 201"/>
                <a:gd name="T72" fmla="*/ 24 w 200"/>
                <a:gd name="T73" fmla="*/ 166 h 201"/>
                <a:gd name="T74" fmla="*/ 32 w 200"/>
                <a:gd name="T75" fmla="*/ 174 h 201"/>
                <a:gd name="T76" fmla="*/ 40 w 200"/>
                <a:gd name="T77" fmla="*/ 180 h 201"/>
                <a:gd name="T78" fmla="*/ 48 w 200"/>
                <a:gd name="T79" fmla="*/ 186 h 201"/>
                <a:gd name="T80" fmla="*/ 58 w 200"/>
                <a:gd name="T81" fmla="*/ 191 h 201"/>
                <a:gd name="T82" fmla="*/ 67 w 200"/>
                <a:gd name="T83" fmla="*/ 195 h 201"/>
                <a:gd name="T84" fmla="*/ 78 w 200"/>
                <a:gd name="T85" fmla="*/ 198 h 201"/>
                <a:gd name="T86" fmla="*/ 88 w 200"/>
                <a:gd name="T87" fmla="*/ 200 h 201"/>
                <a:gd name="T88" fmla="*/ 98 w 200"/>
                <a:gd name="T89" fmla="*/ 201 h 201"/>
                <a:gd name="T90" fmla="*/ 109 w 200"/>
                <a:gd name="T91" fmla="*/ 200 h 201"/>
                <a:gd name="T92" fmla="*/ 119 w 200"/>
                <a:gd name="T93" fmla="*/ 199 h 201"/>
                <a:gd name="T94" fmla="*/ 129 w 200"/>
                <a:gd name="T95" fmla="*/ 196 h 201"/>
                <a:gd name="T96" fmla="*/ 139 w 200"/>
                <a:gd name="T97" fmla="*/ 193 h 201"/>
                <a:gd name="T98" fmla="*/ 149 w 200"/>
                <a:gd name="T99" fmla="*/ 188 h 201"/>
                <a:gd name="T100" fmla="*/ 157 w 200"/>
                <a:gd name="T101" fmla="*/ 183 h 201"/>
                <a:gd name="T102" fmla="*/ 166 w 200"/>
                <a:gd name="T103" fmla="*/ 176 h 201"/>
                <a:gd name="T104" fmla="*/ 173 w 200"/>
                <a:gd name="T105" fmla="*/ 169 h 201"/>
                <a:gd name="T106" fmla="*/ 180 w 200"/>
                <a:gd name="T107" fmla="*/ 161 h 201"/>
                <a:gd name="T108" fmla="*/ 186 w 200"/>
                <a:gd name="T109" fmla="*/ 152 h 201"/>
                <a:gd name="T110" fmla="*/ 191 w 200"/>
                <a:gd name="T111" fmla="*/ 143 h 201"/>
                <a:gd name="T112" fmla="*/ 195 w 200"/>
                <a:gd name="T113" fmla="*/ 133 h 201"/>
                <a:gd name="T114" fmla="*/ 198 w 200"/>
                <a:gd name="T115" fmla="*/ 123 h 201"/>
                <a:gd name="T116" fmla="*/ 199 w 200"/>
                <a:gd name="T117" fmla="*/ 113 h 201"/>
                <a:gd name="T118" fmla="*/ 200 w 200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1">
                  <a:moveTo>
                    <a:pt x="200" y="100"/>
                  </a:moveTo>
                  <a:lnTo>
                    <a:pt x="200" y="99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199" y="88"/>
                  </a:lnTo>
                  <a:lnTo>
                    <a:pt x="199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7" y="76"/>
                  </a:lnTo>
                  <a:lnTo>
                    <a:pt x="197" y="75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3" y="65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4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3" y="15"/>
                  </a:lnTo>
                  <a:lnTo>
                    <a:pt x="152" y="15"/>
                  </a:lnTo>
                  <a:lnTo>
                    <a:pt x="150" y="14"/>
                  </a:lnTo>
                  <a:lnTo>
                    <a:pt x="149" y="13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10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29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4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4" y="4"/>
                  </a:lnTo>
                  <a:lnTo>
                    <a:pt x="72" y="4"/>
                  </a:lnTo>
                  <a:lnTo>
                    <a:pt x="71" y="5"/>
                  </a:lnTo>
                  <a:lnTo>
                    <a:pt x="69" y="5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8" y="10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8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0" y="28"/>
                  </a:lnTo>
                  <a:lnTo>
                    <a:pt x="29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4" y="35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9"/>
                  </a:lnTo>
                  <a:lnTo>
                    <a:pt x="20" y="40"/>
                  </a:lnTo>
                  <a:lnTo>
                    <a:pt x="19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7"/>
                  </a:lnTo>
                  <a:lnTo>
                    <a:pt x="9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2" y="80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0" y="90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30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9" y="143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2" y="149"/>
                  </a:lnTo>
                  <a:lnTo>
                    <a:pt x="13" y="151"/>
                  </a:lnTo>
                  <a:lnTo>
                    <a:pt x="14" y="152"/>
                  </a:lnTo>
                  <a:lnTo>
                    <a:pt x="15" y="154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1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3"/>
                  </a:lnTo>
                  <a:lnTo>
                    <a:pt x="32" y="174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3"/>
                  </a:lnTo>
                  <a:lnTo>
                    <a:pt x="44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59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4" y="194"/>
                  </a:lnTo>
                  <a:lnTo>
                    <a:pt x="66" y="195"/>
                  </a:lnTo>
                  <a:lnTo>
                    <a:pt x="67" y="195"/>
                  </a:lnTo>
                  <a:lnTo>
                    <a:pt x="69" y="196"/>
                  </a:lnTo>
                  <a:lnTo>
                    <a:pt x="71" y="196"/>
                  </a:lnTo>
                  <a:lnTo>
                    <a:pt x="72" y="197"/>
                  </a:lnTo>
                  <a:lnTo>
                    <a:pt x="74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79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4" y="199"/>
                  </a:lnTo>
                  <a:lnTo>
                    <a:pt x="86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8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7" y="199"/>
                  </a:lnTo>
                  <a:lnTo>
                    <a:pt x="119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4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29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4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39" y="193"/>
                  </a:lnTo>
                  <a:lnTo>
                    <a:pt x="141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90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7" y="183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8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9"/>
                  </a:lnTo>
                  <a:lnTo>
                    <a:pt x="174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1" y="141"/>
                  </a:lnTo>
                  <a:lnTo>
                    <a:pt x="192" y="140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5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30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8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0" name="Rectangle 6"/>
            <p:cNvSpPr>
              <a:spLocks noChangeArrowheads="1"/>
            </p:cNvSpPr>
            <p:nvPr/>
          </p:nvSpPr>
          <p:spPr bwMode="auto">
            <a:xfrm>
              <a:off x="1379538" y="1227138"/>
              <a:ext cx="6381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otterdam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Freeform 7"/>
            <p:cNvSpPr>
              <a:spLocks/>
            </p:cNvSpPr>
            <p:nvPr/>
          </p:nvSpPr>
          <p:spPr bwMode="auto">
            <a:xfrm>
              <a:off x="1920876" y="1385888"/>
              <a:ext cx="973138" cy="971550"/>
            </a:xfrm>
            <a:custGeom>
              <a:avLst/>
              <a:gdLst>
                <a:gd name="T0" fmla="*/ 200 w 201"/>
                <a:gd name="T1" fmla="*/ 92 h 201"/>
                <a:gd name="T2" fmla="*/ 199 w 201"/>
                <a:gd name="T3" fmla="*/ 81 h 201"/>
                <a:gd name="T4" fmla="*/ 196 w 201"/>
                <a:gd name="T5" fmla="*/ 71 h 201"/>
                <a:gd name="T6" fmla="*/ 193 w 201"/>
                <a:gd name="T7" fmla="*/ 61 h 201"/>
                <a:gd name="T8" fmla="*/ 188 w 201"/>
                <a:gd name="T9" fmla="*/ 52 h 201"/>
                <a:gd name="T10" fmla="*/ 182 w 201"/>
                <a:gd name="T11" fmla="*/ 43 h 201"/>
                <a:gd name="T12" fmla="*/ 176 w 201"/>
                <a:gd name="T13" fmla="*/ 35 h 201"/>
                <a:gd name="T14" fmla="*/ 169 w 201"/>
                <a:gd name="T15" fmla="*/ 27 h 201"/>
                <a:gd name="T16" fmla="*/ 161 w 201"/>
                <a:gd name="T17" fmla="*/ 20 h 201"/>
                <a:gd name="T18" fmla="*/ 152 w 201"/>
                <a:gd name="T19" fmla="*/ 15 h 201"/>
                <a:gd name="T20" fmla="*/ 143 w 201"/>
                <a:gd name="T21" fmla="*/ 10 h 201"/>
                <a:gd name="T22" fmla="*/ 133 w 201"/>
                <a:gd name="T23" fmla="*/ 6 h 201"/>
                <a:gd name="T24" fmla="*/ 123 w 201"/>
                <a:gd name="T25" fmla="*/ 3 h 201"/>
                <a:gd name="T26" fmla="*/ 113 w 201"/>
                <a:gd name="T27" fmla="*/ 1 h 201"/>
                <a:gd name="T28" fmla="*/ 102 w 201"/>
                <a:gd name="T29" fmla="*/ 0 h 201"/>
                <a:gd name="T30" fmla="*/ 92 w 201"/>
                <a:gd name="T31" fmla="*/ 1 h 201"/>
                <a:gd name="T32" fmla="*/ 81 w 201"/>
                <a:gd name="T33" fmla="*/ 2 h 201"/>
                <a:gd name="T34" fmla="*/ 71 w 201"/>
                <a:gd name="T35" fmla="*/ 5 h 201"/>
                <a:gd name="T36" fmla="*/ 61 w 201"/>
                <a:gd name="T37" fmla="*/ 8 h 201"/>
                <a:gd name="T38" fmla="*/ 52 w 201"/>
                <a:gd name="T39" fmla="*/ 13 h 201"/>
                <a:gd name="T40" fmla="*/ 43 w 201"/>
                <a:gd name="T41" fmla="*/ 18 h 201"/>
                <a:gd name="T42" fmla="*/ 35 w 201"/>
                <a:gd name="T43" fmla="*/ 25 h 201"/>
                <a:gd name="T44" fmla="*/ 27 w 201"/>
                <a:gd name="T45" fmla="*/ 32 h 201"/>
                <a:gd name="T46" fmla="*/ 21 w 201"/>
                <a:gd name="T47" fmla="*/ 40 h 201"/>
                <a:gd name="T48" fmla="*/ 15 w 201"/>
                <a:gd name="T49" fmla="*/ 49 h 201"/>
                <a:gd name="T50" fmla="*/ 10 w 201"/>
                <a:gd name="T51" fmla="*/ 58 h 201"/>
                <a:gd name="T52" fmla="*/ 6 w 201"/>
                <a:gd name="T53" fmla="*/ 68 h 201"/>
                <a:gd name="T54" fmla="*/ 3 w 201"/>
                <a:gd name="T55" fmla="*/ 78 h 201"/>
                <a:gd name="T56" fmla="*/ 1 w 201"/>
                <a:gd name="T57" fmla="*/ 88 h 201"/>
                <a:gd name="T58" fmla="*/ 0 w 201"/>
                <a:gd name="T59" fmla="*/ 99 h 201"/>
                <a:gd name="T60" fmla="*/ 1 w 201"/>
                <a:gd name="T61" fmla="*/ 109 h 201"/>
                <a:gd name="T62" fmla="*/ 2 w 201"/>
                <a:gd name="T63" fmla="*/ 120 h 201"/>
                <a:gd name="T64" fmla="*/ 5 w 201"/>
                <a:gd name="T65" fmla="*/ 130 h 201"/>
                <a:gd name="T66" fmla="*/ 8 w 201"/>
                <a:gd name="T67" fmla="*/ 140 h 201"/>
                <a:gd name="T68" fmla="*/ 13 w 201"/>
                <a:gd name="T69" fmla="*/ 149 h 201"/>
                <a:gd name="T70" fmla="*/ 18 w 201"/>
                <a:gd name="T71" fmla="*/ 158 h 201"/>
                <a:gd name="T72" fmla="*/ 25 w 201"/>
                <a:gd name="T73" fmla="*/ 166 h 201"/>
                <a:gd name="T74" fmla="*/ 32 w 201"/>
                <a:gd name="T75" fmla="*/ 174 h 201"/>
                <a:gd name="T76" fmla="*/ 40 w 201"/>
                <a:gd name="T77" fmla="*/ 180 h 201"/>
                <a:gd name="T78" fmla="*/ 49 w 201"/>
                <a:gd name="T79" fmla="*/ 186 h 201"/>
                <a:gd name="T80" fmla="*/ 58 w 201"/>
                <a:gd name="T81" fmla="*/ 191 h 201"/>
                <a:gd name="T82" fmla="*/ 68 w 201"/>
                <a:gd name="T83" fmla="*/ 195 h 201"/>
                <a:gd name="T84" fmla="*/ 78 w 201"/>
                <a:gd name="T85" fmla="*/ 198 h 201"/>
                <a:gd name="T86" fmla="*/ 88 w 201"/>
                <a:gd name="T87" fmla="*/ 200 h 201"/>
                <a:gd name="T88" fmla="*/ 99 w 201"/>
                <a:gd name="T89" fmla="*/ 201 h 201"/>
                <a:gd name="T90" fmla="*/ 109 w 201"/>
                <a:gd name="T91" fmla="*/ 200 h 201"/>
                <a:gd name="T92" fmla="*/ 120 w 201"/>
                <a:gd name="T93" fmla="*/ 199 h 201"/>
                <a:gd name="T94" fmla="*/ 130 w 201"/>
                <a:gd name="T95" fmla="*/ 196 h 201"/>
                <a:gd name="T96" fmla="*/ 140 w 201"/>
                <a:gd name="T97" fmla="*/ 193 h 201"/>
                <a:gd name="T98" fmla="*/ 149 w 201"/>
                <a:gd name="T99" fmla="*/ 188 h 201"/>
                <a:gd name="T100" fmla="*/ 158 w 201"/>
                <a:gd name="T101" fmla="*/ 183 h 201"/>
                <a:gd name="T102" fmla="*/ 166 w 201"/>
                <a:gd name="T103" fmla="*/ 176 h 201"/>
                <a:gd name="T104" fmla="*/ 174 w 201"/>
                <a:gd name="T105" fmla="*/ 169 h 201"/>
                <a:gd name="T106" fmla="*/ 180 w 201"/>
                <a:gd name="T107" fmla="*/ 161 h 201"/>
                <a:gd name="T108" fmla="*/ 186 w 201"/>
                <a:gd name="T109" fmla="*/ 152 h 201"/>
                <a:gd name="T110" fmla="*/ 191 w 201"/>
                <a:gd name="T111" fmla="*/ 143 h 201"/>
                <a:gd name="T112" fmla="*/ 195 w 201"/>
                <a:gd name="T113" fmla="*/ 133 h 201"/>
                <a:gd name="T114" fmla="*/ 198 w 201"/>
                <a:gd name="T115" fmla="*/ 123 h 201"/>
                <a:gd name="T116" fmla="*/ 200 w 201"/>
                <a:gd name="T117" fmla="*/ 113 h 201"/>
                <a:gd name="T118" fmla="*/ 201 w 201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1" h="201">
                  <a:moveTo>
                    <a:pt x="201" y="100"/>
                  </a:moveTo>
                  <a:lnTo>
                    <a:pt x="201" y="99"/>
                  </a:lnTo>
                  <a:lnTo>
                    <a:pt x="201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200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9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8" y="76"/>
                  </a:lnTo>
                  <a:lnTo>
                    <a:pt x="197" y="75"/>
                  </a:lnTo>
                  <a:lnTo>
                    <a:pt x="197" y="73"/>
                  </a:lnTo>
                  <a:lnTo>
                    <a:pt x="196" y="71"/>
                  </a:lnTo>
                  <a:lnTo>
                    <a:pt x="196" y="69"/>
                  </a:lnTo>
                  <a:lnTo>
                    <a:pt x="195" y="68"/>
                  </a:lnTo>
                  <a:lnTo>
                    <a:pt x="195" y="66"/>
                  </a:lnTo>
                  <a:lnTo>
                    <a:pt x="194" y="65"/>
                  </a:lnTo>
                  <a:lnTo>
                    <a:pt x="193" y="63"/>
                  </a:lnTo>
                  <a:lnTo>
                    <a:pt x="193" y="61"/>
                  </a:lnTo>
                  <a:lnTo>
                    <a:pt x="192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90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5" y="33"/>
                  </a:lnTo>
                  <a:lnTo>
                    <a:pt x="174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1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4" y="15"/>
                  </a:lnTo>
                  <a:lnTo>
                    <a:pt x="152" y="15"/>
                  </a:lnTo>
                  <a:lnTo>
                    <a:pt x="151" y="14"/>
                  </a:lnTo>
                  <a:lnTo>
                    <a:pt x="149" y="13"/>
                  </a:lnTo>
                  <a:lnTo>
                    <a:pt x="147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10"/>
                  </a:lnTo>
                  <a:lnTo>
                    <a:pt x="141" y="9"/>
                  </a:lnTo>
                  <a:lnTo>
                    <a:pt x="140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5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30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5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20" y="2"/>
                  </a:lnTo>
                  <a:lnTo>
                    <a:pt x="118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3" y="1"/>
                  </a:lnTo>
                  <a:lnTo>
                    <a:pt x="111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6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2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5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5" y="4"/>
                  </a:lnTo>
                  <a:lnTo>
                    <a:pt x="73" y="4"/>
                  </a:lnTo>
                  <a:lnTo>
                    <a:pt x="71" y="5"/>
                  </a:lnTo>
                  <a:lnTo>
                    <a:pt x="70" y="5"/>
                  </a:lnTo>
                  <a:lnTo>
                    <a:pt x="68" y="6"/>
                  </a:lnTo>
                  <a:lnTo>
                    <a:pt x="66" y="6"/>
                  </a:lnTo>
                  <a:lnTo>
                    <a:pt x="65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10"/>
                  </a:lnTo>
                  <a:lnTo>
                    <a:pt x="57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9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5" y="17"/>
                  </a:lnTo>
                  <a:lnTo>
                    <a:pt x="43" y="18"/>
                  </a:lnTo>
                  <a:lnTo>
                    <a:pt x="42" y="19"/>
                  </a:lnTo>
                  <a:lnTo>
                    <a:pt x="40" y="20"/>
                  </a:lnTo>
                  <a:lnTo>
                    <a:pt x="39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5" y="25"/>
                  </a:lnTo>
                  <a:lnTo>
                    <a:pt x="34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30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5"/>
                  </a:lnTo>
                  <a:lnTo>
                    <a:pt x="24" y="36"/>
                  </a:lnTo>
                  <a:lnTo>
                    <a:pt x="23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0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7" y="46"/>
                  </a:lnTo>
                  <a:lnTo>
                    <a:pt x="16" y="47"/>
                  </a:lnTo>
                  <a:lnTo>
                    <a:pt x="15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1" y="57"/>
                  </a:lnTo>
                  <a:lnTo>
                    <a:pt x="10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8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3" y="80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2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1" y="106"/>
                  </a:lnTo>
                  <a:lnTo>
                    <a:pt x="1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2" y="116"/>
                  </a:lnTo>
                  <a:lnTo>
                    <a:pt x="2" y="118"/>
                  </a:lnTo>
                  <a:lnTo>
                    <a:pt x="2" y="120"/>
                  </a:lnTo>
                  <a:lnTo>
                    <a:pt x="3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30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8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10" y="143"/>
                  </a:lnTo>
                  <a:lnTo>
                    <a:pt x="11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1"/>
                  </a:lnTo>
                  <a:lnTo>
                    <a:pt x="15" y="152"/>
                  </a:lnTo>
                  <a:lnTo>
                    <a:pt x="16" y="154"/>
                  </a:lnTo>
                  <a:lnTo>
                    <a:pt x="17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20" y="159"/>
                  </a:lnTo>
                  <a:lnTo>
                    <a:pt x="21" y="161"/>
                  </a:lnTo>
                  <a:lnTo>
                    <a:pt x="22" y="162"/>
                  </a:lnTo>
                  <a:lnTo>
                    <a:pt x="23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30" y="171"/>
                  </a:lnTo>
                  <a:lnTo>
                    <a:pt x="31" y="173"/>
                  </a:lnTo>
                  <a:lnTo>
                    <a:pt x="32" y="174"/>
                  </a:lnTo>
                  <a:lnTo>
                    <a:pt x="34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2" y="181"/>
                  </a:lnTo>
                  <a:lnTo>
                    <a:pt x="43" y="183"/>
                  </a:lnTo>
                  <a:lnTo>
                    <a:pt x="45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7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5" y="194"/>
                  </a:lnTo>
                  <a:lnTo>
                    <a:pt x="66" y="195"/>
                  </a:lnTo>
                  <a:lnTo>
                    <a:pt x="68" y="195"/>
                  </a:lnTo>
                  <a:lnTo>
                    <a:pt x="70" y="196"/>
                  </a:lnTo>
                  <a:lnTo>
                    <a:pt x="71" y="196"/>
                  </a:lnTo>
                  <a:lnTo>
                    <a:pt x="73" y="197"/>
                  </a:lnTo>
                  <a:lnTo>
                    <a:pt x="75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80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7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9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6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3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20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5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30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5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40" y="193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90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1" y="187"/>
                  </a:lnTo>
                  <a:lnTo>
                    <a:pt x="152" y="186"/>
                  </a:lnTo>
                  <a:lnTo>
                    <a:pt x="154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3"/>
                  </a:lnTo>
                  <a:lnTo>
                    <a:pt x="159" y="181"/>
                  </a:lnTo>
                  <a:lnTo>
                    <a:pt x="161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4" y="169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90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2" y="141"/>
                  </a:lnTo>
                  <a:lnTo>
                    <a:pt x="193" y="140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5" y="135"/>
                  </a:lnTo>
                  <a:lnTo>
                    <a:pt x="195" y="133"/>
                  </a:lnTo>
                  <a:lnTo>
                    <a:pt x="196" y="131"/>
                  </a:lnTo>
                  <a:lnTo>
                    <a:pt x="196" y="130"/>
                  </a:lnTo>
                  <a:lnTo>
                    <a:pt x="197" y="128"/>
                  </a:lnTo>
                  <a:lnTo>
                    <a:pt x="197" y="126"/>
                  </a:lnTo>
                  <a:lnTo>
                    <a:pt x="198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9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200" y="114"/>
                  </a:lnTo>
                  <a:lnTo>
                    <a:pt x="200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1" y="104"/>
                  </a:lnTo>
                  <a:lnTo>
                    <a:pt x="201" y="102"/>
                  </a:lnTo>
                  <a:lnTo>
                    <a:pt x="201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2" name="Rectangle 8"/>
            <p:cNvSpPr>
              <a:spLocks noChangeArrowheads="1"/>
            </p:cNvSpPr>
            <p:nvPr/>
          </p:nvSpPr>
          <p:spPr bwMode="auto">
            <a:xfrm>
              <a:off x="2203451" y="1212850"/>
              <a:ext cx="5397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ansbig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Freeform 9"/>
            <p:cNvSpPr>
              <a:spLocks/>
            </p:cNvSpPr>
            <p:nvPr/>
          </p:nvSpPr>
          <p:spPr bwMode="auto">
            <a:xfrm>
              <a:off x="1603376" y="1946275"/>
              <a:ext cx="966788" cy="965200"/>
            </a:xfrm>
            <a:custGeom>
              <a:avLst/>
              <a:gdLst>
                <a:gd name="T0" fmla="*/ 199 w 200"/>
                <a:gd name="T1" fmla="*/ 91 h 200"/>
                <a:gd name="T2" fmla="*/ 198 w 200"/>
                <a:gd name="T3" fmla="*/ 81 h 200"/>
                <a:gd name="T4" fmla="*/ 195 w 200"/>
                <a:gd name="T5" fmla="*/ 71 h 200"/>
                <a:gd name="T6" fmla="*/ 192 w 200"/>
                <a:gd name="T7" fmla="*/ 61 h 200"/>
                <a:gd name="T8" fmla="*/ 187 w 200"/>
                <a:gd name="T9" fmla="*/ 52 h 200"/>
                <a:gd name="T10" fmla="*/ 182 w 200"/>
                <a:gd name="T11" fmla="*/ 43 h 200"/>
                <a:gd name="T12" fmla="*/ 175 w 200"/>
                <a:gd name="T13" fmla="*/ 34 h 200"/>
                <a:gd name="T14" fmla="*/ 168 w 200"/>
                <a:gd name="T15" fmla="*/ 27 h 200"/>
                <a:gd name="T16" fmla="*/ 160 w 200"/>
                <a:gd name="T17" fmla="*/ 20 h 200"/>
                <a:gd name="T18" fmla="*/ 151 w 200"/>
                <a:gd name="T19" fmla="*/ 14 h 200"/>
                <a:gd name="T20" fmla="*/ 142 w 200"/>
                <a:gd name="T21" fmla="*/ 9 h 200"/>
                <a:gd name="T22" fmla="*/ 132 w 200"/>
                <a:gd name="T23" fmla="*/ 5 h 200"/>
                <a:gd name="T24" fmla="*/ 122 w 200"/>
                <a:gd name="T25" fmla="*/ 3 h 200"/>
                <a:gd name="T26" fmla="*/ 112 w 200"/>
                <a:gd name="T27" fmla="*/ 1 h 200"/>
                <a:gd name="T28" fmla="*/ 101 w 200"/>
                <a:gd name="T29" fmla="*/ 0 h 200"/>
                <a:gd name="T30" fmla="*/ 91 w 200"/>
                <a:gd name="T31" fmla="*/ 0 h 200"/>
                <a:gd name="T32" fmla="*/ 81 w 200"/>
                <a:gd name="T33" fmla="*/ 2 h 200"/>
                <a:gd name="T34" fmla="*/ 70 w 200"/>
                <a:gd name="T35" fmla="*/ 4 h 200"/>
                <a:gd name="T36" fmla="*/ 61 w 200"/>
                <a:gd name="T37" fmla="*/ 8 h 200"/>
                <a:gd name="T38" fmla="*/ 51 w 200"/>
                <a:gd name="T39" fmla="*/ 12 h 200"/>
                <a:gd name="T40" fmla="*/ 42 w 200"/>
                <a:gd name="T41" fmla="*/ 18 h 200"/>
                <a:gd name="T42" fmla="*/ 34 w 200"/>
                <a:gd name="T43" fmla="*/ 25 h 200"/>
                <a:gd name="T44" fmla="*/ 27 w 200"/>
                <a:gd name="T45" fmla="*/ 32 h 200"/>
                <a:gd name="T46" fmla="*/ 20 w 200"/>
                <a:gd name="T47" fmla="*/ 40 h 200"/>
                <a:gd name="T48" fmla="*/ 14 w 200"/>
                <a:gd name="T49" fmla="*/ 49 h 200"/>
                <a:gd name="T50" fmla="*/ 9 w 200"/>
                <a:gd name="T51" fmla="*/ 58 h 200"/>
                <a:gd name="T52" fmla="*/ 5 w 200"/>
                <a:gd name="T53" fmla="*/ 68 h 200"/>
                <a:gd name="T54" fmla="*/ 2 w 200"/>
                <a:gd name="T55" fmla="*/ 78 h 200"/>
                <a:gd name="T56" fmla="*/ 0 w 200"/>
                <a:gd name="T57" fmla="*/ 88 h 200"/>
                <a:gd name="T58" fmla="*/ 0 w 200"/>
                <a:gd name="T59" fmla="*/ 98 h 200"/>
                <a:gd name="T60" fmla="*/ 0 w 200"/>
                <a:gd name="T61" fmla="*/ 109 h 200"/>
                <a:gd name="T62" fmla="*/ 2 w 200"/>
                <a:gd name="T63" fmla="*/ 119 h 200"/>
                <a:gd name="T64" fmla="*/ 4 w 200"/>
                <a:gd name="T65" fmla="*/ 129 h 200"/>
                <a:gd name="T66" fmla="*/ 8 w 200"/>
                <a:gd name="T67" fmla="*/ 139 h 200"/>
                <a:gd name="T68" fmla="*/ 12 w 200"/>
                <a:gd name="T69" fmla="*/ 149 h 200"/>
                <a:gd name="T70" fmla="*/ 18 w 200"/>
                <a:gd name="T71" fmla="*/ 158 h 200"/>
                <a:gd name="T72" fmla="*/ 24 w 200"/>
                <a:gd name="T73" fmla="*/ 166 h 200"/>
                <a:gd name="T74" fmla="*/ 31 w 200"/>
                <a:gd name="T75" fmla="*/ 173 h 200"/>
                <a:gd name="T76" fmla="*/ 40 w 200"/>
                <a:gd name="T77" fmla="*/ 180 h 200"/>
                <a:gd name="T78" fmla="*/ 48 w 200"/>
                <a:gd name="T79" fmla="*/ 186 h 200"/>
                <a:gd name="T80" fmla="*/ 57 w 200"/>
                <a:gd name="T81" fmla="*/ 191 h 200"/>
                <a:gd name="T82" fmla="*/ 67 w 200"/>
                <a:gd name="T83" fmla="*/ 195 h 200"/>
                <a:gd name="T84" fmla="*/ 77 w 200"/>
                <a:gd name="T85" fmla="*/ 198 h 200"/>
                <a:gd name="T86" fmla="*/ 88 w 200"/>
                <a:gd name="T87" fmla="*/ 200 h 200"/>
                <a:gd name="T88" fmla="*/ 98 w 200"/>
                <a:gd name="T89" fmla="*/ 200 h 200"/>
                <a:gd name="T90" fmla="*/ 108 w 200"/>
                <a:gd name="T91" fmla="*/ 200 h 200"/>
                <a:gd name="T92" fmla="*/ 119 w 200"/>
                <a:gd name="T93" fmla="*/ 198 h 200"/>
                <a:gd name="T94" fmla="*/ 129 w 200"/>
                <a:gd name="T95" fmla="*/ 196 h 200"/>
                <a:gd name="T96" fmla="*/ 139 w 200"/>
                <a:gd name="T97" fmla="*/ 192 h 200"/>
                <a:gd name="T98" fmla="*/ 148 w 200"/>
                <a:gd name="T99" fmla="*/ 188 h 200"/>
                <a:gd name="T100" fmla="*/ 157 w 200"/>
                <a:gd name="T101" fmla="*/ 182 h 200"/>
                <a:gd name="T102" fmla="*/ 165 w 200"/>
                <a:gd name="T103" fmla="*/ 176 h 200"/>
                <a:gd name="T104" fmla="*/ 173 w 200"/>
                <a:gd name="T105" fmla="*/ 168 h 200"/>
                <a:gd name="T106" fmla="*/ 180 w 200"/>
                <a:gd name="T107" fmla="*/ 160 h 200"/>
                <a:gd name="T108" fmla="*/ 186 w 200"/>
                <a:gd name="T109" fmla="*/ 152 h 200"/>
                <a:gd name="T110" fmla="*/ 190 w 200"/>
                <a:gd name="T111" fmla="*/ 142 h 200"/>
                <a:gd name="T112" fmla="*/ 194 w 200"/>
                <a:gd name="T113" fmla="*/ 133 h 200"/>
                <a:gd name="T114" fmla="*/ 197 w 200"/>
                <a:gd name="T115" fmla="*/ 123 h 200"/>
                <a:gd name="T116" fmla="*/ 199 w 200"/>
                <a:gd name="T117" fmla="*/ 112 h 200"/>
                <a:gd name="T118" fmla="*/ 200 w 200"/>
                <a:gd name="T119" fmla="*/ 102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0">
                  <a:moveTo>
                    <a:pt x="200" y="100"/>
                  </a:moveTo>
                  <a:lnTo>
                    <a:pt x="200" y="98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199" y="91"/>
                  </a:lnTo>
                  <a:lnTo>
                    <a:pt x="199" y="90"/>
                  </a:lnTo>
                  <a:lnTo>
                    <a:pt x="199" y="88"/>
                  </a:lnTo>
                  <a:lnTo>
                    <a:pt x="199" y="86"/>
                  </a:lnTo>
                  <a:lnTo>
                    <a:pt x="199" y="84"/>
                  </a:lnTo>
                  <a:lnTo>
                    <a:pt x="198" y="83"/>
                  </a:lnTo>
                  <a:lnTo>
                    <a:pt x="198" y="81"/>
                  </a:lnTo>
                  <a:lnTo>
                    <a:pt x="198" y="79"/>
                  </a:lnTo>
                  <a:lnTo>
                    <a:pt x="197" y="78"/>
                  </a:lnTo>
                  <a:lnTo>
                    <a:pt x="197" y="76"/>
                  </a:lnTo>
                  <a:lnTo>
                    <a:pt x="196" y="74"/>
                  </a:lnTo>
                  <a:lnTo>
                    <a:pt x="196" y="73"/>
                  </a:lnTo>
                  <a:lnTo>
                    <a:pt x="195" y="71"/>
                  </a:lnTo>
                  <a:lnTo>
                    <a:pt x="195" y="69"/>
                  </a:lnTo>
                  <a:lnTo>
                    <a:pt x="194" y="68"/>
                  </a:lnTo>
                  <a:lnTo>
                    <a:pt x="194" y="66"/>
                  </a:lnTo>
                  <a:lnTo>
                    <a:pt x="193" y="64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59"/>
                  </a:lnTo>
                  <a:lnTo>
                    <a:pt x="190" y="58"/>
                  </a:lnTo>
                  <a:lnTo>
                    <a:pt x="190" y="56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7" y="52"/>
                  </a:lnTo>
                  <a:lnTo>
                    <a:pt x="186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1"/>
                  </a:lnTo>
                  <a:lnTo>
                    <a:pt x="180" y="40"/>
                  </a:lnTo>
                  <a:lnTo>
                    <a:pt x="179" y="38"/>
                  </a:lnTo>
                  <a:lnTo>
                    <a:pt x="178" y="37"/>
                  </a:lnTo>
                  <a:lnTo>
                    <a:pt x="176" y="36"/>
                  </a:lnTo>
                  <a:lnTo>
                    <a:pt x="175" y="34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29"/>
                  </a:lnTo>
                  <a:lnTo>
                    <a:pt x="169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5" y="25"/>
                  </a:lnTo>
                  <a:lnTo>
                    <a:pt x="164" y="23"/>
                  </a:lnTo>
                  <a:lnTo>
                    <a:pt x="163" y="22"/>
                  </a:lnTo>
                  <a:lnTo>
                    <a:pt x="161" y="21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4" y="16"/>
                  </a:lnTo>
                  <a:lnTo>
                    <a:pt x="153" y="15"/>
                  </a:lnTo>
                  <a:lnTo>
                    <a:pt x="151" y="14"/>
                  </a:lnTo>
                  <a:lnTo>
                    <a:pt x="150" y="13"/>
                  </a:lnTo>
                  <a:lnTo>
                    <a:pt x="148" y="12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9"/>
                  </a:lnTo>
                  <a:lnTo>
                    <a:pt x="140" y="9"/>
                  </a:lnTo>
                  <a:lnTo>
                    <a:pt x="139" y="8"/>
                  </a:lnTo>
                  <a:lnTo>
                    <a:pt x="137" y="7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2" y="5"/>
                  </a:lnTo>
                  <a:lnTo>
                    <a:pt x="131" y="5"/>
                  </a:lnTo>
                  <a:lnTo>
                    <a:pt x="129" y="4"/>
                  </a:lnTo>
                  <a:lnTo>
                    <a:pt x="127" y="4"/>
                  </a:lnTo>
                  <a:lnTo>
                    <a:pt x="126" y="3"/>
                  </a:lnTo>
                  <a:lnTo>
                    <a:pt x="124" y="3"/>
                  </a:lnTo>
                  <a:lnTo>
                    <a:pt x="122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1"/>
                  </a:lnTo>
                  <a:lnTo>
                    <a:pt x="115" y="1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101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3" y="0"/>
                  </a:lnTo>
                  <a:lnTo>
                    <a:pt x="91" y="0"/>
                  </a:lnTo>
                  <a:lnTo>
                    <a:pt x="89" y="0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1"/>
                  </a:lnTo>
                  <a:lnTo>
                    <a:pt x="82" y="1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4" y="3"/>
                  </a:lnTo>
                  <a:lnTo>
                    <a:pt x="72" y="4"/>
                  </a:lnTo>
                  <a:lnTo>
                    <a:pt x="70" y="4"/>
                  </a:lnTo>
                  <a:lnTo>
                    <a:pt x="69" y="5"/>
                  </a:lnTo>
                  <a:lnTo>
                    <a:pt x="67" y="5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2" y="7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7" y="9"/>
                  </a:lnTo>
                  <a:lnTo>
                    <a:pt x="56" y="10"/>
                  </a:lnTo>
                  <a:lnTo>
                    <a:pt x="54" y="11"/>
                  </a:lnTo>
                  <a:lnTo>
                    <a:pt x="53" y="12"/>
                  </a:lnTo>
                  <a:lnTo>
                    <a:pt x="51" y="12"/>
                  </a:lnTo>
                  <a:lnTo>
                    <a:pt x="50" y="13"/>
                  </a:lnTo>
                  <a:lnTo>
                    <a:pt x="48" y="14"/>
                  </a:lnTo>
                  <a:lnTo>
                    <a:pt x="47" y="15"/>
                  </a:lnTo>
                  <a:lnTo>
                    <a:pt x="45" y="16"/>
                  </a:lnTo>
                  <a:lnTo>
                    <a:pt x="44" y="17"/>
                  </a:lnTo>
                  <a:lnTo>
                    <a:pt x="42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1"/>
                  </a:lnTo>
                  <a:lnTo>
                    <a:pt x="37" y="22"/>
                  </a:lnTo>
                  <a:lnTo>
                    <a:pt x="35" y="23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1" y="27"/>
                  </a:lnTo>
                  <a:lnTo>
                    <a:pt x="30" y="28"/>
                  </a:lnTo>
                  <a:lnTo>
                    <a:pt x="29" y="29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5" y="33"/>
                  </a:lnTo>
                  <a:lnTo>
                    <a:pt x="24" y="34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8"/>
                  </a:lnTo>
                  <a:lnTo>
                    <a:pt x="20" y="40"/>
                  </a:lnTo>
                  <a:lnTo>
                    <a:pt x="19" y="41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1" y="53"/>
                  </a:lnTo>
                  <a:lnTo>
                    <a:pt x="11" y="55"/>
                  </a:lnTo>
                  <a:lnTo>
                    <a:pt x="10" y="56"/>
                  </a:lnTo>
                  <a:lnTo>
                    <a:pt x="9" y="58"/>
                  </a:lnTo>
                  <a:lnTo>
                    <a:pt x="8" y="59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6" y="64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4"/>
                  </a:lnTo>
                  <a:lnTo>
                    <a:pt x="3" y="76"/>
                  </a:lnTo>
                  <a:lnTo>
                    <a:pt x="2" y="78"/>
                  </a:lnTo>
                  <a:lnTo>
                    <a:pt x="2" y="79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4"/>
                  </a:lnTo>
                  <a:lnTo>
                    <a:pt x="1" y="86"/>
                  </a:lnTo>
                  <a:lnTo>
                    <a:pt x="0" y="88"/>
                  </a:lnTo>
                  <a:lnTo>
                    <a:pt x="0" y="90"/>
                  </a:lnTo>
                  <a:lnTo>
                    <a:pt x="0" y="91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19"/>
                  </a:lnTo>
                  <a:lnTo>
                    <a:pt x="2" y="121"/>
                  </a:lnTo>
                  <a:lnTo>
                    <a:pt x="2" y="123"/>
                  </a:lnTo>
                  <a:lnTo>
                    <a:pt x="3" y="124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29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4"/>
                  </a:lnTo>
                  <a:lnTo>
                    <a:pt x="6" y="136"/>
                  </a:lnTo>
                  <a:lnTo>
                    <a:pt x="7" y="138"/>
                  </a:lnTo>
                  <a:lnTo>
                    <a:pt x="8" y="139"/>
                  </a:lnTo>
                  <a:lnTo>
                    <a:pt x="8" y="141"/>
                  </a:lnTo>
                  <a:lnTo>
                    <a:pt x="9" y="142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1" y="147"/>
                  </a:lnTo>
                  <a:lnTo>
                    <a:pt x="12" y="149"/>
                  </a:lnTo>
                  <a:lnTo>
                    <a:pt x="13" y="150"/>
                  </a:lnTo>
                  <a:lnTo>
                    <a:pt x="14" y="152"/>
                  </a:lnTo>
                  <a:lnTo>
                    <a:pt x="15" y="153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0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5" y="167"/>
                  </a:lnTo>
                  <a:lnTo>
                    <a:pt x="27" y="168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2"/>
                  </a:lnTo>
                  <a:lnTo>
                    <a:pt x="31" y="173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5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2" y="182"/>
                  </a:lnTo>
                  <a:lnTo>
                    <a:pt x="44" y="183"/>
                  </a:lnTo>
                  <a:lnTo>
                    <a:pt x="45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1" y="188"/>
                  </a:lnTo>
                  <a:lnTo>
                    <a:pt x="53" y="189"/>
                  </a:lnTo>
                  <a:lnTo>
                    <a:pt x="54" y="189"/>
                  </a:lnTo>
                  <a:lnTo>
                    <a:pt x="56" y="190"/>
                  </a:lnTo>
                  <a:lnTo>
                    <a:pt x="57" y="191"/>
                  </a:lnTo>
                  <a:lnTo>
                    <a:pt x="59" y="192"/>
                  </a:lnTo>
                  <a:lnTo>
                    <a:pt x="61" y="192"/>
                  </a:lnTo>
                  <a:lnTo>
                    <a:pt x="62" y="193"/>
                  </a:lnTo>
                  <a:lnTo>
                    <a:pt x="64" y="194"/>
                  </a:lnTo>
                  <a:lnTo>
                    <a:pt x="66" y="194"/>
                  </a:lnTo>
                  <a:lnTo>
                    <a:pt x="67" y="195"/>
                  </a:lnTo>
                  <a:lnTo>
                    <a:pt x="69" y="195"/>
                  </a:lnTo>
                  <a:lnTo>
                    <a:pt x="70" y="196"/>
                  </a:lnTo>
                  <a:lnTo>
                    <a:pt x="72" y="196"/>
                  </a:lnTo>
                  <a:lnTo>
                    <a:pt x="74" y="197"/>
                  </a:lnTo>
                  <a:lnTo>
                    <a:pt x="76" y="197"/>
                  </a:lnTo>
                  <a:lnTo>
                    <a:pt x="77" y="198"/>
                  </a:lnTo>
                  <a:lnTo>
                    <a:pt x="79" y="198"/>
                  </a:lnTo>
                  <a:lnTo>
                    <a:pt x="81" y="198"/>
                  </a:lnTo>
                  <a:lnTo>
                    <a:pt x="82" y="199"/>
                  </a:lnTo>
                  <a:lnTo>
                    <a:pt x="84" y="199"/>
                  </a:lnTo>
                  <a:lnTo>
                    <a:pt x="86" y="199"/>
                  </a:lnTo>
                  <a:lnTo>
                    <a:pt x="88" y="200"/>
                  </a:lnTo>
                  <a:lnTo>
                    <a:pt x="89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6" y="200"/>
                  </a:lnTo>
                  <a:lnTo>
                    <a:pt x="98" y="200"/>
                  </a:lnTo>
                  <a:lnTo>
                    <a:pt x="100" y="200"/>
                  </a:lnTo>
                  <a:lnTo>
                    <a:pt x="101" y="200"/>
                  </a:lnTo>
                  <a:lnTo>
                    <a:pt x="103" y="200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8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199"/>
                  </a:lnTo>
                  <a:lnTo>
                    <a:pt x="115" y="199"/>
                  </a:lnTo>
                  <a:lnTo>
                    <a:pt x="117" y="199"/>
                  </a:lnTo>
                  <a:lnTo>
                    <a:pt x="119" y="198"/>
                  </a:lnTo>
                  <a:lnTo>
                    <a:pt x="121" y="198"/>
                  </a:lnTo>
                  <a:lnTo>
                    <a:pt x="122" y="198"/>
                  </a:lnTo>
                  <a:lnTo>
                    <a:pt x="124" y="197"/>
                  </a:lnTo>
                  <a:lnTo>
                    <a:pt x="126" y="197"/>
                  </a:lnTo>
                  <a:lnTo>
                    <a:pt x="127" y="196"/>
                  </a:lnTo>
                  <a:lnTo>
                    <a:pt x="129" y="196"/>
                  </a:lnTo>
                  <a:lnTo>
                    <a:pt x="131" y="195"/>
                  </a:lnTo>
                  <a:lnTo>
                    <a:pt x="132" y="195"/>
                  </a:lnTo>
                  <a:lnTo>
                    <a:pt x="134" y="194"/>
                  </a:lnTo>
                  <a:lnTo>
                    <a:pt x="136" y="194"/>
                  </a:lnTo>
                  <a:lnTo>
                    <a:pt x="137" y="193"/>
                  </a:lnTo>
                  <a:lnTo>
                    <a:pt x="139" y="192"/>
                  </a:lnTo>
                  <a:lnTo>
                    <a:pt x="140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89"/>
                  </a:lnTo>
                  <a:lnTo>
                    <a:pt x="147" y="189"/>
                  </a:lnTo>
                  <a:lnTo>
                    <a:pt x="148" y="188"/>
                  </a:lnTo>
                  <a:lnTo>
                    <a:pt x="150" y="187"/>
                  </a:lnTo>
                  <a:lnTo>
                    <a:pt x="151" y="186"/>
                  </a:lnTo>
                  <a:lnTo>
                    <a:pt x="153" y="185"/>
                  </a:lnTo>
                  <a:lnTo>
                    <a:pt x="154" y="184"/>
                  </a:lnTo>
                  <a:lnTo>
                    <a:pt x="156" y="183"/>
                  </a:lnTo>
                  <a:lnTo>
                    <a:pt x="157" y="182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1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5" y="176"/>
                  </a:lnTo>
                  <a:lnTo>
                    <a:pt x="167" y="175"/>
                  </a:lnTo>
                  <a:lnTo>
                    <a:pt x="168" y="173"/>
                  </a:lnTo>
                  <a:lnTo>
                    <a:pt x="169" y="172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8"/>
                  </a:lnTo>
                  <a:lnTo>
                    <a:pt x="174" y="167"/>
                  </a:lnTo>
                  <a:lnTo>
                    <a:pt x="175" y="166"/>
                  </a:lnTo>
                  <a:lnTo>
                    <a:pt x="176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0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3"/>
                  </a:lnTo>
                  <a:lnTo>
                    <a:pt x="186" y="152"/>
                  </a:lnTo>
                  <a:lnTo>
                    <a:pt x="186" y="150"/>
                  </a:lnTo>
                  <a:lnTo>
                    <a:pt x="187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0" y="142"/>
                  </a:lnTo>
                  <a:lnTo>
                    <a:pt x="191" y="141"/>
                  </a:lnTo>
                  <a:lnTo>
                    <a:pt x="192" y="139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4"/>
                  </a:lnTo>
                  <a:lnTo>
                    <a:pt x="194" y="133"/>
                  </a:lnTo>
                  <a:lnTo>
                    <a:pt x="195" y="131"/>
                  </a:lnTo>
                  <a:lnTo>
                    <a:pt x="195" y="129"/>
                  </a:lnTo>
                  <a:lnTo>
                    <a:pt x="196" y="128"/>
                  </a:lnTo>
                  <a:lnTo>
                    <a:pt x="196" y="126"/>
                  </a:lnTo>
                  <a:lnTo>
                    <a:pt x="197" y="124"/>
                  </a:lnTo>
                  <a:lnTo>
                    <a:pt x="197" y="123"/>
                  </a:lnTo>
                  <a:lnTo>
                    <a:pt x="198" y="121"/>
                  </a:lnTo>
                  <a:lnTo>
                    <a:pt x="198" y="119"/>
                  </a:lnTo>
                  <a:lnTo>
                    <a:pt x="198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2"/>
                  </a:lnTo>
                  <a:lnTo>
                    <a:pt x="199" y="111"/>
                  </a:lnTo>
                  <a:lnTo>
                    <a:pt x="199" y="109"/>
                  </a:lnTo>
                  <a:lnTo>
                    <a:pt x="200" y="107"/>
                  </a:lnTo>
                  <a:lnTo>
                    <a:pt x="200" y="105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" name="Rectangle 10"/>
            <p:cNvSpPr>
              <a:spLocks noChangeArrowheads="1"/>
            </p:cNvSpPr>
            <p:nvPr/>
          </p:nvSpPr>
          <p:spPr bwMode="auto">
            <a:xfrm>
              <a:off x="1892301" y="2965450"/>
              <a:ext cx="387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inz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3"/>
            <p:cNvSpPr>
              <a:spLocks noChangeArrowheads="1"/>
            </p:cNvSpPr>
            <p:nvPr/>
          </p:nvSpPr>
          <p:spPr bwMode="auto">
            <a:xfrm>
              <a:off x="1919288" y="2549525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83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4"/>
            <p:cNvSpPr>
              <a:spLocks noChangeArrowheads="1"/>
            </p:cNvSpPr>
            <p:nvPr/>
          </p:nvSpPr>
          <p:spPr bwMode="auto">
            <a:xfrm>
              <a:off x="2439988" y="1676400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63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5"/>
            <p:cNvSpPr>
              <a:spLocks noChangeArrowheads="1"/>
            </p:cNvSpPr>
            <p:nvPr/>
          </p:nvSpPr>
          <p:spPr bwMode="auto">
            <a:xfrm>
              <a:off x="2197101" y="210978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4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16"/>
            <p:cNvSpPr>
              <a:spLocks noChangeArrowheads="1"/>
            </p:cNvSpPr>
            <p:nvPr/>
          </p:nvSpPr>
          <p:spPr bwMode="auto">
            <a:xfrm>
              <a:off x="1436688" y="1676400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52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17"/>
            <p:cNvSpPr>
              <a:spLocks noChangeArrowheads="1"/>
            </p:cNvSpPr>
            <p:nvPr/>
          </p:nvSpPr>
          <p:spPr bwMode="auto">
            <a:xfrm>
              <a:off x="1753886" y="2109788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3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18"/>
            <p:cNvSpPr>
              <a:spLocks noChangeArrowheads="1"/>
            </p:cNvSpPr>
            <p:nvPr/>
          </p:nvSpPr>
          <p:spPr bwMode="auto">
            <a:xfrm>
              <a:off x="1997047" y="1703388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4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19"/>
            <p:cNvSpPr>
              <a:spLocks noChangeArrowheads="1"/>
            </p:cNvSpPr>
            <p:nvPr/>
          </p:nvSpPr>
          <p:spPr bwMode="auto">
            <a:xfrm>
              <a:off x="1997047" y="1990097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6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Freeform 20"/>
            <p:cNvSpPr>
              <a:spLocks/>
            </p:cNvSpPr>
            <p:nvPr/>
          </p:nvSpPr>
          <p:spPr bwMode="auto">
            <a:xfrm>
              <a:off x="4064001" y="1385888"/>
              <a:ext cx="971550" cy="971550"/>
            </a:xfrm>
            <a:custGeom>
              <a:avLst/>
              <a:gdLst>
                <a:gd name="T0" fmla="*/ 200 w 201"/>
                <a:gd name="T1" fmla="*/ 92 h 201"/>
                <a:gd name="T2" fmla="*/ 199 w 201"/>
                <a:gd name="T3" fmla="*/ 81 h 201"/>
                <a:gd name="T4" fmla="*/ 196 w 201"/>
                <a:gd name="T5" fmla="*/ 71 h 201"/>
                <a:gd name="T6" fmla="*/ 193 w 201"/>
                <a:gd name="T7" fmla="*/ 61 h 201"/>
                <a:gd name="T8" fmla="*/ 188 w 201"/>
                <a:gd name="T9" fmla="*/ 52 h 201"/>
                <a:gd name="T10" fmla="*/ 183 w 201"/>
                <a:gd name="T11" fmla="*/ 43 h 201"/>
                <a:gd name="T12" fmla="*/ 176 w 201"/>
                <a:gd name="T13" fmla="*/ 35 h 201"/>
                <a:gd name="T14" fmla="*/ 169 w 201"/>
                <a:gd name="T15" fmla="*/ 27 h 201"/>
                <a:gd name="T16" fmla="*/ 161 w 201"/>
                <a:gd name="T17" fmla="*/ 20 h 201"/>
                <a:gd name="T18" fmla="*/ 152 w 201"/>
                <a:gd name="T19" fmla="*/ 15 h 201"/>
                <a:gd name="T20" fmla="*/ 143 w 201"/>
                <a:gd name="T21" fmla="*/ 10 h 201"/>
                <a:gd name="T22" fmla="*/ 133 w 201"/>
                <a:gd name="T23" fmla="*/ 6 h 201"/>
                <a:gd name="T24" fmla="*/ 123 w 201"/>
                <a:gd name="T25" fmla="*/ 3 h 201"/>
                <a:gd name="T26" fmla="*/ 113 w 201"/>
                <a:gd name="T27" fmla="*/ 1 h 201"/>
                <a:gd name="T28" fmla="*/ 102 w 201"/>
                <a:gd name="T29" fmla="*/ 0 h 201"/>
                <a:gd name="T30" fmla="*/ 92 w 201"/>
                <a:gd name="T31" fmla="*/ 1 h 201"/>
                <a:gd name="T32" fmla="*/ 81 w 201"/>
                <a:gd name="T33" fmla="*/ 2 h 201"/>
                <a:gd name="T34" fmla="*/ 71 w 201"/>
                <a:gd name="T35" fmla="*/ 5 h 201"/>
                <a:gd name="T36" fmla="*/ 61 w 201"/>
                <a:gd name="T37" fmla="*/ 8 h 201"/>
                <a:gd name="T38" fmla="*/ 52 w 201"/>
                <a:gd name="T39" fmla="*/ 13 h 201"/>
                <a:gd name="T40" fmla="*/ 43 w 201"/>
                <a:gd name="T41" fmla="*/ 18 h 201"/>
                <a:gd name="T42" fmla="*/ 35 w 201"/>
                <a:gd name="T43" fmla="*/ 25 h 201"/>
                <a:gd name="T44" fmla="*/ 27 w 201"/>
                <a:gd name="T45" fmla="*/ 32 h 201"/>
                <a:gd name="T46" fmla="*/ 21 w 201"/>
                <a:gd name="T47" fmla="*/ 40 h 201"/>
                <a:gd name="T48" fmla="*/ 15 w 201"/>
                <a:gd name="T49" fmla="*/ 49 h 201"/>
                <a:gd name="T50" fmla="*/ 10 w 201"/>
                <a:gd name="T51" fmla="*/ 58 h 201"/>
                <a:gd name="T52" fmla="*/ 6 w 201"/>
                <a:gd name="T53" fmla="*/ 68 h 201"/>
                <a:gd name="T54" fmla="*/ 3 w 201"/>
                <a:gd name="T55" fmla="*/ 78 h 201"/>
                <a:gd name="T56" fmla="*/ 1 w 201"/>
                <a:gd name="T57" fmla="*/ 88 h 201"/>
                <a:gd name="T58" fmla="*/ 0 w 201"/>
                <a:gd name="T59" fmla="*/ 99 h 201"/>
                <a:gd name="T60" fmla="*/ 1 w 201"/>
                <a:gd name="T61" fmla="*/ 109 h 201"/>
                <a:gd name="T62" fmla="*/ 2 w 201"/>
                <a:gd name="T63" fmla="*/ 120 h 201"/>
                <a:gd name="T64" fmla="*/ 5 w 201"/>
                <a:gd name="T65" fmla="*/ 130 h 201"/>
                <a:gd name="T66" fmla="*/ 8 w 201"/>
                <a:gd name="T67" fmla="*/ 140 h 201"/>
                <a:gd name="T68" fmla="*/ 13 w 201"/>
                <a:gd name="T69" fmla="*/ 149 h 201"/>
                <a:gd name="T70" fmla="*/ 19 w 201"/>
                <a:gd name="T71" fmla="*/ 158 h 201"/>
                <a:gd name="T72" fmla="*/ 25 w 201"/>
                <a:gd name="T73" fmla="*/ 166 h 201"/>
                <a:gd name="T74" fmla="*/ 32 w 201"/>
                <a:gd name="T75" fmla="*/ 174 h 201"/>
                <a:gd name="T76" fmla="*/ 40 w 201"/>
                <a:gd name="T77" fmla="*/ 180 h 201"/>
                <a:gd name="T78" fmla="*/ 49 w 201"/>
                <a:gd name="T79" fmla="*/ 186 h 201"/>
                <a:gd name="T80" fmla="*/ 58 w 201"/>
                <a:gd name="T81" fmla="*/ 191 h 201"/>
                <a:gd name="T82" fmla="*/ 68 w 201"/>
                <a:gd name="T83" fmla="*/ 195 h 201"/>
                <a:gd name="T84" fmla="*/ 78 w 201"/>
                <a:gd name="T85" fmla="*/ 198 h 201"/>
                <a:gd name="T86" fmla="*/ 88 w 201"/>
                <a:gd name="T87" fmla="*/ 200 h 201"/>
                <a:gd name="T88" fmla="*/ 99 w 201"/>
                <a:gd name="T89" fmla="*/ 201 h 201"/>
                <a:gd name="T90" fmla="*/ 109 w 201"/>
                <a:gd name="T91" fmla="*/ 200 h 201"/>
                <a:gd name="T92" fmla="*/ 120 w 201"/>
                <a:gd name="T93" fmla="*/ 199 h 201"/>
                <a:gd name="T94" fmla="*/ 130 w 201"/>
                <a:gd name="T95" fmla="*/ 196 h 201"/>
                <a:gd name="T96" fmla="*/ 140 w 201"/>
                <a:gd name="T97" fmla="*/ 193 h 201"/>
                <a:gd name="T98" fmla="*/ 149 w 201"/>
                <a:gd name="T99" fmla="*/ 188 h 201"/>
                <a:gd name="T100" fmla="*/ 158 w 201"/>
                <a:gd name="T101" fmla="*/ 183 h 201"/>
                <a:gd name="T102" fmla="*/ 166 w 201"/>
                <a:gd name="T103" fmla="*/ 176 h 201"/>
                <a:gd name="T104" fmla="*/ 174 w 201"/>
                <a:gd name="T105" fmla="*/ 169 h 201"/>
                <a:gd name="T106" fmla="*/ 180 w 201"/>
                <a:gd name="T107" fmla="*/ 161 h 201"/>
                <a:gd name="T108" fmla="*/ 186 w 201"/>
                <a:gd name="T109" fmla="*/ 152 h 201"/>
                <a:gd name="T110" fmla="*/ 191 w 201"/>
                <a:gd name="T111" fmla="*/ 143 h 201"/>
                <a:gd name="T112" fmla="*/ 195 w 201"/>
                <a:gd name="T113" fmla="*/ 133 h 201"/>
                <a:gd name="T114" fmla="*/ 198 w 201"/>
                <a:gd name="T115" fmla="*/ 123 h 201"/>
                <a:gd name="T116" fmla="*/ 200 w 201"/>
                <a:gd name="T117" fmla="*/ 113 h 201"/>
                <a:gd name="T118" fmla="*/ 201 w 201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1" h="201">
                  <a:moveTo>
                    <a:pt x="201" y="100"/>
                  </a:moveTo>
                  <a:lnTo>
                    <a:pt x="201" y="99"/>
                  </a:lnTo>
                  <a:lnTo>
                    <a:pt x="201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200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9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8" y="76"/>
                  </a:lnTo>
                  <a:lnTo>
                    <a:pt x="197" y="75"/>
                  </a:lnTo>
                  <a:lnTo>
                    <a:pt x="197" y="73"/>
                  </a:lnTo>
                  <a:lnTo>
                    <a:pt x="196" y="71"/>
                  </a:lnTo>
                  <a:lnTo>
                    <a:pt x="196" y="69"/>
                  </a:lnTo>
                  <a:lnTo>
                    <a:pt x="195" y="68"/>
                  </a:lnTo>
                  <a:lnTo>
                    <a:pt x="195" y="66"/>
                  </a:lnTo>
                  <a:lnTo>
                    <a:pt x="194" y="65"/>
                  </a:lnTo>
                  <a:lnTo>
                    <a:pt x="193" y="63"/>
                  </a:lnTo>
                  <a:lnTo>
                    <a:pt x="193" y="61"/>
                  </a:lnTo>
                  <a:lnTo>
                    <a:pt x="192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90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4" y="44"/>
                  </a:lnTo>
                  <a:lnTo>
                    <a:pt x="183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5" y="33"/>
                  </a:lnTo>
                  <a:lnTo>
                    <a:pt x="174" y="32"/>
                  </a:lnTo>
                  <a:lnTo>
                    <a:pt x="173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4"/>
                  </a:lnTo>
                  <a:lnTo>
                    <a:pt x="164" y="23"/>
                  </a:lnTo>
                  <a:lnTo>
                    <a:pt x="162" y="22"/>
                  </a:lnTo>
                  <a:lnTo>
                    <a:pt x="161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4" y="15"/>
                  </a:lnTo>
                  <a:lnTo>
                    <a:pt x="152" y="15"/>
                  </a:lnTo>
                  <a:lnTo>
                    <a:pt x="151" y="14"/>
                  </a:lnTo>
                  <a:lnTo>
                    <a:pt x="149" y="13"/>
                  </a:lnTo>
                  <a:lnTo>
                    <a:pt x="148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10"/>
                  </a:lnTo>
                  <a:lnTo>
                    <a:pt x="141" y="9"/>
                  </a:lnTo>
                  <a:lnTo>
                    <a:pt x="140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5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30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5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20" y="2"/>
                  </a:lnTo>
                  <a:lnTo>
                    <a:pt x="118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3" y="1"/>
                  </a:lnTo>
                  <a:lnTo>
                    <a:pt x="111" y="1"/>
                  </a:lnTo>
                  <a:lnTo>
                    <a:pt x="109" y="1"/>
                  </a:lnTo>
                  <a:lnTo>
                    <a:pt x="108" y="1"/>
                  </a:lnTo>
                  <a:lnTo>
                    <a:pt x="106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1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4" y="1"/>
                  </a:lnTo>
                  <a:lnTo>
                    <a:pt x="92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5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5" y="4"/>
                  </a:lnTo>
                  <a:lnTo>
                    <a:pt x="73" y="4"/>
                  </a:lnTo>
                  <a:lnTo>
                    <a:pt x="71" y="5"/>
                  </a:lnTo>
                  <a:lnTo>
                    <a:pt x="70" y="5"/>
                  </a:lnTo>
                  <a:lnTo>
                    <a:pt x="68" y="6"/>
                  </a:lnTo>
                  <a:lnTo>
                    <a:pt x="66" y="6"/>
                  </a:lnTo>
                  <a:lnTo>
                    <a:pt x="65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10"/>
                  </a:lnTo>
                  <a:lnTo>
                    <a:pt x="57" y="10"/>
                  </a:lnTo>
                  <a:lnTo>
                    <a:pt x="55" y="11"/>
                  </a:lnTo>
                  <a:lnTo>
                    <a:pt x="54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9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5" y="17"/>
                  </a:lnTo>
                  <a:lnTo>
                    <a:pt x="43" y="18"/>
                  </a:lnTo>
                  <a:lnTo>
                    <a:pt x="42" y="19"/>
                  </a:lnTo>
                  <a:lnTo>
                    <a:pt x="40" y="20"/>
                  </a:lnTo>
                  <a:lnTo>
                    <a:pt x="39" y="22"/>
                  </a:lnTo>
                  <a:lnTo>
                    <a:pt x="38" y="23"/>
                  </a:lnTo>
                  <a:lnTo>
                    <a:pt x="36" y="24"/>
                  </a:lnTo>
                  <a:lnTo>
                    <a:pt x="35" y="25"/>
                  </a:lnTo>
                  <a:lnTo>
                    <a:pt x="34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30" y="30"/>
                  </a:lnTo>
                  <a:lnTo>
                    <a:pt x="29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5"/>
                  </a:lnTo>
                  <a:lnTo>
                    <a:pt x="24" y="36"/>
                  </a:lnTo>
                  <a:lnTo>
                    <a:pt x="23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0" y="42"/>
                  </a:lnTo>
                  <a:lnTo>
                    <a:pt x="19" y="43"/>
                  </a:lnTo>
                  <a:lnTo>
                    <a:pt x="18" y="44"/>
                  </a:lnTo>
                  <a:lnTo>
                    <a:pt x="17" y="46"/>
                  </a:lnTo>
                  <a:lnTo>
                    <a:pt x="16" y="47"/>
                  </a:lnTo>
                  <a:lnTo>
                    <a:pt x="15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1" y="57"/>
                  </a:lnTo>
                  <a:lnTo>
                    <a:pt x="10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8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3" y="80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2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1" y="106"/>
                  </a:lnTo>
                  <a:lnTo>
                    <a:pt x="1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2" y="116"/>
                  </a:lnTo>
                  <a:lnTo>
                    <a:pt x="2" y="118"/>
                  </a:lnTo>
                  <a:lnTo>
                    <a:pt x="2" y="120"/>
                  </a:lnTo>
                  <a:lnTo>
                    <a:pt x="3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30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8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10" y="143"/>
                  </a:lnTo>
                  <a:lnTo>
                    <a:pt x="11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1"/>
                  </a:lnTo>
                  <a:lnTo>
                    <a:pt x="15" y="152"/>
                  </a:lnTo>
                  <a:lnTo>
                    <a:pt x="16" y="154"/>
                  </a:lnTo>
                  <a:lnTo>
                    <a:pt x="17" y="155"/>
                  </a:lnTo>
                  <a:lnTo>
                    <a:pt x="18" y="156"/>
                  </a:lnTo>
                  <a:lnTo>
                    <a:pt x="19" y="158"/>
                  </a:lnTo>
                  <a:lnTo>
                    <a:pt x="20" y="159"/>
                  </a:lnTo>
                  <a:lnTo>
                    <a:pt x="21" y="161"/>
                  </a:lnTo>
                  <a:lnTo>
                    <a:pt x="22" y="162"/>
                  </a:lnTo>
                  <a:lnTo>
                    <a:pt x="23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9" y="170"/>
                  </a:lnTo>
                  <a:lnTo>
                    <a:pt x="30" y="171"/>
                  </a:lnTo>
                  <a:lnTo>
                    <a:pt x="31" y="173"/>
                  </a:lnTo>
                  <a:lnTo>
                    <a:pt x="32" y="174"/>
                  </a:lnTo>
                  <a:lnTo>
                    <a:pt x="34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8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2" y="181"/>
                  </a:lnTo>
                  <a:lnTo>
                    <a:pt x="43" y="183"/>
                  </a:lnTo>
                  <a:lnTo>
                    <a:pt x="45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4" y="189"/>
                  </a:lnTo>
                  <a:lnTo>
                    <a:pt x="55" y="190"/>
                  </a:lnTo>
                  <a:lnTo>
                    <a:pt x="57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5" y="194"/>
                  </a:lnTo>
                  <a:lnTo>
                    <a:pt x="66" y="195"/>
                  </a:lnTo>
                  <a:lnTo>
                    <a:pt x="68" y="195"/>
                  </a:lnTo>
                  <a:lnTo>
                    <a:pt x="70" y="196"/>
                  </a:lnTo>
                  <a:lnTo>
                    <a:pt x="71" y="196"/>
                  </a:lnTo>
                  <a:lnTo>
                    <a:pt x="73" y="197"/>
                  </a:lnTo>
                  <a:lnTo>
                    <a:pt x="75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80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7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4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9" y="201"/>
                  </a:lnTo>
                  <a:lnTo>
                    <a:pt x="101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6" y="200"/>
                  </a:lnTo>
                  <a:lnTo>
                    <a:pt x="108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3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20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5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30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5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40" y="193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90"/>
                  </a:lnTo>
                  <a:lnTo>
                    <a:pt x="148" y="189"/>
                  </a:lnTo>
                  <a:lnTo>
                    <a:pt x="149" y="188"/>
                  </a:lnTo>
                  <a:lnTo>
                    <a:pt x="151" y="187"/>
                  </a:lnTo>
                  <a:lnTo>
                    <a:pt x="152" y="186"/>
                  </a:lnTo>
                  <a:lnTo>
                    <a:pt x="154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3"/>
                  </a:lnTo>
                  <a:lnTo>
                    <a:pt x="159" y="181"/>
                  </a:lnTo>
                  <a:lnTo>
                    <a:pt x="161" y="180"/>
                  </a:lnTo>
                  <a:lnTo>
                    <a:pt x="162" y="179"/>
                  </a:lnTo>
                  <a:lnTo>
                    <a:pt x="164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3" y="170"/>
                  </a:lnTo>
                  <a:lnTo>
                    <a:pt x="174" y="169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3" y="158"/>
                  </a:lnTo>
                  <a:lnTo>
                    <a:pt x="184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90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2" y="141"/>
                  </a:lnTo>
                  <a:lnTo>
                    <a:pt x="193" y="140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5" y="135"/>
                  </a:lnTo>
                  <a:lnTo>
                    <a:pt x="195" y="133"/>
                  </a:lnTo>
                  <a:lnTo>
                    <a:pt x="196" y="131"/>
                  </a:lnTo>
                  <a:lnTo>
                    <a:pt x="196" y="130"/>
                  </a:lnTo>
                  <a:lnTo>
                    <a:pt x="197" y="128"/>
                  </a:lnTo>
                  <a:lnTo>
                    <a:pt x="197" y="126"/>
                  </a:lnTo>
                  <a:lnTo>
                    <a:pt x="198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9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200" y="114"/>
                  </a:lnTo>
                  <a:lnTo>
                    <a:pt x="200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1" y="104"/>
                  </a:lnTo>
                  <a:lnTo>
                    <a:pt x="201" y="102"/>
                  </a:lnTo>
                  <a:lnTo>
                    <a:pt x="201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25" name="Rectangle 21"/>
            <p:cNvSpPr>
              <a:spLocks noChangeArrowheads="1"/>
            </p:cNvSpPr>
            <p:nvPr/>
          </p:nvSpPr>
          <p:spPr bwMode="auto">
            <a:xfrm>
              <a:off x="4164013" y="1227138"/>
              <a:ext cx="6381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otterdam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Freeform 22"/>
            <p:cNvSpPr>
              <a:spLocks/>
            </p:cNvSpPr>
            <p:nvPr/>
          </p:nvSpPr>
          <p:spPr bwMode="auto">
            <a:xfrm>
              <a:off x="4711701" y="1385888"/>
              <a:ext cx="966788" cy="971550"/>
            </a:xfrm>
            <a:custGeom>
              <a:avLst/>
              <a:gdLst>
                <a:gd name="T0" fmla="*/ 200 w 200"/>
                <a:gd name="T1" fmla="*/ 92 h 201"/>
                <a:gd name="T2" fmla="*/ 198 w 200"/>
                <a:gd name="T3" fmla="*/ 81 h 201"/>
                <a:gd name="T4" fmla="*/ 196 w 200"/>
                <a:gd name="T5" fmla="*/ 71 h 201"/>
                <a:gd name="T6" fmla="*/ 192 w 200"/>
                <a:gd name="T7" fmla="*/ 61 h 201"/>
                <a:gd name="T8" fmla="*/ 188 w 200"/>
                <a:gd name="T9" fmla="*/ 52 h 201"/>
                <a:gd name="T10" fmla="*/ 182 w 200"/>
                <a:gd name="T11" fmla="*/ 43 h 201"/>
                <a:gd name="T12" fmla="*/ 176 w 200"/>
                <a:gd name="T13" fmla="*/ 35 h 201"/>
                <a:gd name="T14" fmla="*/ 168 w 200"/>
                <a:gd name="T15" fmla="*/ 27 h 201"/>
                <a:gd name="T16" fmla="*/ 160 w 200"/>
                <a:gd name="T17" fmla="*/ 20 h 201"/>
                <a:gd name="T18" fmla="*/ 152 w 200"/>
                <a:gd name="T19" fmla="*/ 15 h 201"/>
                <a:gd name="T20" fmla="*/ 142 w 200"/>
                <a:gd name="T21" fmla="*/ 10 h 201"/>
                <a:gd name="T22" fmla="*/ 133 w 200"/>
                <a:gd name="T23" fmla="*/ 6 h 201"/>
                <a:gd name="T24" fmla="*/ 122 w 200"/>
                <a:gd name="T25" fmla="*/ 3 h 201"/>
                <a:gd name="T26" fmla="*/ 112 w 200"/>
                <a:gd name="T27" fmla="*/ 1 h 201"/>
                <a:gd name="T28" fmla="*/ 102 w 200"/>
                <a:gd name="T29" fmla="*/ 0 h 201"/>
                <a:gd name="T30" fmla="*/ 91 w 200"/>
                <a:gd name="T31" fmla="*/ 1 h 201"/>
                <a:gd name="T32" fmla="*/ 81 w 200"/>
                <a:gd name="T33" fmla="*/ 2 h 201"/>
                <a:gd name="T34" fmla="*/ 71 w 200"/>
                <a:gd name="T35" fmla="*/ 5 h 201"/>
                <a:gd name="T36" fmla="*/ 61 w 200"/>
                <a:gd name="T37" fmla="*/ 8 h 201"/>
                <a:gd name="T38" fmla="*/ 51 w 200"/>
                <a:gd name="T39" fmla="*/ 13 h 201"/>
                <a:gd name="T40" fmla="*/ 43 w 200"/>
                <a:gd name="T41" fmla="*/ 18 h 201"/>
                <a:gd name="T42" fmla="*/ 34 w 200"/>
                <a:gd name="T43" fmla="*/ 25 h 201"/>
                <a:gd name="T44" fmla="*/ 27 w 200"/>
                <a:gd name="T45" fmla="*/ 32 h 201"/>
                <a:gd name="T46" fmla="*/ 20 w 200"/>
                <a:gd name="T47" fmla="*/ 40 h 201"/>
                <a:gd name="T48" fmla="*/ 14 w 200"/>
                <a:gd name="T49" fmla="*/ 49 h 201"/>
                <a:gd name="T50" fmla="*/ 9 w 200"/>
                <a:gd name="T51" fmla="*/ 58 h 201"/>
                <a:gd name="T52" fmla="*/ 5 w 200"/>
                <a:gd name="T53" fmla="*/ 68 h 201"/>
                <a:gd name="T54" fmla="*/ 2 w 200"/>
                <a:gd name="T55" fmla="*/ 78 h 201"/>
                <a:gd name="T56" fmla="*/ 1 w 200"/>
                <a:gd name="T57" fmla="*/ 88 h 201"/>
                <a:gd name="T58" fmla="*/ 0 w 200"/>
                <a:gd name="T59" fmla="*/ 99 h 201"/>
                <a:gd name="T60" fmla="*/ 0 w 200"/>
                <a:gd name="T61" fmla="*/ 109 h 201"/>
                <a:gd name="T62" fmla="*/ 2 w 200"/>
                <a:gd name="T63" fmla="*/ 120 h 201"/>
                <a:gd name="T64" fmla="*/ 4 w 200"/>
                <a:gd name="T65" fmla="*/ 130 h 201"/>
                <a:gd name="T66" fmla="*/ 8 w 200"/>
                <a:gd name="T67" fmla="*/ 140 h 201"/>
                <a:gd name="T68" fmla="*/ 12 w 200"/>
                <a:gd name="T69" fmla="*/ 149 h 201"/>
                <a:gd name="T70" fmla="*/ 18 w 200"/>
                <a:gd name="T71" fmla="*/ 158 h 201"/>
                <a:gd name="T72" fmla="*/ 24 w 200"/>
                <a:gd name="T73" fmla="*/ 166 h 201"/>
                <a:gd name="T74" fmla="*/ 32 w 200"/>
                <a:gd name="T75" fmla="*/ 174 h 201"/>
                <a:gd name="T76" fmla="*/ 40 w 200"/>
                <a:gd name="T77" fmla="*/ 180 h 201"/>
                <a:gd name="T78" fmla="*/ 48 w 200"/>
                <a:gd name="T79" fmla="*/ 186 h 201"/>
                <a:gd name="T80" fmla="*/ 58 w 200"/>
                <a:gd name="T81" fmla="*/ 191 h 201"/>
                <a:gd name="T82" fmla="*/ 67 w 200"/>
                <a:gd name="T83" fmla="*/ 195 h 201"/>
                <a:gd name="T84" fmla="*/ 77 w 200"/>
                <a:gd name="T85" fmla="*/ 198 h 201"/>
                <a:gd name="T86" fmla="*/ 88 w 200"/>
                <a:gd name="T87" fmla="*/ 200 h 201"/>
                <a:gd name="T88" fmla="*/ 98 w 200"/>
                <a:gd name="T89" fmla="*/ 201 h 201"/>
                <a:gd name="T90" fmla="*/ 109 w 200"/>
                <a:gd name="T91" fmla="*/ 200 h 201"/>
                <a:gd name="T92" fmla="*/ 119 w 200"/>
                <a:gd name="T93" fmla="*/ 199 h 201"/>
                <a:gd name="T94" fmla="*/ 129 w 200"/>
                <a:gd name="T95" fmla="*/ 196 h 201"/>
                <a:gd name="T96" fmla="*/ 139 w 200"/>
                <a:gd name="T97" fmla="*/ 193 h 201"/>
                <a:gd name="T98" fmla="*/ 148 w 200"/>
                <a:gd name="T99" fmla="*/ 188 h 201"/>
                <a:gd name="T100" fmla="*/ 157 w 200"/>
                <a:gd name="T101" fmla="*/ 183 h 201"/>
                <a:gd name="T102" fmla="*/ 166 w 200"/>
                <a:gd name="T103" fmla="*/ 176 h 201"/>
                <a:gd name="T104" fmla="*/ 173 w 200"/>
                <a:gd name="T105" fmla="*/ 169 h 201"/>
                <a:gd name="T106" fmla="*/ 180 w 200"/>
                <a:gd name="T107" fmla="*/ 161 h 201"/>
                <a:gd name="T108" fmla="*/ 186 w 200"/>
                <a:gd name="T109" fmla="*/ 152 h 201"/>
                <a:gd name="T110" fmla="*/ 191 w 200"/>
                <a:gd name="T111" fmla="*/ 143 h 201"/>
                <a:gd name="T112" fmla="*/ 195 w 200"/>
                <a:gd name="T113" fmla="*/ 133 h 201"/>
                <a:gd name="T114" fmla="*/ 197 w 200"/>
                <a:gd name="T115" fmla="*/ 123 h 201"/>
                <a:gd name="T116" fmla="*/ 199 w 200"/>
                <a:gd name="T117" fmla="*/ 113 h 201"/>
                <a:gd name="T118" fmla="*/ 200 w 200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1">
                  <a:moveTo>
                    <a:pt x="200" y="100"/>
                  </a:moveTo>
                  <a:lnTo>
                    <a:pt x="200" y="99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199" y="88"/>
                  </a:lnTo>
                  <a:lnTo>
                    <a:pt x="199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80"/>
                  </a:lnTo>
                  <a:lnTo>
                    <a:pt x="197" y="78"/>
                  </a:lnTo>
                  <a:lnTo>
                    <a:pt x="197" y="76"/>
                  </a:lnTo>
                  <a:lnTo>
                    <a:pt x="197" y="75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3" y="65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4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4" y="16"/>
                  </a:lnTo>
                  <a:lnTo>
                    <a:pt x="153" y="15"/>
                  </a:lnTo>
                  <a:lnTo>
                    <a:pt x="152" y="15"/>
                  </a:lnTo>
                  <a:lnTo>
                    <a:pt x="150" y="14"/>
                  </a:lnTo>
                  <a:lnTo>
                    <a:pt x="148" y="13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10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7" y="8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29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4" y="3"/>
                  </a:lnTo>
                  <a:lnTo>
                    <a:pt x="122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4" y="4"/>
                  </a:lnTo>
                  <a:lnTo>
                    <a:pt x="72" y="4"/>
                  </a:lnTo>
                  <a:lnTo>
                    <a:pt x="71" y="5"/>
                  </a:lnTo>
                  <a:lnTo>
                    <a:pt x="69" y="5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2" y="8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8" y="10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1" y="13"/>
                  </a:lnTo>
                  <a:lnTo>
                    <a:pt x="50" y="14"/>
                  </a:lnTo>
                  <a:lnTo>
                    <a:pt x="48" y="15"/>
                  </a:lnTo>
                  <a:lnTo>
                    <a:pt x="47" y="15"/>
                  </a:lnTo>
                  <a:lnTo>
                    <a:pt x="45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0" y="28"/>
                  </a:lnTo>
                  <a:lnTo>
                    <a:pt x="29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4" y="35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9"/>
                  </a:lnTo>
                  <a:lnTo>
                    <a:pt x="20" y="40"/>
                  </a:lnTo>
                  <a:lnTo>
                    <a:pt x="19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7"/>
                  </a:lnTo>
                  <a:lnTo>
                    <a:pt x="9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5"/>
                  </a:lnTo>
                  <a:lnTo>
                    <a:pt x="3" y="76"/>
                  </a:lnTo>
                  <a:lnTo>
                    <a:pt x="2" y="78"/>
                  </a:lnTo>
                  <a:lnTo>
                    <a:pt x="2" y="80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0" y="90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3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30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9" y="143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2" y="149"/>
                  </a:lnTo>
                  <a:lnTo>
                    <a:pt x="13" y="151"/>
                  </a:lnTo>
                  <a:lnTo>
                    <a:pt x="14" y="152"/>
                  </a:lnTo>
                  <a:lnTo>
                    <a:pt x="15" y="154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1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3"/>
                  </a:lnTo>
                  <a:lnTo>
                    <a:pt x="32" y="174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3"/>
                  </a:lnTo>
                  <a:lnTo>
                    <a:pt x="44" y="183"/>
                  </a:lnTo>
                  <a:lnTo>
                    <a:pt x="45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1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59" y="192"/>
                  </a:lnTo>
                  <a:lnTo>
                    <a:pt x="61" y="193"/>
                  </a:lnTo>
                  <a:lnTo>
                    <a:pt x="62" y="193"/>
                  </a:lnTo>
                  <a:lnTo>
                    <a:pt x="64" y="194"/>
                  </a:lnTo>
                  <a:lnTo>
                    <a:pt x="66" y="195"/>
                  </a:lnTo>
                  <a:lnTo>
                    <a:pt x="67" y="195"/>
                  </a:lnTo>
                  <a:lnTo>
                    <a:pt x="69" y="196"/>
                  </a:lnTo>
                  <a:lnTo>
                    <a:pt x="71" y="196"/>
                  </a:lnTo>
                  <a:lnTo>
                    <a:pt x="72" y="197"/>
                  </a:lnTo>
                  <a:lnTo>
                    <a:pt x="74" y="197"/>
                  </a:lnTo>
                  <a:lnTo>
                    <a:pt x="76" y="198"/>
                  </a:lnTo>
                  <a:lnTo>
                    <a:pt x="77" y="198"/>
                  </a:lnTo>
                  <a:lnTo>
                    <a:pt x="79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4" y="199"/>
                  </a:lnTo>
                  <a:lnTo>
                    <a:pt x="86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6" y="201"/>
                  </a:lnTo>
                  <a:lnTo>
                    <a:pt x="98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3" y="201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7" y="199"/>
                  </a:lnTo>
                  <a:lnTo>
                    <a:pt x="119" y="199"/>
                  </a:lnTo>
                  <a:lnTo>
                    <a:pt x="121" y="198"/>
                  </a:lnTo>
                  <a:lnTo>
                    <a:pt x="122" y="198"/>
                  </a:lnTo>
                  <a:lnTo>
                    <a:pt x="124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29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4" y="195"/>
                  </a:lnTo>
                  <a:lnTo>
                    <a:pt x="136" y="194"/>
                  </a:lnTo>
                  <a:lnTo>
                    <a:pt x="137" y="193"/>
                  </a:lnTo>
                  <a:lnTo>
                    <a:pt x="139" y="193"/>
                  </a:lnTo>
                  <a:lnTo>
                    <a:pt x="141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90"/>
                  </a:lnTo>
                  <a:lnTo>
                    <a:pt x="147" y="189"/>
                  </a:lnTo>
                  <a:lnTo>
                    <a:pt x="148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4" y="184"/>
                  </a:lnTo>
                  <a:lnTo>
                    <a:pt x="156" y="183"/>
                  </a:lnTo>
                  <a:lnTo>
                    <a:pt x="157" y="183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8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9"/>
                  </a:lnTo>
                  <a:lnTo>
                    <a:pt x="174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1" y="141"/>
                  </a:lnTo>
                  <a:lnTo>
                    <a:pt x="192" y="140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5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30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5"/>
                  </a:lnTo>
                  <a:lnTo>
                    <a:pt x="197" y="123"/>
                  </a:lnTo>
                  <a:lnTo>
                    <a:pt x="198" y="121"/>
                  </a:lnTo>
                  <a:lnTo>
                    <a:pt x="198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27" name="Rectangle 23"/>
            <p:cNvSpPr>
              <a:spLocks noChangeArrowheads="1"/>
            </p:cNvSpPr>
            <p:nvPr/>
          </p:nvSpPr>
          <p:spPr bwMode="auto">
            <a:xfrm>
              <a:off x="4987926" y="1212850"/>
              <a:ext cx="5397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ansbig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Freeform 24"/>
            <p:cNvSpPr>
              <a:spLocks/>
            </p:cNvSpPr>
            <p:nvPr/>
          </p:nvSpPr>
          <p:spPr bwMode="auto">
            <a:xfrm>
              <a:off x="4387851" y="1946275"/>
              <a:ext cx="966788" cy="965200"/>
            </a:xfrm>
            <a:custGeom>
              <a:avLst/>
              <a:gdLst>
                <a:gd name="T0" fmla="*/ 200 w 200"/>
                <a:gd name="T1" fmla="*/ 91 h 200"/>
                <a:gd name="T2" fmla="*/ 198 w 200"/>
                <a:gd name="T3" fmla="*/ 81 h 200"/>
                <a:gd name="T4" fmla="*/ 196 w 200"/>
                <a:gd name="T5" fmla="*/ 71 h 200"/>
                <a:gd name="T6" fmla="*/ 192 w 200"/>
                <a:gd name="T7" fmla="*/ 61 h 200"/>
                <a:gd name="T8" fmla="*/ 188 w 200"/>
                <a:gd name="T9" fmla="*/ 52 h 200"/>
                <a:gd name="T10" fmla="*/ 182 w 200"/>
                <a:gd name="T11" fmla="*/ 43 h 200"/>
                <a:gd name="T12" fmla="*/ 176 w 200"/>
                <a:gd name="T13" fmla="*/ 34 h 200"/>
                <a:gd name="T14" fmla="*/ 169 w 200"/>
                <a:gd name="T15" fmla="*/ 27 h 200"/>
                <a:gd name="T16" fmla="*/ 160 w 200"/>
                <a:gd name="T17" fmla="*/ 20 h 200"/>
                <a:gd name="T18" fmla="*/ 152 w 200"/>
                <a:gd name="T19" fmla="*/ 14 h 200"/>
                <a:gd name="T20" fmla="*/ 143 w 200"/>
                <a:gd name="T21" fmla="*/ 9 h 200"/>
                <a:gd name="T22" fmla="*/ 133 w 200"/>
                <a:gd name="T23" fmla="*/ 5 h 200"/>
                <a:gd name="T24" fmla="*/ 123 w 200"/>
                <a:gd name="T25" fmla="*/ 3 h 200"/>
                <a:gd name="T26" fmla="*/ 112 w 200"/>
                <a:gd name="T27" fmla="*/ 1 h 200"/>
                <a:gd name="T28" fmla="*/ 102 w 200"/>
                <a:gd name="T29" fmla="*/ 0 h 200"/>
                <a:gd name="T30" fmla="*/ 92 w 200"/>
                <a:gd name="T31" fmla="*/ 0 h 200"/>
                <a:gd name="T32" fmla="*/ 81 w 200"/>
                <a:gd name="T33" fmla="*/ 2 h 200"/>
                <a:gd name="T34" fmla="*/ 71 w 200"/>
                <a:gd name="T35" fmla="*/ 4 h 200"/>
                <a:gd name="T36" fmla="*/ 61 w 200"/>
                <a:gd name="T37" fmla="*/ 8 h 200"/>
                <a:gd name="T38" fmla="*/ 52 w 200"/>
                <a:gd name="T39" fmla="*/ 12 h 200"/>
                <a:gd name="T40" fmla="*/ 43 w 200"/>
                <a:gd name="T41" fmla="*/ 18 h 200"/>
                <a:gd name="T42" fmla="*/ 35 w 200"/>
                <a:gd name="T43" fmla="*/ 25 h 200"/>
                <a:gd name="T44" fmla="*/ 27 w 200"/>
                <a:gd name="T45" fmla="*/ 32 h 200"/>
                <a:gd name="T46" fmla="*/ 20 w 200"/>
                <a:gd name="T47" fmla="*/ 40 h 200"/>
                <a:gd name="T48" fmla="*/ 14 w 200"/>
                <a:gd name="T49" fmla="*/ 49 h 200"/>
                <a:gd name="T50" fmla="*/ 10 w 200"/>
                <a:gd name="T51" fmla="*/ 58 h 200"/>
                <a:gd name="T52" fmla="*/ 6 w 200"/>
                <a:gd name="T53" fmla="*/ 68 h 200"/>
                <a:gd name="T54" fmla="*/ 3 w 200"/>
                <a:gd name="T55" fmla="*/ 78 h 200"/>
                <a:gd name="T56" fmla="*/ 1 w 200"/>
                <a:gd name="T57" fmla="*/ 88 h 200"/>
                <a:gd name="T58" fmla="*/ 0 w 200"/>
                <a:gd name="T59" fmla="*/ 98 h 200"/>
                <a:gd name="T60" fmla="*/ 1 w 200"/>
                <a:gd name="T61" fmla="*/ 109 h 200"/>
                <a:gd name="T62" fmla="*/ 2 w 200"/>
                <a:gd name="T63" fmla="*/ 119 h 200"/>
                <a:gd name="T64" fmla="*/ 5 w 200"/>
                <a:gd name="T65" fmla="*/ 129 h 200"/>
                <a:gd name="T66" fmla="*/ 8 w 200"/>
                <a:gd name="T67" fmla="*/ 139 h 200"/>
                <a:gd name="T68" fmla="*/ 13 w 200"/>
                <a:gd name="T69" fmla="*/ 149 h 200"/>
                <a:gd name="T70" fmla="*/ 18 w 200"/>
                <a:gd name="T71" fmla="*/ 158 h 200"/>
                <a:gd name="T72" fmla="*/ 25 w 200"/>
                <a:gd name="T73" fmla="*/ 166 h 200"/>
                <a:gd name="T74" fmla="*/ 32 w 200"/>
                <a:gd name="T75" fmla="*/ 173 h 200"/>
                <a:gd name="T76" fmla="*/ 40 w 200"/>
                <a:gd name="T77" fmla="*/ 180 h 200"/>
                <a:gd name="T78" fmla="*/ 49 w 200"/>
                <a:gd name="T79" fmla="*/ 186 h 200"/>
                <a:gd name="T80" fmla="*/ 58 w 200"/>
                <a:gd name="T81" fmla="*/ 191 h 200"/>
                <a:gd name="T82" fmla="*/ 68 w 200"/>
                <a:gd name="T83" fmla="*/ 195 h 200"/>
                <a:gd name="T84" fmla="*/ 78 w 200"/>
                <a:gd name="T85" fmla="*/ 198 h 200"/>
                <a:gd name="T86" fmla="*/ 88 w 200"/>
                <a:gd name="T87" fmla="*/ 200 h 200"/>
                <a:gd name="T88" fmla="*/ 99 w 200"/>
                <a:gd name="T89" fmla="*/ 200 h 200"/>
                <a:gd name="T90" fmla="*/ 109 w 200"/>
                <a:gd name="T91" fmla="*/ 200 h 200"/>
                <a:gd name="T92" fmla="*/ 119 w 200"/>
                <a:gd name="T93" fmla="*/ 198 h 200"/>
                <a:gd name="T94" fmla="*/ 130 w 200"/>
                <a:gd name="T95" fmla="*/ 196 h 200"/>
                <a:gd name="T96" fmla="*/ 139 w 200"/>
                <a:gd name="T97" fmla="*/ 192 h 200"/>
                <a:gd name="T98" fmla="*/ 149 w 200"/>
                <a:gd name="T99" fmla="*/ 188 h 200"/>
                <a:gd name="T100" fmla="*/ 158 w 200"/>
                <a:gd name="T101" fmla="*/ 182 h 200"/>
                <a:gd name="T102" fmla="*/ 166 w 200"/>
                <a:gd name="T103" fmla="*/ 176 h 200"/>
                <a:gd name="T104" fmla="*/ 173 w 200"/>
                <a:gd name="T105" fmla="*/ 168 h 200"/>
                <a:gd name="T106" fmla="*/ 180 w 200"/>
                <a:gd name="T107" fmla="*/ 160 h 200"/>
                <a:gd name="T108" fmla="*/ 186 w 200"/>
                <a:gd name="T109" fmla="*/ 152 h 200"/>
                <a:gd name="T110" fmla="*/ 191 w 200"/>
                <a:gd name="T111" fmla="*/ 142 h 200"/>
                <a:gd name="T112" fmla="*/ 195 w 200"/>
                <a:gd name="T113" fmla="*/ 133 h 200"/>
                <a:gd name="T114" fmla="*/ 198 w 200"/>
                <a:gd name="T115" fmla="*/ 123 h 200"/>
                <a:gd name="T116" fmla="*/ 200 w 200"/>
                <a:gd name="T117" fmla="*/ 112 h 200"/>
                <a:gd name="T118" fmla="*/ 200 w 200"/>
                <a:gd name="T119" fmla="*/ 102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0">
                  <a:moveTo>
                    <a:pt x="200" y="100"/>
                  </a:moveTo>
                  <a:lnTo>
                    <a:pt x="200" y="98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1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199" y="86"/>
                  </a:lnTo>
                  <a:lnTo>
                    <a:pt x="199" y="84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79"/>
                  </a:lnTo>
                  <a:lnTo>
                    <a:pt x="198" y="78"/>
                  </a:lnTo>
                  <a:lnTo>
                    <a:pt x="197" y="76"/>
                  </a:lnTo>
                  <a:lnTo>
                    <a:pt x="197" y="74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4" y="64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2" y="59"/>
                  </a:lnTo>
                  <a:lnTo>
                    <a:pt x="191" y="58"/>
                  </a:lnTo>
                  <a:lnTo>
                    <a:pt x="190" y="56"/>
                  </a:lnTo>
                  <a:lnTo>
                    <a:pt x="189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1"/>
                  </a:lnTo>
                  <a:lnTo>
                    <a:pt x="180" y="40"/>
                  </a:lnTo>
                  <a:lnTo>
                    <a:pt x="179" y="38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4"/>
                  </a:lnTo>
                  <a:lnTo>
                    <a:pt x="175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29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3"/>
                  </a:lnTo>
                  <a:lnTo>
                    <a:pt x="163" y="22"/>
                  </a:lnTo>
                  <a:lnTo>
                    <a:pt x="162" y="21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3" y="15"/>
                  </a:lnTo>
                  <a:lnTo>
                    <a:pt x="152" y="14"/>
                  </a:lnTo>
                  <a:lnTo>
                    <a:pt x="150" y="13"/>
                  </a:lnTo>
                  <a:lnTo>
                    <a:pt x="149" y="12"/>
                  </a:lnTo>
                  <a:lnTo>
                    <a:pt x="147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9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8" y="7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5"/>
                  </a:lnTo>
                  <a:lnTo>
                    <a:pt x="131" y="5"/>
                  </a:lnTo>
                  <a:lnTo>
                    <a:pt x="130" y="4"/>
                  </a:lnTo>
                  <a:lnTo>
                    <a:pt x="128" y="4"/>
                  </a:lnTo>
                  <a:lnTo>
                    <a:pt x="126" y="3"/>
                  </a:lnTo>
                  <a:lnTo>
                    <a:pt x="124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8" y="1"/>
                  </a:lnTo>
                  <a:lnTo>
                    <a:pt x="116" y="1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1" y="0"/>
                  </a:lnTo>
                  <a:lnTo>
                    <a:pt x="109" y="0"/>
                  </a:lnTo>
                  <a:lnTo>
                    <a:pt x="107" y="0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0"/>
                  </a:lnTo>
                  <a:lnTo>
                    <a:pt x="92" y="0"/>
                  </a:lnTo>
                  <a:lnTo>
                    <a:pt x="90" y="0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5" y="1"/>
                  </a:lnTo>
                  <a:lnTo>
                    <a:pt x="83" y="1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4" y="3"/>
                  </a:lnTo>
                  <a:lnTo>
                    <a:pt x="73" y="4"/>
                  </a:lnTo>
                  <a:lnTo>
                    <a:pt x="71" y="4"/>
                  </a:lnTo>
                  <a:lnTo>
                    <a:pt x="69" y="5"/>
                  </a:lnTo>
                  <a:lnTo>
                    <a:pt x="68" y="5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3" y="7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9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2"/>
                  </a:lnTo>
                  <a:lnTo>
                    <a:pt x="50" y="13"/>
                  </a:lnTo>
                  <a:lnTo>
                    <a:pt x="49" y="14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9" y="21"/>
                  </a:lnTo>
                  <a:lnTo>
                    <a:pt x="37" y="22"/>
                  </a:lnTo>
                  <a:lnTo>
                    <a:pt x="36" y="23"/>
                  </a:lnTo>
                  <a:lnTo>
                    <a:pt x="35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29" y="29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4"/>
                  </a:lnTo>
                  <a:lnTo>
                    <a:pt x="24" y="36"/>
                  </a:lnTo>
                  <a:lnTo>
                    <a:pt x="22" y="37"/>
                  </a:lnTo>
                  <a:lnTo>
                    <a:pt x="21" y="38"/>
                  </a:lnTo>
                  <a:lnTo>
                    <a:pt x="20" y="40"/>
                  </a:lnTo>
                  <a:lnTo>
                    <a:pt x="19" y="41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6"/>
                  </a:lnTo>
                  <a:lnTo>
                    <a:pt x="10" y="58"/>
                  </a:lnTo>
                  <a:lnTo>
                    <a:pt x="9" y="59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4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4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2" y="79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1" y="84"/>
                  </a:lnTo>
                  <a:lnTo>
                    <a:pt x="1" y="86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2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2" y="118"/>
                  </a:lnTo>
                  <a:lnTo>
                    <a:pt x="2" y="119"/>
                  </a:lnTo>
                  <a:lnTo>
                    <a:pt x="2" y="121"/>
                  </a:lnTo>
                  <a:lnTo>
                    <a:pt x="3" y="123"/>
                  </a:lnTo>
                  <a:lnTo>
                    <a:pt x="3" y="124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29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4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39"/>
                  </a:lnTo>
                  <a:lnTo>
                    <a:pt x="9" y="141"/>
                  </a:lnTo>
                  <a:lnTo>
                    <a:pt x="10" y="142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0"/>
                  </a:lnTo>
                  <a:lnTo>
                    <a:pt x="14" y="152"/>
                  </a:lnTo>
                  <a:lnTo>
                    <a:pt x="15" y="153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0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8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1" y="172"/>
                  </a:lnTo>
                  <a:lnTo>
                    <a:pt x="32" y="173"/>
                  </a:lnTo>
                  <a:lnTo>
                    <a:pt x="33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2"/>
                  </a:lnTo>
                  <a:lnTo>
                    <a:pt x="44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89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2"/>
                  </a:lnTo>
                  <a:lnTo>
                    <a:pt x="63" y="193"/>
                  </a:lnTo>
                  <a:lnTo>
                    <a:pt x="64" y="194"/>
                  </a:lnTo>
                  <a:lnTo>
                    <a:pt x="66" y="194"/>
                  </a:lnTo>
                  <a:lnTo>
                    <a:pt x="68" y="195"/>
                  </a:lnTo>
                  <a:lnTo>
                    <a:pt x="69" y="195"/>
                  </a:lnTo>
                  <a:lnTo>
                    <a:pt x="71" y="196"/>
                  </a:lnTo>
                  <a:lnTo>
                    <a:pt x="73" y="196"/>
                  </a:lnTo>
                  <a:lnTo>
                    <a:pt x="74" y="197"/>
                  </a:lnTo>
                  <a:lnTo>
                    <a:pt x="76" y="197"/>
                  </a:lnTo>
                  <a:lnTo>
                    <a:pt x="78" y="198"/>
                  </a:lnTo>
                  <a:lnTo>
                    <a:pt x="79" y="198"/>
                  </a:lnTo>
                  <a:lnTo>
                    <a:pt x="81" y="198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6" y="199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0"/>
                  </a:lnTo>
                  <a:lnTo>
                    <a:pt x="99" y="200"/>
                  </a:lnTo>
                  <a:lnTo>
                    <a:pt x="100" y="200"/>
                  </a:lnTo>
                  <a:lnTo>
                    <a:pt x="102" y="200"/>
                  </a:lnTo>
                  <a:lnTo>
                    <a:pt x="104" y="200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2" y="200"/>
                  </a:lnTo>
                  <a:lnTo>
                    <a:pt x="114" y="199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19" y="198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4" y="197"/>
                  </a:lnTo>
                  <a:lnTo>
                    <a:pt x="126" y="197"/>
                  </a:lnTo>
                  <a:lnTo>
                    <a:pt x="128" y="196"/>
                  </a:lnTo>
                  <a:lnTo>
                    <a:pt x="130" y="196"/>
                  </a:lnTo>
                  <a:lnTo>
                    <a:pt x="131" y="195"/>
                  </a:lnTo>
                  <a:lnTo>
                    <a:pt x="133" y="195"/>
                  </a:lnTo>
                  <a:lnTo>
                    <a:pt x="134" y="194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39" y="192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89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2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3"/>
                  </a:lnTo>
                  <a:lnTo>
                    <a:pt x="170" y="172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8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0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3"/>
                  </a:lnTo>
                  <a:lnTo>
                    <a:pt x="186" y="152"/>
                  </a:lnTo>
                  <a:lnTo>
                    <a:pt x="187" y="150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2"/>
                  </a:lnTo>
                  <a:lnTo>
                    <a:pt x="192" y="141"/>
                  </a:lnTo>
                  <a:lnTo>
                    <a:pt x="192" y="139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4" y="134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29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4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8" y="119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200" y="112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5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29" name="Rectangle 25"/>
            <p:cNvSpPr>
              <a:spLocks noChangeArrowheads="1"/>
            </p:cNvSpPr>
            <p:nvPr/>
          </p:nvSpPr>
          <p:spPr bwMode="auto">
            <a:xfrm>
              <a:off x="4676776" y="2965450"/>
              <a:ext cx="387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inz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28"/>
            <p:cNvSpPr>
              <a:spLocks noChangeArrowheads="1"/>
            </p:cNvSpPr>
            <p:nvPr/>
          </p:nvSpPr>
          <p:spPr bwMode="auto">
            <a:xfrm>
              <a:off x="4703763" y="2506663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1340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29"/>
            <p:cNvSpPr>
              <a:spLocks noChangeArrowheads="1"/>
            </p:cNvSpPr>
            <p:nvPr/>
          </p:nvSpPr>
          <p:spPr bwMode="auto">
            <a:xfrm>
              <a:off x="5224463" y="1631950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55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30"/>
            <p:cNvSpPr>
              <a:spLocks noChangeArrowheads="1"/>
            </p:cNvSpPr>
            <p:nvPr/>
          </p:nvSpPr>
          <p:spPr bwMode="auto">
            <a:xfrm>
              <a:off x="4981576" y="2066925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18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1"/>
            <p:cNvSpPr>
              <a:spLocks noChangeArrowheads="1"/>
            </p:cNvSpPr>
            <p:nvPr/>
          </p:nvSpPr>
          <p:spPr bwMode="auto">
            <a:xfrm>
              <a:off x="4221163" y="1631950"/>
              <a:ext cx="3333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1706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32"/>
            <p:cNvSpPr>
              <a:spLocks noChangeArrowheads="1"/>
            </p:cNvSpPr>
            <p:nvPr/>
          </p:nvSpPr>
          <p:spPr bwMode="auto">
            <a:xfrm>
              <a:off x="4498976" y="2066925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37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33"/>
            <p:cNvSpPr>
              <a:spLocks noChangeArrowheads="1"/>
            </p:cNvSpPr>
            <p:nvPr/>
          </p:nvSpPr>
          <p:spPr bwMode="auto">
            <a:xfrm>
              <a:off x="4773613" y="1661726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170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34"/>
            <p:cNvSpPr>
              <a:spLocks noChangeArrowheads="1"/>
            </p:cNvSpPr>
            <p:nvPr/>
          </p:nvSpPr>
          <p:spPr bwMode="auto">
            <a:xfrm>
              <a:off x="4755790" y="1955800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290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36"/>
            <p:cNvSpPr>
              <a:spLocks noChangeArrowheads="1"/>
            </p:cNvSpPr>
            <p:nvPr/>
          </p:nvSpPr>
          <p:spPr bwMode="auto">
            <a:xfrm>
              <a:off x="4740276" y="2593975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sv-SE" altLang="sv-SE" sz="900" dirty="0" smtClean="0">
                  <a:solidFill>
                    <a:srgbClr val="0000FF"/>
                  </a:solidFill>
                </a:rPr>
                <a:t>70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37"/>
            <p:cNvSpPr>
              <a:spLocks noChangeArrowheads="1"/>
            </p:cNvSpPr>
            <p:nvPr/>
          </p:nvSpPr>
          <p:spPr bwMode="auto">
            <a:xfrm>
              <a:off x="5224463" y="1719263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sv-SE" altLang="sv-SE" sz="900" dirty="0" smtClean="0">
                  <a:solidFill>
                    <a:srgbClr val="0000FF"/>
                  </a:solidFill>
                </a:rPr>
                <a:t>40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38"/>
            <p:cNvSpPr>
              <a:spLocks noChangeArrowheads="1"/>
            </p:cNvSpPr>
            <p:nvPr/>
          </p:nvSpPr>
          <p:spPr bwMode="auto">
            <a:xfrm>
              <a:off x="4981576" y="215423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16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ctangle 39"/>
            <p:cNvSpPr>
              <a:spLocks noChangeArrowheads="1"/>
            </p:cNvSpPr>
            <p:nvPr/>
          </p:nvSpPr>
          <p:spPr bwMode="auto">
            <a:xfrm>
              <a:off x="4221163" y="1719263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311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40"/>
            <p:cNvSpPr>
              <a:spLocks noChangeArrowheads="1"/>
            </p:cNvSpPr>
            <p:nvPr/>
          </p:nvSpPr>
          <p:spPr bwMode="auto">
            <a:xfrm>
              <a:off x="4498976" y="215423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16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1"/>
            <p:cNvSpPr>
              <a:spLocks noChangeArrowheads="1"/>
            </p:cNvSpPr>
            <p:nvPr/>
          </p:nvSpPr>
          <p:spPr bwMode="auto">
            <a:xfrm>
              <a:off x="4789128" y="1752600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9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2"/>
            <p:cNvSpPr>
              <a:spLocks noChangeArrowheads="1"/>
            </p:cNvSpPr>
            <p:nvPr/>
          </p:nvSpPr>
          <p:spPr bwMode="auto">
            <a:xfrm>
              <a:off x="4802188" y="204311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908720" y="4962875"/>
            <a:ext cx="5771301" cy="2822303"/>
            <a:chOff x="491387" y="3621905"/>
            <a:chExt cx="5771301" cy="2822303"/>
          </a:xfrm>
        </p:grpSpPr>
        <p:sp>
          <p:nvSpPr>
            <p:cNvPr id="6" name="Textfeld 5"/>
            <p:cNvSpPr txBox="1"/>
            <p:nvPr/>
          </p:nvSpPr>
          <p:spPr>
            <a:xfrm>
              <a:off x="491387" y="3621905"/>
              <a:ext cx="46203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be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ts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ssociated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ith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ate</a:t>
              </a:r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etastasis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AutoShape 44"/>
            <p:cNvSpPr>
              <a:spLocks noChangeAspect="1" noChangeArrowheads="1" noTextEdit="1"/>
            </p:cNvSpPr>
            <p:nvPr/>
          </p:nvSpPr>
          <p:spPr bwMode="auto">
            <a:xfrm>
              <a:off x="693738" y="3662908"/>
              <a:ext cx="5568950" cy="2781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49" name="Freeform 46"/>
            <p:cNvSpPr>
              <a:spLocks/>
            </p:cNvSpPr>
            <p:nvPr/>
          </p:nvSpPr>
          <p:spPr bwMode="auto">
            <a:xfrm>
              <a:off x="1277938" y="4382046"/>
              <a:ext cx="968375" cy="971550"/>
            </a:xfrm>
            <a:custGeom>
              <a:avLst/>
              <a:gdLst>
                <a:gd name="T0" fmla="*/ 200 w 200"/>
                <a:gd name="T1" fmla="*/ 92 h 201"/>
                <a:gd name="T2" fmla="*/ 198 w 200"/>
                <a:gd name="T3" fmla="*/ 81 h 201"/>
                <a:gd name="T4" fmla="*/ 196 w 200"/>
                <a:gd name="T5" fmla="*/ 71 h 201"/>
                <a:gd name="T6" fmla="*/ 192 w 200"/>
                <a:gd name="T7" fmla="*/ 61 h 201"/>
                <a:gd name="T8" fmla="*/ 188 w 200"/>
                <a:gd name="T9" fmla="*/ 52 h 201"/>
                <a:gd name="T10" fmla="*/ 182 w 200"/>
                <a:gd name="T11" fmla="*/ 43 h 201"/>
                <a:gd name="T12" fmla="*/ 176 w 200"/>
                <a:gd name="T13" fmla="*/ 35 h 201"/>
                <a:gd name="T14" fmla="*/ 168 w 200"/>
                <a:gd name="T15" fmla="*/ 27 h 201"/>
                <a:gd name="T16" fmla="*/ 160 w 200"/>
                <a:gd name="T17" fmla="*/ 20 h 201"/>
                <a:gd name="T18" fmla="*/ 152 w 200"/>
                <a:gd name="T19" fmla="*/ 15 h 201"/>
                <a:gd name="T20" fmla="*/ 142 w 200"/>
                <a:gd name="T21" fmla="*/ 10 h 201"/>
                <a:gd name="T22" fmla="*/ 133 w 200"/>
                <a:gd name="T23" fmla="*/ 6 h 201"/>
                <a:gd name="T24" fmla="*/ 123 w 200"/>
                <a:gd name="T25" fmla="*/ 3 h 201"/>
                <a:gd name="T26" fmla="*/ 112 w 200"/>
                <a:gd name="T27" fmla="*/ 1 h 201"/>
                <a:gd name="T28" fmla="*/ 102 w 200"/>
                <a:gd name="T29" fmla="*/ 0 h 201"/>
                <a:gd name="T30" fmla="*/ 91 w 200"/>
                <a:gd name="T31" fmla="*/ 1 h 201"/>
                <a:gd name="T32" fmla="*/ 81 w 200"/>
                <a:gd name="T33" fmla="*/ 2 h 201"/>
                <a:gd name="T34" fmla="*/ 71 w 200"/>
                <a:gd name="T35" fmla="*/ 5 h 201"/>
                <a:gd name="T36" fmla="*/ 61 w 200"/>
                <a:gd name="T37" fmla="*/ 8 h 201"/>
                <a:gd name="T38" fmla="*/ 52 w 200"/>
                <a:gd name="T39" fmla="*/ 13 h 201"/>
                <a:gd name="T40" fmla="*/ 43 w 200"/>
                <a:gd name="T41" fmla="*/ 18 h 201"/>
                <a:gd name="T42" fmla="*/ 34 w 200"/>
                <a:gd name="T43" fmla="*/ 25 h 201"/>
                <a:gd name="T44" fmla="*/ 27 w 200"/>
                <a:gd name="T45" fmla="*/ 32 h 201"/>
                <a:gd name="T46" fmla="*/ 20 w 200"/>
                <a:gd name="T47" fmla="*/ 40 h 201"/>
                <a:gd name="T48" fmla="*/ 14 w 200"/>
                <a:gd name="T49" fmla="*/ 49 h 201"/>
                <a:gd name="T50" fmla="*/ 9 w 200"/>
                <a:gd name="T51" fmla="*/ 58 h 201"/>
                <a:gd name="T52" fmla="*/ 5 w 200"/>
                <a:gd name="T53" fmla="*/ 68 h 201"/>
                <a:gd name="T54" fmla="*/ 3 w 200"/>
                <a:gd name="T55" fmla="*/ 78 h 201"/>
                <a:gd name="T56" fmla="*/ 1 w 200"/>
                <a:gd name="T57" fmla="*/ 88 h 201"/>
                <a:gd name="T58" fmla="*/ 0 w 200"/>
                <a:gd name="T59" fmla="*/ 99 h 201"/>
                <a:gd name="T60" fmla="*/ 0 w 200"/>
                <a:gd name="T61" fmla="*/ 109 h 201"/>
                <a:gd name="T62" fmla="*/ 2 w 200"/>
                <a:gd name="T63" fmla="*/ 120 h 201"/>
                <a:gd name="T64" fmla="*/ 4 w 200"/>
                <a:gd name="T65" fmla="*/ 130 h 201"/>
                <a:gd name="T66" fmla="*/ 8 w 200"/>
                <a:gd name="T67" fmla="*/ 140 h 201"/>
                <a:gd name="T68" fmla="*/ 12 w 200"/>
                <a:gd name="T69" fmla="*/ 149 h 201"/>
                <a:gd name="T70" fmla="*/ 18 w 200"/>
                <a:gd name="T71" fmla="*/ 158 h 201"/>
                <a:gd name="T72" fmla="*/ 24 w 200"/>
                <a:gd name="T73" fmla="*/ 166 h 201"/>
                <a:gd name="T74" fmla="*/ 32 w 200"/>
                <a:gd name="T75" fmla="*/ 174 h 201"/>
                <a:gd name="T76" fmla="*/ 40 w 200"/>
                <a:gd name="T77" fmla="*/ 180 h 201"/>
                <a:gd name="T78" fmla="*/ 48 w 200"/>
                <a:gd name="T79" fmla="*/ 186 h 201"/>
                <a:gd name="T80" fmla="*/ 58 w 200"/>
                <a:gd name="T81" fmla="*/ 191 h 201"/>
                <a:gd name="T82" fmla="*/ 67 w 200"/>
                <a:gd name="T83" fmla="*/ 195 h 201"/>
                <a:gd name="T84" fmla="*/ 78 w 200"/>
                <a:gd name="T85" fmla="*/ 198 h 201"/>
                <a:gd name="T86" fmla="*/ 88 w 200"/>
                <a:gd name="T87" fmla="*/ 200 h 201"/>
                <a:gd name="T88" fmla="*/ 98 w 200"/>
                <a:gd name="T89" fmla="*/ 201 h 201"/>
                <a:gd name="T90" fmla="*/ 109 w 200"/>
                <a:gd name="T91" fmla="*/ 200 h 201"/>
                <a:gd name="T92" fmla="*/ 119 w 200"/>
                <a:gd name="T93" fmla="*/ 199 h 201"/>
                <a:gd name="T94" fmla="*/ 129 w 200"/>
                <a:gd name="T95" fmla="*/ 196 h 201"/>
                <a:gd name="T96" fmla="*/ 139 w 200"/>
                <a:gd name="T97" fmla="*/ 193 h 201"/>
                <a:gd name="T98" fmla="*/ 149 w 200"/>
                <a:gd name="T99" fmla="*/ 188 h 201"/>
                <a:gd name="T100" fmla="*/ 157 w 200"/>
                <a:gd name="T101" fmla="*/ 183 h 201"/>
                <a:gd name="T102" fmla="*/ 166 w 200"/>
                <a:gd name="T103" fmla="*/ 176 h 201"/>
                <a:gd name="T104" fmla="*/ 173 w 200"/>
                <a:gd name="T105" fmla="*/ 169 h 201"/>
                <a:gd name="T106" fmla="*/ 180 w 200"/>
                <a:gd name="T107" fmla="*/ 161 h 201"/>
                <a:gd name="T108" fmla="*/ 186 w 200"/>
                <a:gd name="T109" fmla="*/ 152 h 201"/>
                <a:gd name="T110" fmla="*/ 191 w 200"/>
                <a:gd name="T111" fmla="*/ 143 h 201"/>
                <a:gd name="T112" fmla="*/ 195 w 200"/>
                <a:gd name="T113" fmla="*/ 133 h 201"/>
                <a:gd name="T114" fmla="*/ 198 w 200"/>
                <a:gd name="T115" fmla="*/ 123 h 201"/>
                <a:gd name="T116" fmla="*/ 199 w 200"/>
                <a:gd name="T117" fmla="*/ 113 h 201"/>
                <a:gd name="T118" fmla="*/ 200 w 200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1">
                  <a:moveTo>
                    <a:pt x="200" y="100"/>
                  </a:moveTo>
                  <a:lnTo>
                    <a:pt x="200" y="99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199" y="88"/>
                  </a:lnTo>
                  <a:lnTo>
                    <a:pt x="199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7" y="76"/>
                  </a:lnTo>
                  <a:lnTo>
                    <a:pt x="197" y="75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3" y="65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4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3" y="15"/>
                  </a:lnTo>
                  <a:lnTo>
                    <a:pt x="152" y="15"/>
                  </a:lnTo>
                  <a:lnTo>
                    <a:pt x="150" y="14"/>
                  </a:lnTo>
                  <a:lnTo>
                    <a:pt x="149" y="13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10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29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4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4" y="4"/>
                  </a:lnTo>
                  <a:lnTo>
                    <a:pt x="72" y="4"/>
                  </a:lnTo>
                  <a:lnTo>
                    <a:pt x="71" y="5"/>
                  </a:lnTo>
                  <a:lnTo>
                    <a:pt x="69" y="5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8" y="10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8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0" y="28"/>
                  </a:lnTo>
                  <a:lnTo>
                    <a:pt x="29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4" y="35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9"/>
                  </a:lnTo>
                  <a:lnTo>
                    <a:pt x="20" y="40"/>
                  </a:lnTo>
                  <a:lnTo>
                    <a:pt x="19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7"/>
                  </a:lnTo>
                  <a:lnTo>
                    <a:pt x="9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2" y="80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0" y="90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30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9" y="143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2" y="149"/>
                  </a:lnTo>
                  <a:lnTo>
                    <a:pt x="13" y="151"/>
                  </a:lnTo>
                  <a:lnTo>
                    <a:pt x="14" y="152"/>
                  </a:lnTo>
                  <a:lnTo>
                    <a:pt x="15" y="154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1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3"/>
                  </a:lnTo>
                  <a:lnTo>
                    <a:pt x="32" y="174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3"/>
                  </a:lnTo>
                  <a:lnTo>
                    <a:pt x="44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59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4" y="194"/>
                  </a:lnTo>
                  <a:lnTo>
                    <a:pt x="66" y="195"/>
                  </a:lnTo>
                  <a:lnTo>
                    <a:pt x="67" y="195"/>
                  </a:lnTo>
                  <a:lnTo>
                    <a:pt x="69" y="196"/>
                  </a:lnTo>
                  <a:lnTo>
                    <a:pt x="71" y="196"/>
                  </a:lnTo>
                  <a:lnTo>
                    <a:pt x="72" y="197"/>
                  </a:lnTo>
                  <a:lnTo>
                    <a:pt x="74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79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4" y="199"/>
                  </a:lnTo>
                  <a:lnTo>
                    <a:pt x="86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8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7" y="199"/>
                  </a:lnTo>
                  <a:lnTo>
                    <a:pt x="119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4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29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4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39" y="193"/>
                  </a:lnTo>
                  <a:lnTo>
                    <a:pt x="141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90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7" y="183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8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9"/>
                  </a:lnTo>
                  <a:lnTo>
                    <a:pt x="174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1" y="141"/>
                  </a:lnTo>
                  <a:lnTo>
                    <a:pt x="192" y="140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5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30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8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50" name="Rectangle 47"/>
            <p:cNvSpPr>
              <a:spLocks noChangeArrowheads="1"/>
            </p:cNvSpPr>
            <p:nvPr/>
          </p:nvSpPr>
          <p:spPr bwMode="auto">
            <a:xfrm>
              <a:off x="1379538" y="4223296"/>
              <a:ext cx="6381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otterdam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Freeform 48"/>
            <p:cNvSpPr>
              <a:spLocks/>
            </p:cNvSpPr>
            <p:nvPr/>
          </p:nvSpPr>
          <p:spPr bwMode="auto">
            <a:xfrm>
              <a:off x="1920876" y="4382046"/>
              <a:ext cx="973138" cy="971550"/>
            </a:xfrm>
            <a:custGeom>
              <a:avLst/>
              <a:gdLst>
                <a:gd name="T0" fmla="*/ 200 w 201"/>
                <a:gd name="T1" fmla="*/ 92 h 201"/>
                <a:gd name="T2" fmla="*/ 199 w 201"/>
                <a:gd name="T3" fmla="*/ 81 h 201"/>
                <a:gd name="T4" fmla="*/ 196 w 201"/>
                <a:gd name="T5" fmla="*/ 71 h 201"/>
                <a:gd name="T6" fmla="*/ 193 w 201"/>
                <a:gd name="T7" fmla="*/ 61 h 201"/>
                <a:gd name="T8" fmla="*/ 188 w 201"/>
                <a:gd name="T9" fmla="*/ 52 h 201"/>
                <a:gd name="T10" fmla="*/ 182 w 201"/>
                <a:gd name="T11" fmla="*/ 43 h 201"/>
                <a:gd name="T12" fmla="*/ 176 w 201"/>
                <a:gd name="T13" fmla="*/ 35 h 201"/>
                <a:gd name="T14" fmla="*/ 169 w 201"/>
                <a:gd name="T15" fmla="*/ 27 h 201"/>
                <a:gd name="T16" fmla="*/ 161 w 201"/>
                <a:gd name="T17" fmla="*/ 20 h 201"/>
                <a:gd name="T18" fmla="*/ 152 w 201"/>
                <a:gd name="T19" fmla="*/ 15 h 201"/>
                <a:gd name="T20" fmla="*/ 143 w 201"/>
                <a:gd name="T21" fmla="*/ 10 h 201"/>
                <a:gd name="T22" fmla="*/ 133 w 201"/>
                <a:gd name="T23" fmla="*/ 6 h 201"/>
                <a:gd name="T24" fmla="*/ 123 w 201"/>
                <a:gd name="T25" fmla="*/ 3 h 201"/>
                <a:gd name="T26" fmla="*/ 113 w 201"/>
                <a:gd name="T27" fmla="*/ 1 h 201"/>
                <a:gd name="T28" fmla="*/ 102 w 201"/>
                <a:gd name="T29" fmla="*/ 0 h 201"/>
                <a:gd name="T30" fmla="*/ 92 w 201"/>
                <a:gd name="T31" fmla="*/ 1 h 201"/>
                <a:gd name="T32" fmla="*/ 81 w 201"/>
                <a:gd name="T33" fmla="*/ 2 h 201"/>
                <a:gd name="T34" fmla="*/ 71 w 201"/>
                <a:gd name="T35" fmla="*/ 5 h 201"/>
                <a:gd name="T36" fmla="*/ 61 w 201"/>
                <a:gd name="T37" fmla="*/ 8 h 201"/>
                <a:gd name="T38" fmla="*/ 52 w 201"/>
                <a:gd name="T39" fmla="*/ 13 h 201"/>
                <a:gd name="T40" fmla="*/ 43 w 201"/>
                <a:gd name="T41" fmla="*/ 18 h 201"/>
                <a:gd name="T42" fmla="*/ 35 w 201"/>
                <a:gd name="T43" fmla="*/ 25 h 201"/>
                <a:gd name="T44" fmla="*/ 27 w 201"/>
                <a:gd name="T45" fmla="*/ 32 h 201"/>
                <a:gd name="T46" fmla="*/ 21 w 201"/>
                <a:gd name="T47" fmla="*/ 40 h 201"/>
                <a:gd name="T48" fmla="*/ 15 w 201"/>
                <a:gd name="T49" fmla="*/ 49 h 201"/>
                <a:gd name="T50" fmla="*/ 10 w 201"/>
                <a:gd name="T51" fmla="*/ 58 h 201"/>
                <a:gd name="T52" fmla="*/ 6 w 201"/>
                <a:gd name="T53" fmla="*/ 68 h 201"/>
                <a:gd name="T54" fmla="*/ 3 w 201"/>
                <a:gd name="T55" fmla="*/ 78 h 201"/>
                <a:gd name="T56" fmla="*/ 1 w 201"/>
                <a:gd name="T57" fmla="*/ 88 h 201"/>
                <a:gd name="T58" fmla="*/ 0 w 201"/>
                <a:gd name="T59" fmla="*/ 99 h 201"/>
                <a:gd name="T60" fmla="*/ 1 w 201"/>
                <a:gd name="T61" fmla="*/ 109 h 201"/>
                <a:gd name="T62" fmla="*/ 2 w 201"/>
                <a:gd name="T63" fmla="*/ 120 h 201"/>
                <a:gd name="T64" fmla="*/ 5 w 201"/>
                <a:gd name="T65" fmla="*/ 130 h 201"/>
                <a:gd name="T66" fmla="*/ 8 w 201"/>
                <a:gd name="T67" fmla="*/ 140 h 201"/>
                <a:gd name="T68" fmla="*/ 13 w 201"/>
                <a:gd name="T69" fmla="*/ 149 h 201"/>
                <a:gd name="T70" fmla="*/ 18 w 201"/>
                <a:gd name="T71" fmla="*/ 158 h 201"/>
                <a:gd name="T72" fmla="*/ 25 w 201"/>
                <a:gd name="T73" fmla="*/ 166 h 201"/>
                <a:gd name="T74" fmla="*/ 32 w 201"/>
                <a:gd name="T75" fmla="*/ 174 h 201"/>
                <a:gd name="T76" fmla="*/ 40 w 201"/>
                <a:gd name="T77" fmla="*/ 180 h 201"/>
                <a:gd name="T78" fmla="*/ 49 w 201"/>
                <a:gd name="T79" fmla="*/ 186 h 201"/>
                <a:gd name="T80" fmla="*/ 58 w 201"/>
                <a:gd name="T81" fmla="*/ 191 h 201"/>
                <a:gd name="T82" fmla="*/ 68 w 201"/>
                <a:gd name="T83" fmla="*/ 195 h 201"/>
                <a:gd name="T84" fmla="*/ 78 w 201"/>
                <a:gd name="T85" fmla="*/ 198 h 201"/>
                <a:gd name="T86" fmla="*/ 88 w 201"/>
                <a:gd name="T87" fmla="*/ 200 h 201"/>
                <a:gd name="T88" fmla="*/ 99 w 201"/>
                <a:gd name="T89" fmla="*/ 201 h 201"/>
                <a:gd name="T90" fmla="*/ 109 w 201"/>
                <a:gd name="T91" fmla="*/ 200 h 201"/>
                <a:gd name="T92" fmla="*/ 120 w 201"/>
                <a:gd name="T93" fmla="*/ 199 h 201"/>
                <a:gd name="T94" fmla="*/ 130 w 201"/>
                <a:gd name="T95" fmla="*/ 196 h 201"/>
                <a:gd name="T96" fmla="*/ 140 w 201"/>
                <a:gd name="T97" fmla="*/ 193 h 201"/>
                <a:gd name="T98" fmla="*/ 149 w 201"/>
                <a:gd name="T99" fmla="*/ 188 h 201"/>
                <a:gd name="T100" fmla="*/ 158 w 201"/>
                <a:gd name="T101" fmla="*/ 183 h 201"/>
                <a:gd name="T102" fmla="*/ 166 w 201"/>
                <a:gd name="T103" fmla="*/ 176 h 201"/>
                <a:gd name="T104" fmla="*/ 174 w 201"/>
                <a:gd name="T105" fmla="*/ 169 h 201"/>
                <a:gd name="T106" fmla="*/ 180 w 201"/>
                <a:gd name="T107" fmla="*/ 161 h 201"/>
                <a:gd name="T108" fmla="*/ 186 w 201"/>
                <a:gd name="T109" fmla="*/ 152 h 201"/>
                <a:gd name="T110" fmla="*/ 191 w 201"/>
                <a:gd name="T111" fmla="*/ 143 h 201"/>
                <a:gd name="T112" fmla="*/ 195 w 201"/>
                <a:gd name="T113" fmla="*/ 133 h 201"/>
                <a:gd name="T114" fmla="*/ 198 w 201"/>
                <a:gd name="T115" fmla="*/ 123 h 201"/>
                <a:gd name="T116" fmla="*/ 200 w 201"/>
                <a:gd name="T117" fmla="*/ 113 h 201"/>
                <a:gd name="T118" fmla="*/ 201 w 201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1" h="201">
                  <a:moveTo>
                    <a:pt x="201" y="100"/>
                  </a:moveTo>
                  <a:lnTo>
                    <a:pt x="201" y="99"/>
                  </a:lnTo>
                  <a:lnTo>
                    <a:pt x="201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200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9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8" y="76"/>
                  </a:lnTo>
                  <a:lnTo>
                    <a:pt x="197" y="75"/>
                  </a:lnTo>
                  <a:lnTo>
                    <a:pt x="197" y="73"/>
                  </a:lnTo>
                  <a:lnTo>
                    <a:pt x="196" y="71"/>
                  </a:lnTo>
                  <a:lnTo>
                    <a:pt x="196" y="69"/>
                  </a:lnTo>
                  <a:lnTo>
                    <a:pt x="195" y="68"/>
                  </a:lnTo>
                  <a:lnTo>
                    <a:pt x="195" y="66"/>
                  </a:lnTo>
                  <a:lnTo>
                    <a:pt x="194" y="65"/>
                  </a:lnTo>
                  <a:lnTo>
                    <a:pt x="193" y="63"/>
                  </a:lnTo>
                  <a:lnTo>
                    <a:pt x="193" y="61"/>
                  </a:lnTo>
                  <a:lnTo>
                    <a:pt x="192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90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5" y="33"/>
                  </a:lnTo>
                  <a:lnTo>
                    <a:pt x="174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1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4" y="15"/>
                  </a:lnTo>
                  <a:lnTo>
                    <a:pt x="152" y="15"/>
                  </a:lnTo>
                  <a:lnTo>
                    <a:pt x="151" y="14"/>
                  </a:lnTo>
                  <a:lnTo>
                    <a:pt x="149" y="13"/>
                  </a:lnTo>
                  <a:lnTo>
                    <a:pt x="147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10"/>
                  </a:lnTo>
                  <a:lnTo>
                    <a:pt x="141" y="9"/>
                  </a:lnTo>
                  <a:lnTo>
                    <a:pt x="140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5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30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5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20" y="2"/>
                  </a:lnTo>
                  <a:lnTo>
                    <a:pt x="118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3" y="1"/>
                  </a:lnTo>
                  <a:lnTo>
                    <a:pt x="111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6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2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5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5" y="4"/>
                  </a:lnTo>
                  <a:lnTo>
                    <a:pt x="73" y="4"/>
                  </a:lnTo>
                  <a:lnTo>
                    <a:pt x="71" y="5"/>
                  </a:lnTo>
                  <a:lnTo>
                    <a:pt x="70" y="5"/>
                  </a:lnTo>
                  <a:lnTo>
                    <a:pt x="68" y="6"/>
                  </a:lnTo>
                  <a:lnTo>
                    <a:pt x="66" y="6"/>
                  </a:lnTo>
                  <a:lnTo>
                    <a:pt x="65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10"/>
                  </a:lnTo>
                  <a:lnTo>
                    <a:pt x="57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9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5" y="17"/>
                  </a:lnTo>
                  <a:lnTo>
                    <a:pt x="43" y="18"/>
                  </a:lnTo>
                  <a:lnTo>
                    <a:pt x="42" y="19"/>
                  </a:lnTo>
                  <a:lnTo>
                    <a:pt x="40" y="20"/>
                  </a:lnTo>
                  <a:lnTo>
                    <a:pt x="39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5" y="25"/>
                  </a:lnTo>
                  <a:lnTo>
                    <a:pt x="34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30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5"/>
                  </a:lnTo>
                  <a:lnTo>
                    <a:pt x="24" y="36"/>
                  </a:lnTo>
                  <a:lnTo>
                    <a:pt x="23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0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7" y="46"/>
                  </a:lnTo>
                  <a:lnTo>
                    <a:pt x="16" y="47"/>
                  </a:lnTo>
                  <a:lnTo>
                    <a:pt x="15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1" y="57"/>
                  </a:lnTo>
                  <a:lnTo>
                    <a:pt x="10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8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3" y="80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2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1" y="106"/>
                  </a:lnTo>
                  <a:lnTo>
                    <a:pt x="1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2" y="116"/>
                  </a:lnTo>
                  <a:lnTo>
                    <a:pt x="2" y="118"/>
                  </a:lnTo>
                  <a:lnTo>
                    <a:pt x="2" y="120"/>
                  </a:lnTo>
                  <a:lnTo>
                    <a:pt x="3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30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8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10" y="143"/>
                  </a:lnTo>
                  <a:lnTo>
                    <a:pt x="11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1"/>
                  </a:lnTo>
                  <a:lnTo>
                    <a:pt x="15" y="152"/>
                  </a:lnTo>
                  <a:lnTo>
                    <a:pt x="16" y="154"/>
                  </a:lnTo>
                  <a:lnTo>
                    <a:pt x="17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20" y="159"/>
                  </a:lnTo>
                  <a:lnTo>
                    <a:pt x="21" y="161"/>
                  </a:lnTo>
                  <a:lnTo>
                    <a:pt x="22" y="162"/>
                  </a:lnTo>
                  <a:lnTo>
                    <a:pt x="23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30" y="171"/>
                  </a:lnTo>
                  <a:lnTo>
                    <a:pt x="31" y="173"/>
                  </a:lnTo>
                  <a:lnTo>
                    <a:pt x="32" y="174"/>
                  </a:lnTo>
                  <a:lnTo>
                    <a:pt x="34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2" y="181"/>
                  </a:lnTo>
                  <a:lnTo>
                    <a:pt x="43" y="183"/>
                  </a:lnTo>
                  <a:lnTo>
                    <a:pt x="45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7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5" y="194"/>
                  </a:lnTo>
                  <a:lnTo>
                    <a:pt x="66" y="195"/>
                  </a:lnTo>
                  <a:lnTo>
                    <a:pt x="68" y="195"/>
                  </a:lnTo>
                  <a:lnTo>
                    <a:pt x="70" y="196"/>
                  </a:lnTo>
                  <a:lnTo>
                    <a:pt x="71" y="196"/>
                  </a:lnTo>
                  <a:lnTo>
                    <a:pt x="73" y="197"/>
                  </a:lnTo>
                  <a:lnTo>
                    <a:pt x="75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80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7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9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6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3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20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5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30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5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40" y="193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90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1" y="187"/>
                  </a:lnTo>
                  <a:lnTo>
                    <a:pt x="152" y="186"/>
                  </a:lnTo>
                  <a:lnTo>
                    <a:pt x="154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3"/>
                  </a:lnTo>
                  <a:lnTo>
                    <a:pt x="159" y="181"/>
                  </a:lnTo>
                  <a:lnTo>
                    <a:pt x="161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4" y="169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90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2" y="141"/>
                  </a:lnTo>
                  <a:lnTo>
                    <a:pt x="193" y="140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5" y="135"/>
                  </a:lnTo>
                  <a:lnTo>
                    <a:pt x="195" y="133"/>
                  </a:lnTo>
                  <a:lnTo>
                    <a:pt x="196" y="131"/>
                  </a:lnTo>
                  <a:lnTo>
                    <a:pt x="196" y="130"/>
                  </a:lnTo>
                  <a:lnTo>
                    <a:pt x="197" y="128"/>
                  </a:lnTo>
                  <a:lnTo>
                    <a:pt x="197" y="126"/>
                  </a:lnTo>
                  <a:lnTo>
                    <a:pt x="198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9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200" y="114"/>
                  </a:lnTo>
                  <a:lnTo>
                    <a:pt x="200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1" y="104"/>
                  </a:lnTo>
                  <a:lnTo>
                    <a:pt x="201" y="102"/>
                  </a:lnTo>
                  <a:lnTo>
                    <a:pt x="201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52" name="Rectangle 49"/>
            <p:cNvSpPr>
              <a:spLocks noChangeArrowheads="1"/>
            </p:cNvSpPr>
            <p:nvPr/>
          </p:nvSpPr>
          <p:spPr bwMode="auto">
            <a:xfrm>
              <a:off x="2203451" y="4209008"/>
              <a:ext cx="5397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ansbig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Freeform 50"/>
            <p:cNvSpPr>
              <a:spLocks/>
            </p:cNvSpPr>
            <p:nvPr/>
          </p:nvSpPr>
          <p:spPr bwMode="auto">
            <a:xfrm>
              <a:off x="1603376" y="4942433"/>
              <a:ext cx="966788" cy="965200"/>
            </a:xfrm>
            <a:custGeom>
              <a:avLst/>
              <a:gdLst>
                <a:gd name="T0" fmla="*/ 199 w 200"/>
                <a:gd name="T1" fmla="*/ 91 h 200"/>
                <a:gd name="T2" fmla="*/ 198 w 200"/>
                <a:gd name="T3" fmla="*/ 81 h 200"/>
                <a:gd name="T4" fmla="*/ 195 w 200"/>
                <a:gd name="T5" fmla="*/ 71 h 200"/>
                <a:gd name="T6" fmla="*/ 192 w 200"/>
                <a:gd name="T7" fmla="*/ 61 h 200"/>
                <a:gd name="T8" fmla="*/ 187 w 200"/>
                <a:gd name="T9" fmla="*/ 52 h 200"/>
                <a:gd name="T10" fmla="*/ 182 w 200"/>
                <a:gd name="T11" fmla="*/ 43 h 200"/>
                <a:gd name="T12" fmla="*/ 175 w 200"/>
                <a:gd name="T13" fmla="*/ 34 h 200"/>
                <a:gd name="T14" fmla="*/ 168 w 200"/>
                <a:gd name="T15" fmla="*/ 27 h 200"/>
                <a:gd name="T16" fmla="*/ 160 w 200"/>
                <a:gd name="T17" fmla="*/ 20 h 200"/>
                <a:gd name="T18" fmla="*/ 151 w 200"/>
                <a:gd name="T19" fmla="*/ 14 h 200"/>
                <a:gd name="T20" fmla="*/ 142 w 200"/>
                <a:gd name="T21" fmla="*/ 9 h 200"/>
                <a:gd name="T22" fmla="*/ 132 w 200"/>
                <a:gd name="T23" fmla="*/ 5 h 200"/>
                <a:gd name="T24" fmla="*/ 122 w 200"/>
                <a:gd name="T25" fmla="*/ 3 h 200"/>
                <a:gd name="T26" fmla="*/ 112 w 200"/>
                <a:gd name="T27" fmla="*/ 1 h 200"/>
                <a:gd name="T28" fmla="*/ 101 w 200"/>
                <a:gd name="T29" fmla="*/ 0 h 200"/>
                <a:gd name="T30" fmla="*/ 91 w 200"/>
                <a:gd name="T31" fmla="*/ 0 h 200"/>
                <a:gd name="T32" fmla="*/ 81 w 200"/>
                <a:gd name="T33" fmla="*/ 2 h 200"/>
                <a:gd name="T34" fmla="*/ 70 w 200"/>
                <a:gd name="T35" fmla="*/ 4 h 200"/>
                <a:gd name="T36" fmla="*/ 61 w 200"/>
                <a:gd name="T37" fmla="*/ 8 h 200"/>
                <a:gd name="T38" fmla="*/ 51 w 200"/>
                <a:gd name="T39" fmla="*/ 12 h 200"/>
                <a:gd name="T40" fmla="*/ 42 w 200"/>
                <a:gd name="T41" fmla="*/ 18 h 200"/>
                <a:gd name="T42" fmla="*/ 34 w 200"/>
                <a:gd name="T43" fmla="*/ 25 h 200"/>
                <a:gd name="T44" fmla="*/ 27 w 200"/>
                <a:gd name="T45" fmla="*/ 32 h 200"/>
                <a:gd name="T46" fmla="*/ 20 w 200"/>
                <a:gd name="T47" fmla="*/ 40 h 200"/>
                <a:gd name="T48" fmla="*/ 14 w 200"/>
                <a:gd name="T49" fmla="*/ 49 h 200"/>
                <a:gd name="T50" fmla="*/ 9 w 200"/>
                <a:gd name="T51" fmla="*/ 58 h 200"/>
                <a:gd name="T52" fmla="*/ 5 w 200"/>
                <a:gd name="T53" fmla="*/ 68 h 200"/>
                <a:gd name="T54" fmla="*/ 2 w 200"/>
                <a:gd name="T55" fmla="*/ 78 h 200"/>
                <a:gd name="T56" fmla="*/ 0 w 200"/>
                <a:gd name="T57" fmla="*/ 88 h 200"/>
                <a:gd name="T58" fmla="*/ 0 w 200"/>
                <a:gd name="T59" fmla="*/ 98 h 200"/>
                <a:gd name="T60" fmla="*/ 0 w 200"/>
                <a:gd name="T61" fmla="*/ 109 h 200"/>
                <a:gd name="T62" fmla="*/ 2 w 200"/>
                <a:gd name="T63" fmla="*/ 119 h 200"/>
                <a:gd name="T64" fmla="*/ 4 w 200"/>
                <a:gd name="T65" fmla="*/ 129 h 200"/>
                <a:gd name="T66" fmla="*/ 8 w 200"/>
                <a:gd name="T67" fmla="*/ 139 h 200"/>
                <a:gd name="T68" fmla="*/ 12 w 200"/>
                <a:gd name="T69" fmla="*/ 149 h 200"/>
                <a:gd name="T70" fmla="*/ 18 w 200"/>
                <a:gd name="T71" fmla="*/ 158 h 200"/>
                <a:gd name="T72" fmla="*/ 24 w 200"/>
                <a:gd name="T73" fmla="*/ 166 h 200"/>
                <a:gd name="T74" fmla="*/ 31 w 200"/>
                <a:gd name="T75" fmla="*/ 173 h 200"/>
                <a:gd name="T76" fmla="*/ 40 w 200"/>
                <a:gd name="T77" fmla="*/ 180 h 200"/>
                <a:gd name="T78" fmla="*/ 48 w 200"/>
                <a:gd name="T79" fmla="*/ 186 h 200"/>
                <a:gd name="T80" fmla="*/ 57 w 200"/>
                <a:gd name="T81" fmla="*/ 191 h 200"/>
                <a:gd name="T82" fmla="*/ 67 w 200"/>
                <a:gd name="T83" fmla="*/ 195 h 200"/>
                <a:gd name="T84" fmla="*/ 77 w 200"/>
                <a:gd name="T85" fmla="*/ 198 h 200"/>
                <a:gd name="T86" fmla="*/ 88 w 200"/>
                <a:gd name="T87" fmla="*/ 200 h 200"/>
                <a:gd name="T88" fmla="*/ 98 w 200"/>
                <a:gd name="T89" fmla="*/ 200 h 200"/>
                <a:gd name="T90" fmla="*/ 108 w 200"/>
                <a:gd name="T91" fmla="*/ 200 h 200"/>
                <a:gd name="T92" fmla="*/ 119 w 200"/>
                <a:gd name="T93" fmla="*/ 198 h 200"/>
                <a:gd name="T94" fmla="*/ 129 w 200"/>
                <a:gd name="T95" fmla="*/ 196 h 200"/>
                <a:gd name="T96" fmla="*/ 139 w 200"/>
                <a:gd name="T97" fmla="*/ 192 h 200"/>
                <a:gd name="T98" fmla="*/ 148 w 200"/>
                <a:gd name="T99" fmla="*/ 188 h 200"/>
                <a:gd name="T100" fmla="*/ 157 w 200"/>
                <a:gd name="T101" fmla="*/ 182 h 200"/>
                <a:gd name="T102" fmla="*/ 165 w 200"/>
                <a:gd name="T103" fmla="*/ 176 h 200"/>
                <a:gd name="T104" fmla="*/ 173 w 200"/>
                <a:gd name="T105" fmla="*/ 168 h 200"/>
                <a:gd name="T106" fmla="*/ 180 w 200"/>
                <a:gd name="T107" fmla="*/ 160 h 200"/>
                <a:gd name="T108" fmla="*/ 186 w 200"/>
                <a:gd name="T109" fmla="*/ 152 h 200"/>
                <a:gd name="T110" fmla="*/ 190 w 200"/>
                <a:gd name="T111" fmla="*/ 142 h 200"/>
                <a:gd name="T112" fmla="*/ 194 w 200"/>
                <a:gd name="T113" fmla="*/ 133 h 200"/>
                <a:gd name="T114" fmla="*/ 197 w 200"/>
                <a:gd name="T115" fmla="*/ 123 h 200"/>
                <a:gd name="T116" fmla="*/ 199 w 200"/>
                <a:gd name="T117" fmla="*/ 112 h 200"/>
                <a:gd name="T118" fmla="*/ 200 w 200"/>
                <a:gd name="T119" fmla="*/ 102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0">
                  <a:moveTo>
                    <a:pt x="200" y="100"/>
                  </a:moveTo>
                  <a:lnTo>
                    <a:pt x="200" y="98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199" y="91"/>
                  </a:lnTo>
                  <a:lnTo>
                    <a:pt x="199" y="90"/>
                  </a:lnTo>
                  <a:lnTo>
                    <a:pt x="199" y="88"/>
                  </a:lnTo>
                  <a:lnTo>
                    <a:pt x="199" y="86"/>
                  </a:lnTo>
                  <a:lnTo>
                    <a:pt x="199" y="84"/>
                  </a:lnTo>
                  <a:lnTo>
                    <a:pt x="198" y="83"/>
                  </a:lnTo>
                  <a:lnTo>
                    <a:pt x="198" y="81"/>
                  </a:lnTo>
                  <a:lnTo>
                    <a:pt x="198" y="79"/>
                  </a:lnTo>
                  <a:lnTo>
                    <a:pt x="197" y="78"/>
                  </a:lnTo>
                  <a:lnTo>
                    <a:pt x="197" y="76"/>
                  </a:lnTo>
                  <a:lnTo>
                    <a:pt x="196" y="74"/>
                  </a:lnTo>
                  <a:lnTo>
                    <a:pt x="196" y="73"/>
                  </a:lnTo>
                  <a:lnTo>
                    <a:pt x="195" y="71"/>
                  </a:lnTo>
                  <a:lnTo>
                    <a:pt x="195" y="69"/>
                  </a:lnTo>
                  <a:lnTo>
                    <a:pt x="194" y="68"/>
                  </a:lnTo>
                  <a:lnTo>
                    <a:pt x="194" y="66"/>
                  </a:lnTo>
                  <a:lnTo>
                    <a:pt x="193" y="64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59"/>
                  </a:lnTo>
                  <a:lnTo>
                    <a:pt x="190" y="58"/>
                  </a:lnTo>
                  <a:lnTo>
                    <a:pt x="190" y="56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7" y="52"/>
                  </a:lnTo>
                  <a:lnTo>
                    <a:pt x="186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1"/>
                  </a:lnTo>
                  <a:lnTo>
                    <a:pt x="180" y="40"/>
                  </a:lnTo>
                  <a:lnTo>
                    <a:pt x="179" y="38"/>
                  </a:lnTo>
                  <a:lnTo>
                    <a:pt x="178" y="37"/>
                  </a:lnTo>
                  <a:lnTo>
                    <a:pt x="176" y="36"/>
                  </a:lnTo>
                  <a:lnTo>
                    <a:pt x="175" y="34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29"/>
                  </a:lnTo>
                  <a:lnTo>
                    <a:pt x="169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5" y="25"/>
                  </a:lnTo>
                  <a:lnTo>
                    <a:pt x="164" y="23"/>
                  </a:lnTo>
                  <a:lnTo>
                    <a:pt x="163" y="22"/>
                  </a:lnTo>
                  <a:lnTo>
                    <a:pt x="161" y="21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4" y="16"/>
                  </a:lnTo>
                  <a:lnTo>
                    <a:pt x="153" y="15"/>
                  </a:lnTo>
                  <a:lnTo>
                    <a:pt x="151" y="14"/>
                  </a:lnTo>
                  <a:lnTo>
                    <a:pt x="150" y="13"/>
                  </a:lnTo>
                  <a:lnTo>
                    <a:pt x="148" y="12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9"/>
                  </a:lnTo>
                  <a:lnTo>
                    <a:pt x="140" y="9"/>
                  </a:lnTo>
                  <a:lnTo>
                    <a:pt x="139" y="8"/>
                  </a:lnTo>
                  <a:lnTo>
                    <a:pt x="137" y="7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2" y="5"/>
                  </a:lnTo>
                  <a:lnTo>
                    <a:pt x="131" y="5"/>
                  </a:lnTo>
                  <a:lnTo>
                    <a:pt x="129" y="4"/>
                  </a:lnTo>
                  <a:lnTo>
                    <a:pt x="127" y="4"/>
                  </a:lnTo>
                  <a:lnTo>
                    <a:pt x="126" y="3"/>
                  </a:lnTo>
                  <a:lnTo>
                    <a:pt x="124" y="3"/>
                  </a:lnTo>
                  <a:lnTo>
                    <a:pt x="122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1"/>
                  </a:lnTo>
                  <a:lnTo>
                    <a:pt x="115" y="1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101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3" y="0"/>
                  </a:lnTo>
                  <a:lnTo>
                    <a:pt x="91" y="0"/>
                  </a:lnTo>
                  <a:lnTo>
                    <a:pt x="89" y="0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1"/>
                  </a:lnTo>
                  <a:lnTo>
                    <a:pt x="82" y="1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4" y="3"/>
                  </a:lnTo>
                  <a:lnTo>
                    <a:pt x="72" y="4"/>
                  </a:lnTo>
                  <a:lnTo>
                    <a:pt x="70" y="4"/>
                  </a:lnTo>
                  <a:lnTo>
                    <a:pt x="69" y="5"/>
                  </a:lnTo>
                  <a:lnTo>
                    <a:pt x="67" y="5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2" y="7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7" y="9"/>
                  </a:lnTo>
                  <a:lnTo>
                    <a:pt x="56" y="10"/>
                  </a:lnTo>
                  <a:lnTo>
                    <a:pt x="54" y="11"/>
                  </a:lnTo>
                  <a:lnTo>
                    <a:pt x="53" y="12"/>
                  </a:lnTo>
                  <a:lnTo>
                    <a:pt x="51" y="12"/>
                  </a:lnTo>
                  <a:lnTo>
                    <a:pt x="50" y="13"/>
                  </a:lnTo>
                  <a:lnTo>
                    <a:pt x="48" y="14"/>
                  </a:lnTo>
                  <a:lnTo>
                    <a:pt x="47" y="15"/>
                  </a:lnTo>
                  <a:lnTo>
                    <a:pt x="45" y="16"/>
                  </a:lnTo>
                  <a:lnTo>
                    <a:pt x="44" y="17"/>
                  </a:lnTo>
                  <a:lnTo>
                    <a:pt x="42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1"/>
                  </a:lnTo>
                  <a:lnTo>
                    <a:pt x="37" y="22"/>
                  </a:lnTo>
                  <a:lnTo>
                    <a:pt x="35" y="23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1" y="27"/>
                  </a:lnTo>
                  <a:lnTo>
                    <a:pt x="30" y="28"/>
                  </a:lnTo>
                  <a:lnTo>
                    <a:pt x="29" y="29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5" y="33"/>
                  </a:lnTo>
                  <a:lnTo>
                    <a:pt x="24" y="34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8"/>
                  </a:lnTo>
                  <a:lnTo>
                    <a:pt x="20" y="40"/>
                  </a:lnTo>
                  <a:lnTo>
                    <a:pt x="19" y="41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1" y="53"/>
                  </a:lnTo>
                  <a:lnTo>
                    <a:pt x="11" y="55"/>
                  </a:lnTo>
                  <a:lnTo>
                    <a:pt x="10" y="56"/>
                  </a:lnTo>
                  <a:lnTo>
                    <a:pt x="9" y="58"/>
                  </a:lnTo>
                  <a:lnTo>
                    <a:pt x="8" y="59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6" y="64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4"/>
                  </a:lnTo>
                  <a:lnTo>
                    <a:pt x="3" y="76"/>
                  </a:lnTo>
                  <a:lnTo>
                    <a:pt x="2" y="78"/>
                  </a:lnTo>
                  <a:lnTo>
                    <a:pt x="2" y="79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4"/>
                  </a:lnTo>
                  <a:lnTo>
                    <a:pt x="1" y="86"/>
                  </a:lnTo>
                  <a:lnTo>
                    <a:pt x="0" y="88"/>
                  </a:lnTo>
                  <a:lnTo>
                    <a:pt x="0" y="90"/>
                  </a:lnTo>
                  <a:lnTo>
                    <a:pt x="0" y="91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19"/>
                  </a:lnTo>
                  <a:lnTo>
                    <a:pt x="2" y="121"/>
                  </a:lnTo>
                  <a:lnTo>
                    <a:pt x="2" y="123"/>
                  </a:lnTo>
                  <a:lnTo>
                    <a:pt x="3" y="124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29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4"/>
                  </a:lnTo>
                  <a:lnTo>
                    <a:pt x="6" y="136"/>
                  </a:lnTo>
                  <a:lnTo>
                    <a:pt x="7" y="138"/>
                  </a:lnTo>
                  <a:lnTo>
                    <a:pt x="8" y="139"/>
                  </a:lnTo>
                  <a:lnTo>
                    <a:pt x="8" y="141"/>
                  </a:lnTo>
                  <a:lnTo>
                    <a:pt x="9" y="142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1" y="147"/>
                  </a:lnTo>
                  <a:lnTo>
                    <a:pt x="12" y="149"/>
                  </a:lnTo>
                  <a:lnTo>
                    <a:pt x="13" y="150"/>
                  </a:lnTo>
                  <a:lnTo>
                    <a:pt x="14" y="152"/>
                  </a:lnTo>
                  <a:lnTo>
                    <a:pt x="15" y="153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0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5" y="167"/>
                  </a:lnTo>
                  <a:lnTo>
                    <a:pt x="27" y="168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2"/>
                  </a:lnTo>
                  <a:lnTo>
                    <a:pt x="31" y="173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5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2" y="182"/>
                  </a:lnTo>
                  <a:lnTo>
                    <a:pt x="44" y="183"/>
                  </a:lnTo>
                  <a:lnTo>
                    <a:pt x="45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1" y="188"/>
                  </a:lnTo>
                  <a:lnTo>
                    <a:pt x="53" y="189"/>
                  </a:lnTo>
                  <a:lnTo>
                    <a:pt x="54" y="189"/>
                  </a:lnTo>
                  <a:lnTo>
                    <a:pt x="56" y="190"/>
                  </a:lnTo>
                  <a:lnTo>
                    <a:pt x="57" y="191"/>
                  </a:lnTo>
                  <a:lnTo>
                    <a:pt x="59" y="192"/>
                  </a:lnTo>
                  <a:lnTo>
                    <a:pt x="61" y="192"/>
                  </a:lnTo>
                  <a:lnTo>
                    <a:pt x="62" y="193"/>
                  </a:lnTo>
                  <a:lnTo>
                    <a:pt x="64" y="194"/>
                  </a:lnTo>
                  <a:lnTo>
                    <a:pt x="66" y="194"/>
                  </a:lnTo>
                  <a:lnTo>
                    <a:pt x="67" y="195"/>
                  </a:lnTo>
                  <a:lnTo>
                    <a:pt x="69" y="195"/>
                  </a:lnTo>
                  <a:lnTo>
                    <a:pt x="70" y="196"/>
                  </a:lnTo>
                  <a:lnTo>
                    <a:pt x="72" y="196"/>
                  </a:lnTo>
                  <a:lnTo>
                    <a:pt x="74" y="197"/>
                  </a:lnTo>
                  <a:lnTo>
                    <a:pt x="76" y="197"/>
                  </a:lnTo>
                  <a:lnTo>
                    <a:pt x="77" y="198"/>
                  </a:lnTo>
                  <a:lnTo>
                    <a:pt x="79" y="198"/>
                  </a:lnTo>
                  <a:lnTo>
                    <a:pt x="81" y="198"/>
                  </a:lnTo>
                  <a:lnTo>
                    <a:pt x="82" y="199"/>
                  </a:lnTo>
                  <a:lnTo>
                    <a:pt x="84" y="199"/>
                  </a:lnTo>
                  <a:lnTo>
                    <a:pt x="86" y="199"/>
                  </a:lnTo>
                  <a:lnTo>
                    <a:pt x="88" y="200"/>
                  </a:lnTo>
                  <a:lnTo>
                    <a:pt x="89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6" y="200"/>
                  </a:lnTo>
                  <a:lnTo>
                    <a:pt x="98" y="200"/>
                  </a:lnTo>
                  <a:lnTo>
                    <a:pt x="100" y="200"/>
                  </a:lnTo>
                  <a:lnTo>
                    <a:pt x="101" y="200"/>
                  </a:lnTo>
                  <a:lnTo>
                    <a:pt x="103" y="200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8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199"/>
                  </a:lnTo>
                  <a:lnTo>
                    <a:pt x="115" y="199"/>
                  </a:lnTo>
                  <a:lnTo>
                    <a:pt x="117" y="199"/>
                  </a:lnTo>
                  <a:lnTo>
                    <a:pt x="119" y="198"/>
                  </a:lnTo>
                  <a:lnTo>
                    <a:pt x="121" y="198"/>
                  </a:lnTo>
                  <a:lnTo>
                    <a:pt x="122" y="198"/>
                  </a:lnTo>
                  <a:lnTo>
                    <a:pt x="124" y="197"/>
                  </a:lnTo>
                  <a:lnTo>
                    <a:pt x="126" y="197"/>
                  </a:lnTo>
                  <a:lnTo>
                    <a:pt x="127" y="196"/>
                  </a:lnTo>
                  <a:lnTo>
                    <a:pt x="129" y="196"/>
                  </a:lnTo>
                  <a:lnTo>
                    <a:pt x="131" y="195"/>
                  </a:lnTo>
                  <a:lnTo>
                    <a:pt x="132" y="195"/>
                  </a:lnTo>
                  <a:lnTo>
                    <a:pt x="134" y="194"/>
                  </a:lnTo>
                  <a:lnTo>
                    <a:pt x="136" y="194"/>
                  </a:lnTo>
                  <a:lnTo>
                    <a:pt x="137" y="193"/>
                  </a:lnTo>
                  <a:lnTo>
                    <a:pt x="139" y="192"/>
                  </a:lnTo>
                  <a:lnTo>
                    <a:pt x="140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89"/>
                  </a:lnTo>
                  <a:lnTo>
                    <a:pt x="147" y="189"/>
                  </a:lnTo>
                  <a:lnTo>
                    <a:pt x="148" y="188"/>
                  </a:lnTo>
                  <a:lnTo>
                    <a:pt x="150" y="187"/>
                  </a:lnTo>
                  <a:lnTo>
                    <a:pt x="151" y="186"/>
                  </a:lnTo>
                  <a:lnTo>
                    <a:pt x="153" y="185"/>
                  </a:lnTo>
                  <a:lnTo>
                    <a:pt x="154" y="184"/>
                  </a:lnTo>
                  <a:lnTo>
                    <a:pt x="156" y="183"/>
                  </a:lnTo>
                  <a:lnTo>
                    <a:pt x="157" y="182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1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5" y="176"/>
                  </a:lnTo>
                  <a:lnTo>
                    <a:pt x="167" y="175"/>
                  </a:lnTo>
                  <a:lnTo>
                    <a:pt x="168" y="173"/>
                  </a:lnTo>
                  <a:lnTo>
                    <a:pt x="169" y="172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8"/>
                  </a:lnTo>
                  <a:lnTo>
                    <a:pt x="174" y="167"/>
                  </a:lnTo>
                  <a:lnTo>
                    <a:pt x="175" y="166"/>
                  </a:lnTo>
                  <a:lnTo>
                    <a:pt x="176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0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3"/>
                  </a:lnTo>
                  <a:lnTo>
                    <a:pt x="186" y="152"/>
                  </a:lnTo>
                  <a:lnTo>
                    <a:pt x="186" y="150"/>
                  </a:lnTo>
                  <a:lnTo>
                    <a:pt x="187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0" y="142"/>
                  </a:lnTo>
                  <a:lnTo>
                    <a:pt x="191" y="141"/>
                  </a:lnTo>
                  <a:lnTo>
                    <a:pt x="192" y="139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4"/>
                  </a:lnTo>
                  <a:lnTo>
                    <a:pt x="194" y="133"/>
                  </a:lnTo>
                  <a:lnTo>
                    <a:pt x="195" y="131"/>
                  </a:lnTo>
                  <a:lnTo>
                    <a:pt x="195" y="129"/>
                  </a:lnTo>
                  <a:lnTo>
                    <a:pt x="196" y="128"/>
                  </a:lnTo>
                  <a:lnTo>
                    <a:pt x="196" y="126"/>
                  </a:lnTo>
                  <a:lnTo>
                    <a:pt x="197" y="124"/>
                  </a:lnTo>
                  <a:lnTo>
                    <a:pt x="197" y="123"/>
                  </a:lnTo>
                  <a:lnTo>
                    <a:pt x="198" y="121"/>
                  </a:lnTo>
                  <a:lnTo>
                    <a:pt x="198" y="119"/>
                  </a:lnTo>
                  <a:lnTo>
                    <a:pt x="198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2"/>
                  </a:lnTo>
                  <a:lnTo>
                    <a:pt x="199" y="111"/>
                  </a:lnTo>
                  <a:lnTo>
                    <a:pt x="199" y="109"/>
                  </a:lnTo>
                  <a:lnTo>
                    <a:pt x="200" y="107"/>
                  </a:lnTo>
                  <a:lnTo>
                    <a:pt x="200" y="105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54" name="Rectangle 51"/>
            <p:cNvSpPr>
              <a:spLocks noChangeArrowheads="1"/>
            </p:cNvSpPr>
            <p:nvPr/>
          </p:nvSpPr>
          <p:spPr bwMode="auto">
            <a:xfrm>
              <a:off x="1892301" y="5961608"/>
              <a:ext cx="387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inz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4"/>
            <p:cNvSpPr>
              <a:spLocks noChangeArrowheads="1"/>
            </p:cNvSpPr>
            <p:nvPr/>
          </p:nvSpPr>
          <p:spPr bwMode="auto">
            <a:xfrm>
              <a:off x="1919288" y="5545683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687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5"/>
            <p:cNvSpPr>
              <a:spLocks noChangeArrowheads="1"/>
            </p:cNvSpPr>
            <p:nvPr/>
          </p:nvSpPr>
          <p:spPr bwMode="auto">
            <a:xfrm>
              <a:off x="2439988" y="467255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7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56"/>
            <p:cNvSpPr>
              <a:spLocks noChangeArrowheads="1"/>
            </p:cNvSpPr>
            <p:nvPr/>
          </p:nvSpPr>
          <p:spPr bwMode="auto">
            <a:xfrm>
              <a:off x="2197101" y="5105946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57"/>
            <p:cNvSpPr>
              <a:spLocks noChangeArrowheads="1"/>
            </p:cNvSpPr>
            <p:nvPr/>
          </p:nvSpPr>
          <p:spPr bwMode="auto">
            <a:xfrm>
              <a:off x="1436688" y="4672558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41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58"/>
            <p:cNvSpPr>
              <a:spLocks noChangeArrowheads="1"/>
            </p:cNvSpPr>
            <p:nvPr/>
          </p:nvSpPr>
          <p:spPr bwMode="auto">
            <a:xfrm>
              <a:off x="1714501" y="5105946"/>
              <a:ext cx="260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79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59"/>
            <p:cNvSpPr>
              <a:spLocks noChangeArrowheads="1"/>
            </p:cNvSpPr>
            <p:nvPr/>
          </p:nvSpPr>
          <p:spPr bwMode="auto">
            <a:xfrm>
              <a:off x="1989138" y="4705896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8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60"/>
            <p:cNvSpPr>
              <a:spLocks noChangeArrowheads="1"/>
            </p:cNvSpPr>
            <p:nvPr/>
          </p:nvSpPr>
          <p:spPr bwMode="auto">
            <a:xfrm>
              <a:off x="1989138" y="4994821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6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Freeform 61"/>
            <p:cNvSpPr>
              <a:spLocks/>
            </p:cNvSpPr>
            <p:nvPr/>
          </p:nvSpPr>
          <p:spPr bwMode="auto">
            <a:xfrm>
              <a:off x="4064001" y="4382046"/>
              <a:ext cx="971550" cy="971550"/>
            </a:xfrm>
            <a:custGeom>
              <a:avLst/>
              <a:gdLst>
                <a:gd name="T0" fmla="*/ 200 w 201"/>
                <a:gd name="T1" fmla="*/ 92 h 201"/>
                <a:gd name="T2" fmla="*/ 199 w 201"/>
                <a:gd name="T3" fmla="*/ 81 h 201"/>
                <a:gd name="T4" fmla="*/ 196 w 201"/>
                <a:gd name="T5" fmla="*/ 71 h 201"/>
                <a:gd name="T6" fmla="*/ 193 w 201"/>
                <a:gd name="T7" fmla="*/ 61 h 201"/>
                <a:gd name="T8" fmla="*/ 188 w 201"/>
                <a:gd name="T9" fmla="*/ 52 h 201"/>
                <a:gd name="T10" fmla="*/ 183 w 201"/>
                <a:gd name="T11" fmla="*/ 43 h 201"/>
                <a:gd name="T12" fmla="*/ 176 w 201"/>
                <a:gd name="T13" fmla="*/ 35 h 201"/>
                <a:gd name="T14" fmla="*/ 169 w 201"/>
                <a:gd name="T15" fmla="*/ 27 h 201"/>
                <a:gd name="T16" fmla="*/ 161 w 201"/>
                <a:gd name="T17" fmla="*/ 20 h 201"/>
                <a:gd name="T18" fmla="*/ 152 w 201"/>
                <a:gd name="T19" fmla="*/ 15 h 201"/>
                <a:gd name="T20" fmla="*/ 143 w 201"/>
                <a:gd name="T21" fmla="*/ 10 h 201"/>
                <a:gd name="T22" fmla="*/ 133 w 201"/>
                <a:gd name="T23" fmla="*/ 6 h 201"/>
                <a:gd name="T24" fmla="*/ 123 w 201"/>
                <a:gd name="T25" fmla="*/ 3 h 201"/>
                <a:gd name="T26" fmla="*/ 113 w 201"/>
                <a:gd name="T27" fmla="*/ 1 h 201"/>
                <a:gd name="T28" fmla="*/ 102 w 201"/>
                <a:gd name="T29" fmla="*/ 0 h 201"/>
                <a:gd name="T30" fmla="*/ 92 w 201"/>
                <a:gd name="T31" fmla="*/ 1 h 201"/>
                <a:gd name="T32" fmla="*/ 81 w 201"/>
                <a:gd name="T33" fmla="*/ 2 h 201"/>
                <a:gd name="T34" fmla="*/ 71 w 201"/>
                <a:gd name="T35" fmla="*/ 5 h 201"/>
                <a:gd name="T36" fmla="*/ 61 w 201"/>
                <a:gd name="T37" fmla="*/ 8 h 201"/>
                <a:gd name="T38" fmla="*/ 52 w 201"/>
                <a:gd name="T39" fmla="*/ 13 h 201"/>
                <a:gd name="T40" fmla="*/ 43 w 201"/>
                <a:gd name="T41" fmla="*/ 18 h 201"/>
                <a:gd name="T42" fmla="*/ 35 w 201"/>
                <a:gd name="T43" fmla="*/ 25 h 201"/>
                <a:gd name="T44" fmla="*/ 27 w 201"/>
                <a:gd name="T45" fmla="*/ 32 h 201"/>
                <a:gd name="T46" fmla="*/ 21 w 201"/>
                <a:gd name="T47" fmla="*/ 40 h 201"/>
                <a:gd name="T48" fmla="*/ 15 w 201"/>
                <a:gd name="T49" fmla="*/ 49 h 201"/>
                <a:gd name="T50" fmla="*/ 10 w 201"/>
                <a:gd name="T51" fmla="*/ 58 h 201"/>
                <a:gd name="T52" fmla="*/ 6 w 201"/>
                <a:gd name="T53" fmla="*/ 68 h 201"/>
                <a:gd name="T54" fmla="*/ 3 w 201"/>
                <a:gd name="T55" fmla="*/ 78 h 201"/>
                <a:gd name="T56" fmla="*/ 1 w 201"/>
                <a:gd name="T57" fmla="*/ 88 h 201"/>
                <a:gd name="T58" fmla="*/ 0 w 201"/>
                <a:gd name="T59" fmla="*/ 99 h 201"/>
                <a:gd name="T60" fmla="*/ 1 w 201"/>
                <a:gd name="T61" fmla="*/ 109 h 201"/>
                <a:gd name="T62" fmla="*/ 2 w 201"/>
                <a:gd name="T63" fmla="*/ 120 h 201"/>
                <a:gd name="T64" fmla="*/ 5 w 201"/>
                <a:gd name="T65" fmla="*/ 130 h 201"/>
                <a:gd name="T66" fmla="*/ 8 w 201"/>
                <a:gd name="T67" fmla="*/ 140 h 201"/>
                <a:gd name="T68" fmla="*/ 13 w 201"/>
                <a:gd name="T69" fmla="*/ 149 h 201"/>
                <a:gd name="T70" fmla="*/ 19 w 201"/>
                <a:gd name="T71" fmla="*/ 158 h 201"/>
                <a:gd name="T72" fmla="*/ 25 w 201"/>
                <a:gd name="T73" fmla="*/ 166 h 201"/>
                <a:gd name="T74" fmla="*/ 32 w 201"/>
                <a:gd name="T75" fmla="*/ 174 h 201"/>
                <a:gd name="T76" fmla="*/ 40 w 201"/>
                <a:gd name="T77" fmla="*/ 180 h 201"/>
                <a:gd name="T78" fmla="*/ 49 w 201"/>
                <a:gd name="T79" fmla="*/ 186 h 201"/>
                <a:gd name="T80" fmla="*/ 58 w 201"/>
                <a:gd name="T81" fmla="*/ 191 h 201"/>
                <a:gd name="T82" fmla="*/ 68 w 201"/>
                <a:gd name="T83" fmla="*/ 195 h 201"/>
                <a:gd name="T84" fmla="*/ 78 w 201"/>
                <a:gd name="T85" fmla="*/ 198 h 201"/>
                <a:gd name="T86" fmla="*/ 88 w 201"/>
                <a:gd name="T87" fmla="*/ 200 h 201"/>
                <a:gd name="T88" fmla="*/ 99 w 201"/>
                <a:gd name="T89" fmla="*/ 201 h 201"/>
                <a:gd name="T90" fmla="*/ 109 w 201"/>
                <a:gd name="T91" fmla="*/ 200 h 201"/>
                <a:gd name="T92" fmla="*/ 120 w 201"/>
                <a:gd name="T93" fmla="*/ 199 h 201"/>
                <a:gd name="T94" fmla="*/ 130 w 201"/>
                <a:gd name="T95" fmla="*/ 196 h 201"/>
                <a:gd name="T96" fmla="*/ 140 w 201"/>
                <a:gd name="T97" fmla="*/ 193 h 201"/>
                <a:gd name="T98" fmla="*/ 149 w 201"/>
                <a:gd name="T99" fmla="*/ 188 h 201"/>
                <a:gd name="T100" fmla="*/ 158 w 201"/>
                <a:gd name="T101" fmla="*/ 183 h 201"/>
                <a:gd name="T102" fmla="*/ 166 w 201"/>
                <a:gd name="T103" fmla="*/ 176 h 201"/>
                <a:gd name="T104" fmla="*/ 174 w 201"/>
                <a:gd name="T105" fmla="*/ 169 h 201"/>
                <a:gd name="T106" fmla="*/ 180 w 201"/>
                <a:gd name="T107" fmla="*/ 161 h 201"/>
                <a:gd name="T108" fmla="*/ 186 w 201"/>
                <a:gd name="T109" fmla="*/ 152 h 201"/>
                <a:gd name="T110" fmla="*/ 191 w 201"/>
                <a:gd name="T111" fmla="*/ 143 h 201"/>
                <a:gd name="T112" fmla="*/ 195 w 201"/>
                <a:gd name="T113" fmla="*/ 133 h 201"/>
                <a:gd name="T114" fmla="*/ 198 w 201"/>
                <a:gd name="T115" fmla="*/ 123 h 201"/>
                <a:gd name="T116" fmla="*/ 200 w 201"/>
                <a:gd name="T117" fmla="*/ 113 h 201"/>
                <a:gd name="T118" fmla="*/ 201 w 201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1" h="201">
                  <a:moveTo>
                    <a:pt x="201" y="100"/>
                  </a:moveTo>
                  <a:lnTo>
                    <a:pt x="201" y="99"/>
                  </a:lnTo>
                  <a:lnTo>
                    <a:pt x="201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200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9" y="81"/>
                  </a:lnTo>
                  <a:lnTo>
                    <a:pt x="198" y="80"/>
                  </a:lnTo>
                  <a:lnTo>
                    <a:pt x="198" y="78"/>
                  </a:lnTo>
                  <a:lnTo>
                    <a:pt x="198" y="76"/>
                  </a:lnTo>
                  <a:lnTo>
                    <a:pt x="197" y="75"/>
                  </a:lnTo>
                  <a:lnTo>
                    <a:pt x="197" y="73"/>
                  </a:lnTo>
                  <a:lnTo>
                    <a:pt x="196" y="71"/>
                  </a:lnTo>
                  <a:lnTo>
                    <a:pt x="196" y="69"/>
                  </a:lnTo>
                  <a:lnTo>
                    <a:pt x="195" y="68"/>
                  </a:lnTo>
                  <a:lnTo>
                    <a:pt x="195" y="66"/>
                  </a:lnTo>
                  <a:lnTo>
                    <a:pt x="194" y="65"/>
                  </a:lnTo>
                  <a:lnTo>
                    <a:pt x="193" y="63"/>
                  </a:lnTo>
                  <a:lnTo>
                    <a:pt x="193" y="61"/>
                  </a:lnTo>
                  <a:lnTo>
                    <a:pt x="192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90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4" y="44"/>
                  </a:lnTo>
                  <a:lnTo>
                    <a:pt x="183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5" y="33"/>
                  </a:lnTo>
                  <a:lnTo>
                    <a:pt x="174" y="32"/>
                  </a:lnTo>
                  <a:lnTo>
                    <a:pt x="173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4"/>
                  </a:lnTo>
                  <a:lnTo>
                    <a:pt x="164" y="23"/>
                  </a:lnTo>
                  <a:lnTo>
                    <a:pt x="162" y="22"/>
                  </a:lnTo>
                  <a:lnTo>
                    <a:pt x="161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4" y="15"/>
                  </a:lnTo>
                  <a:lnTo>
                    <a:pt x="152" y="15"/>
                  </a:lnTo>
                  <a:lnTo>
                    <a:pt x="151" y="14"/>
                  </a:lnTo>
                  <a:lnTo>
                    <a:pt x="149" y="13"/>
                  </a:lnTo>
                  <a:lnTo>
                    <a:pt x="148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10"/>
                  </a:lnTo>
                  <a:lnTo>
                    <a:pt x="141" y="9"/>
                  </a:lnTo>
                  <a:lnTo>
                    <a:pt x="140" y="8"/>
                  </a:lnTo>
                  <a:lnTo>
                    <a:pt x="138" y="8"/>
                  </a:lnTo>
                  <a:lnTo>
                    <a:pt x="136" y="7"/>
                  </a:lnTo>
                  <a:lnTo>
                    <a:pt x="135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30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5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20" y="2"/>
                  </a:lnTo>
                  <a:lnTo>
                    <a:pt x="118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3" y="1"/>
                  </a:lnTo>
                  <a:lnTo>
                    <a:pt x="111" y="1"/>
                  </a:lnTo>
                  <a:lnTo>
                    <a:pt x="109" y="1"/>
                  </a:lnTo>
                  <a:lnTo>
                    <a:pt x="108" y="1"/>
                  </a:lnTo>
                  <a:lnTo>
                    <a:pt x="106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1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4" y="1"/>
                  </a:lnTo>
                  <a:lnTo>
                    <a:pt x="92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7" y="1"/>
                  </a:lnTo>
                  <a:lnTo>
                    <a:pt x="85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5" y="4"/>
                  </a:lnTo>
                  <a:lnTo>
                    <a:pt x="73" y="4"/>
                  </a:lnTo>
                  <a:lnTo>
                    <a:pt x="71" y="5"/>
                  </a:lnTo>
                  <a:lnTo>
                    <a:pt x="70" y="5"/>
                  </a:lnTo>
                  <a:lnTo>
                    <a:pt x="68" y="6"/>
                  </a:lnTo>
                  <a:lnTo>
                    <a:pt x="66" y="6"/>
                  </a:lnTo>
                  <a:lnTo>
                    <a:pt x="65" y="7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10"/>
                  </a:lnTo>
                  <a:lnTo>
                    <a:pt x="57" y="10"/>
                  </a:lnTo>
                  <a:lnTo>
                    <a:pt x="55" y="11"/>
                  </a:lnTo>
                  <a:lnTo>
                    <a:pt x="54" y="12"/>
                  </a:lnTo>
                  <a:lnTo>
                    <a:pt x="52" y="13"/>
                  </a:lnTo>
                  <a:lnTo>
                    <a:pt x="50" y="14"/>
                  </a:lnTo>
                  <a:lnTo>
                    <a:pt x="49" y="15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5" y="17"/>
                  </a:lnTo>
                  <a:lnTo>
                    <a:pt x="43" y="18"/>
                  </a:lnTo>
                  <a:lnTo>
                    <a:pt x="42" y="19"/>
                  </a:lnTo>
                  <a:lnTo>
                    <a:pt x="40" y="20"/>
                  </a:lnTo>
                  <a:lnTo>
                    <a:pt x="39" y="22"/>
                  </a:lnTo>
                  <a:lnTo>
                    <a:pt x="38" y="23"/>
                  </a:lnTo>
                  <a:lnTo>
                    <a:pt x="36" y="24"/>
                  </a:lnTo>
                  <a:lnTo>
                    <a:pt x="35" y="25"/>
                  </a:lnTo>
                  <a:lnTo>
                    <a:pt x="34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30" y="30"/>
                  </a:lnTo>
                  <a:lnTo>
                    <a:pt x="29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5"/>
                  </a:lnTo>
                  <a:lnTo>
                    <a:pt x="24" y="36"/>
                  </a:lnTo>
                  <a:lnTo>
                    <a:pt x="23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0" y="42"/>
                  </a:lnTo>
                  <a:lnTo>
                    <a:pt x="19" y="43"/>
                  </a:lnTo>
                  <a:lnTo>
                    <a:pt x="18" y="44"/>
                  </a:lnTo>
                  <a:lnTo>
                    <a:pt x="17" y="46"/>
                  </a:lnTo>
                  <a:lnTo>
                    <a:pt x="16" y="47"/>
                  </a:lnTo>
                  <a:lnTo>
                    <a:pt x="15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1" y="57"/>
                  </a:lnTo>
                  <a:lnTo>
                    <a:pt x="10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8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5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3" y="80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2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1" y="106"/>
                  </a:lnTo>
                  <a:lnTo>
                    <a:pt x="1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2" y="116"/>
                  </a:lnTo>
                  <a:lnTo>
                    <a:pt x="2" y="118"/>
                  </a:lnTo>
                  <a:lnTo>
                    <a:pt x="2" y="120"/>
                  </a:lnTo>
                  <a:lnTo>
                    <a:pt x="3" y="121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30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8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10" y="143"/>
                  </a:lnTo>
                  <a:lnTo>
                    <a:pt x="11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1"/>
                  </a:lnTo>
                  <a:lnTo>
                    <a:pt x="15" y="152"/>
                  </a:lnTo>
                  <a:lnTo>
                    <a:pt x="16" y="154"/>
                  </a:lnTo>
                  <a:lnTo>
                    <a:pt x="17" y="155"/>
                  </a:lnTo>
                  <a:lnTo>
                    <a:pt x="18" y="156"/>
                  </a:lnTo>
                  <a:lnTo>
                    <a:pt x="19" y="158"/>
                  </a:lnTo>
                  <a:lnTo>
                    <a:pt x="20" y="159"/>
                  </a:lnTo>
                  <a:lnTo>
                    <a:pt x="21" y="161"/>
                  </a:lnTo>
                  <a:lnTo>
                    <a:pt x="22" y="162"/>
                  </a:lnTo>
                  <a:lnTo>
                    <a:pt x="23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9" y="170"/>
                  </a:lnTo>
                  <a:lnTo>
                    <a:pt x="30" y="171"/>
                  </a:lnTo>
                  <a:lnTo>
                    <a:pt x="31" y="173"/>
                  </a:lnTo>
                  <a:lnTo>
                    <a:pt x="32" y="174"/>
                  </a:lnTo>
                  <a:lnTo>
                    <a:pt x="34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8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2" y="181"/>
                  </a:lnTo>
                  <a:lnTo>
                    <a:pt x="43" y="183"/>
                  </a:lnTo>
                  <a:lnTo>
                    <a:pt x="45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4" y="189"/>
                  </a:lnTo>
                  <a:lnTo>
                    <a:pt x="55" y="190"/>
                  </a:lnTo>
                  <a:lnTo>
                    <a:pt x="57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3"/>
                  </a:lnTo>
                  <a:lnTo>
                    <a:pt x="63" y="193"/>
                  </a:lnTo>
                  <a:lnTo>
                    <a:pt x="65" y="194"/>
                  </a:lnTo>
                  <a:lnTo>
                    <a:pt x="66" y="195"/>
                  </a:lnTo>
                  <a:lnTo>
                    <a:pt x="68" y="195"/>
                  </a:lnTo>
                  <a:lnTo>
                    <a:pt x="70" y="196"/>
                  </a:lnTo>
                  <a:lnTo>
                    <a:pt x="71" y="196"/>
                  </a:lnTo>
                  <a:lnTo>
                    <a:pt x="73" y="197"/>
                  </a:lnTo>
                  <a:lnTo>
                    <a:pt x="75" y="197"/>
                  </a:lnTo>
                  <a:lnTo>
                    <a:pt x="76" y="198"/>
                  </a:lnTo>
                  <a:lnTo>
                    <a:pt x="78" y="198"/>
                  </a:lnTo>
                  <a:lnTo>
                    <a:pt x="80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7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4" y="200"/>
                  </a:lnTo>
                  <a:lnTo>
                    <a:pt x="95" y="200"/>
                  </a:lnTo>
                  <a:lnTo>
                    <a:pt x="97" y="201"/>
                  </a:lnTo>
                  <a:lnTo>
                    <a:pt x="99" y="201"/>
                  </a:lnTo>
                  <a:lnTo>
                    <a:pt x="101" y="201"/>
                  </a:lnTo>
                  <a:lnTo>
                    <a:pt x="102" y="201"/>
                  </a:lnTo>
                  <a:lnTo>
                    <a:pt x="104" y="201"/>
                  </a:lnTo>
                  <a:lnTo>
                    <a:pt x="106" y="200"/>
                  </a:lnTo>
                  <a:lnTo>
                    <a:pt x="108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3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20" y="199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5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30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5" y="195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40" y="193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90"/>
                  </a:lnTo>
                  <a:lnTo>
                    <a:pt x="148" y="189"/>
                  </a:lnTo>
                  <a:lnTo>
                    <a:pt x="149" y="188"/>
                  </a:lnTo>
                  <a:lnTo>
                    <a:pt x="151" y="187"/>
                  </a:lnTo>
                  <a:lnTo>
                    <a:pt x="152" y="186"/>
                  </a:lnTo>
                  <a:lnTo>
                    <a:pt x="154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3"/>
                  </a:lnTo>
                  <a:lnTo>
                    <a:pt x="159" y="181"/>
                  </a:lnTo>
                  <a:lnTo>
                    <a:pt x="161" y="180"/>
                  </a:lnTo>
                  <a:lnTo>
                    <a:pt x="162" y="179"/>
                  </a:lnTo>
                  <a:lnTo>
                    <a:pt x="164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3" y="170"/>
                  </a:lnTo>
                  <a:lnTo>
                    <a:pt x="174" y="169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3" y="158"/>
                  </a:lnTo>
                  <a:lnTo>
                    <a:pt x="184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90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2" y="141"/>
                  </a:lnTo>
                  <a:lnTo>
                    <a:pt x="193" y="140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5" y="135"/>
                  </a:lnTo>
                  <a:lnTo>
                    <a:pt x="195" y="133"/>
                  </a:lnTo>
                  <a:lnTo>
                    <a:pt x="196" y="131"/>
                  </a:lnTo>
                  <a:lnTo>
                    <a:pt x="196" y="130"/>
                  </a:lnTo>
                  <a:lnTo>
                    <a:pt x="197" y="128"/>
                  </a:lnTo>
                  <a:lnTo>
                    <a:pt x="197" y="126"/>
                  </a:lnTo>
                  <a:lnTo>
                    <a:pt x="198" y="125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9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200" y="114"/>
                  </a:lnTo>
                  <a:lnTo>
                    <a:pt x="200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1" y="104"/>
                  </a:lnTo>
                  <a:lnTo>
                    <a:pt x="201" y="102"/>
                  </a:lnTo>
                  <a:lnTo>
                    <a:pt x="201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65" name="Rectangle 62"/>
            <p:cNvSpPr>
              <a:spLocks noChangeArrowheads="1"/>
            </p:cNvSpPr>
            <p:nvPr/>
          </p:nvSpPr>
          <p:spPr bwMode="auto">
            <a:xfrm>
              <a:off x="4164013" y="4223296"/>
              <a:ext cx="6381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otterdam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Freeform 63"/>
            <p:cNvSpPr>
              <a:spLocks/>
            </p:cNvSpPr>
            <p:nvPr/>
          </p:nvSpPr>
          <p:spPr bwMode="auto">
            <a:xfrm>
              <a:off x="4711701" y="4382046"/>
              <a:ext cx="966788" cy="971550"/>
            </a:xfrm>
            <a:custGeom>
              <a:avLst/>
              <a:gdLst>
                <a:gd name="T0" fmla="*/ 200 w 200"/>
                <a:gd name="T1" fmla="*/ 92 h 201"/>
                <a:gd name="T2" fmla="*/ 198 w 200"/>
                <a:gd name="T3" fmla="*/ 81 h 201"/>
                <a:gd name="T4" fmla="*/ 196 w 200"/>
                <a:gd name="T5" fmla="*/ 71 h 201"/>
                <a:gd name="T6" fmla="*/ 192 w 200"/>
                <a:gd name="T7" fmla="*/ 61 h 201"/>
                <a:gd name="T8" fmla="*/ 188 w 200"/>
                <a:gd name="T9" fmla="*/ 52 h 201"/>
                <a:gd name="T10" fmla="*/ 182 w 200"/>
                <a:gd name="T11" fmla="*/ 43 h 201"/>
                <a:gd name="T12" fmla="*/ 176 w 200"/>
                <a:gd name="T13" fmla="*/ 35 h 201"/>
                <a:gd name="T14" fmla="*/ 168 w 200"/>
                <a:gd name="T15" fmla="*/ 27 h 201"/>
                <a:gd name="T16" fmla="*/ 160 w 200"/>
                <a:gd name="T17" fmla="*/ 20 h 201"/>
                <a:gd name="T18" fmla="*/ 152 w 200"/>
                <a:gd name="T19" fmla="*/ 15 h 201"/>
                <a:gd name="T20" fmla="*/ 142 w 200"/>
                <a:gd name="T21" fmla="*/ 10 h 201"/>
                <a:gd name="T22" fmla="*/ 133 w 200"/>
                <a:gd name="T23" fmla="*/ 6 h 201"/>
                <a:gd name="T24" fmla="*/ 122 w 200"/>
                <a:gd name="T25" fmla="*/ 3 h 201"/>
                <a:gd name="T26" fmla="*/ 112 w 200"/>
                <a:gd name="T27" fmla="*/ 1 h 201"/>
                <a:gd name="T28" fmla="*/ 102 w 200"/>
                <a:gd name="T29" fmla="*/ 0 h 201"/>
                <a:gd name="T30" fmla="*/ 91 w 200"/>
                <a:gd name="T31" fmla="*/ 1 h 201"/>
                <a:gd name="T32" fmla="*/ 81 w 200"/>
                <a:gd name="T33" fmla="*/ 2 h 201"/>
                <a:gd name="T34" fmla="*/ 71 w 200"/>
                <a:gd name="T35" fmla="*/ 5 h 201"/>
                <a:gd name="T36" fmla="*/ 61 w 200"/>
                <a:gd name="T37" fmla="*/ 8 h 201"/>
                <a:gd name="T38" fmla="*/ 51 w 200"/>
                <a:gd name="T39" fmla="*/ 13 h 201"/>
                <a:gd name="T40" fmla="*/ 43 w 200"/>
                <a:gd name="T41" fmla="*/ 18 h 201"/>
                <a:gd name="T42" fmla="*/ 34 w 200"/>
                <a:gd name="T43" fmla="*/ 25 h 201"/>
                <a:gd name="T44" fmla="*/ 27 w 200"/>
                <a:gd name="T45" fmla="*/ 32 h 201"/>
                <a:gd name="T46" fmla="*/ 20 w 200"/>
                <a:gd name="T47" fmla="*/ 40 h 201"/>
                <a:gd name="T48" fmla="*/ 14 w 200"/>
                <a:gd name="T49" fmla="*/ 49 h 201"/>
                <a:gd name="T50" fmla="*/ 9 w 200"/>
                <a:gd name="T51" fmla="*/ 58 h 201"/>
                <a:gd name="T52" fmla="*/ 5 w 200"/>
                <a:gd name="T53" fmla="*/ 68 h 201"/>
                <a:gd name="T54" fmla="*/ 2 w 200"/>
                <a:gd name="T55" fmla="*/ 78 h 201"/>
                <a:gd name="T56" fmla="*/ 1 w 200"/>
                <a:gd name="T57" fmla="*/ 88 h 201"/>
                <a:gd name="T58" fmla="*/ 0 w 200"/>
                <a:gd name="T59" fmla="*/ 99 h 201"/>
                <a:gd name="T60" fmla="*/ 0 w 200"/>
                <a:gd name="T61" fmla="*/ 109 h 201"/>
                <a:gd name="T62" fmla="*/ 2 w 200"/>
                <a:gd name="T63" fmla="*/ 120 h 201"/>
                <a:gd name="T64" fmla="*/ 4 w 200"/>
                <a:gd name="T65" fmla="*/ 130 h 201"/>
                <a:gd name="T66" fmla="*/ 8 w 200"/>
                <a:gd name="T67" fmla="*/ 140 h 201"/>
                <a:gd name="T68" fmla="*/ 12 w 200"/>
                <a:gd name="T69" fmla="*/ 149 h 201"/>
                <a:gd name="T70" fmla="*/ 18 w 200"/>
                <a:gd name="T71" fmla="*/ 158 h 201"/>
                <a:gd name="T72" fmla="*/ 24 w 200"/>
                <a:gd name="T73" fmla="*/ 166 h 201"/>
                <a:gd name="T74" fmla="*/ 32 w 200"/>
                <a:gd name="T75" fmla="*/ 174 h 201"/>
                <a:gd name="T76" fmla="*/ 40 w 200"/>
                <a:gd name="T77" fmla="*/ 180 h 201"/>
                <a:gd name="T78" fmla="*/ 48 w 200"/>
                <a:gd name="T79" fmla="*/ 186 h 201"/>
                <a:gd name="T80" fmla="*/ 58 w 200"/>
                <a:gd name="T81" fmla="*/ 191 h 201"/>
                <a:gd name="T82" fmla="*/ 67 w 200"/>
                <a:gd name="T83" fmla="*/ 195 h 201"/>
                <a:gd name="T84" fmla="*/ 77 w 200"/>
                <a:gd name="T85" fmla="*/ 198 h 201"/>
                <a:gd name="T86" fmla="*/ 88 w 200"/>
                <a:gd name="T87" fmla="*/ 200 h 201"/>
                <a:gd name="T88" fmla="*/ 98 w 200"/>
                <a:gd name="T89" fmla="*/ 201 h 201"/>
                <a:gd name="T90" fmla="*/ 109 w 200"/>
                <a:gd name="T91" fmla="*/ 200 h 201"/>
                <a:gd name="T92" fmla="*/ 119 w 200"/>
                <a:gd name="T93" fmla="*/ 199 h 201"/>
                <a:gd name="T94" fmla="*/ 129 w 200"/>
                <a:gd name="T95" fmla="*/ 196 h 201"/>
                <a:gd name="T96" fmla="*/ 139 w 200"/>
                <a:gd name="T97" fmla="*/ 193 h 201"/>
                <a:gd name="T98" fmla="*/ 148 w 200"/>
                <a:gd name="T99" fmla="*/ 188 h 201"/>
                <a:gd name="T100" fmla="*/ 157 w 200"/>
                <a:gd name="T101" fmla="*/ 183 h 201"/>
                <a:gd name="T102" fmla="*/ 166 w 200"/>
                <a:gd name="T103" fmla="*/ 176 h 201"/>
                <a:gd name="T104" fmla="*/ 173 w 200"/>
                <a:gd name="T105" fmla="*/ 169 h 201"/>
                <a:gd name="T106" fmla="*/ 180 w 200"/>
                <a:gd name="T107" fmla="*/ 161 h 201"/>
                <a:gd name="T108" fmla="*/ 186 w 200"/>
                <a:gd name="T109" fmla="*/ 152 h 201"/>
                <a:gd name="T110" fmla="*/ 191 w 200"/>
                <a:gd name="T111" fmla="*/ 143 h 201"/>
                <a:gd name="T112" fmla="*/ 195 w 200"/>
                <a:gd name="T113" fmla="*/ 133 h 201"/>
                <a:gd name="T114" fmla="*/ 197 w 200"/>
                <a:gd name="T115" fmla="*/ 123 h 201"/>
                <a:gd name="T116" fmla="*/ 199 w 200"/>
                <a:gd name="T117" fmla="*/ 113 h 201"/>
                <a:gd name="T118" fmla="*/ 200 w 200"/>
                <a:gd name="T119" fmla="*/ 102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1">
                  <a:moveTo>
                    <a:pt x="200" y="100"/>
                  </a:moveTo>
                  <a:lnTo>
                    <a:pt x="200" y="99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2"/>
                  </a:lnTo>
                  <a:lnTo>
                    <a:pt x="200" y="90"/>
                  </a:lnTo>
                  <a:lnTo>
                    <a:pt x="199" y="88"/>
                  </a:lnTo>
                  <a:lnTo>
                    <a:pt x="199" y="87"/>
                  </a:lnTo>
                  <a:lnTo>
                    <a:pt x="199" y="85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80"/>
                  </a:lnTo>
                  <a:lnTo>
                    <a:pt x="197" y="78"/>
                  </a:lnTo>
                  <a:lnTo>
                    <a:pt x="197" y="76"/>
                  </a:lnTo>
                  <a:lnTo>
                    <a:pt x="197" y="75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3" y="65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1" y="60"/>
                  </a:lnTo>
                  <a:lnTo>
                    <a:pt x="191" y="58"/>
                  </a:lnTo>
                  <a:lnTo>
                    <a:pt x="190" y="57"/>
                  </a:lnTo>
                  <a:lnTo>
                    <a:pt x="189" y="55"/>
                  </a:lnTo>
                  <a:lnTo>
                    <a:pt x="188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2"/>
                  </a:lnTo>
                  <a:lnTo>
                    <a:pt x="180" y="40"/>
                  </a:lnTo>
                  <a:lnTo>
                    <a:pt x="179" y="39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5"/>
                  </a:lnTo>
                  <a:lnTo>
                    <a:pt x="174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30"/>
                  </a:lnTo>
                  <a:lnTo>
                    <a:pt x="170" y="28"/>
                  </a:lnTo>
                  <a:lnTo>
                    <a:pt x="168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4" y="24"/>
                  </a:lnTo>
                  <a:lnTo>
                    <a:pt x="163" y="23"/>
                  </a:lnTo>
                  <a:lnTo>
                    <a:pt x="162" y="22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7" y="18"/>
                  </a:lnTo>
                  <a:lnTo>
                    <a:pt x="156" y="17"/>
                  </a:lnTo>
                  <a:lnTo>
                    <a:pt x="154" y="16"/>
                  </a:lnTo>
                  <a:lnTo>
                    <a:pt x="153" y="15"/>
                  </a:lnTo>
                  <a:lnTo>
                    <a:pt x="152" y="15"/>
                  </a:lnTo>
                  <a:lnTo>
                    <a:pt x="150" y="14"/>
                  </a:lnTo>
                  <a:lnTo>
                    <a:pt x="148" y="13"/>
                  </a:lnTo>
                  <a:lnTo>
                    <a:pt x="147" y="12"/>
                  </a:lnTo>
                  <a:lnTo>
                    <a:pt x="145" y="11"/>
                  </a:lnTo>
                  <a:lnTo>
                    <a:pt x="144" y="10"/>
                  </a:lnTo>
                  <a:lnTo>
                    <a:pt x="142" y="10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7" y="8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6"/>
                  </a:lnTo>
                  <a:lnTo>
                    <a:pt x="131" y="5"/>
                  </a:lnTo>
                  <a:lnTo>
                    <a:pt x="129" y="5"/>
                  </a:lnTo>
                  <a:lnTo>
                    <a:pt x="128" y="4"/>
                  </a:lnTo>
                  <a:lnTo>
                    <a:pt x="126" y="4"/>
                  </a:lnTo>
                  <a:lnTo>
                    <a:pt x="124" y="3"/>
                  </a:lnTo>
                  <a:lnTo>
                    <a:pt x="122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7" y="2"/>
                  </a:lnTo>
                  <a:lnTo>
                    <a:pt x="116" y="2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7" y="1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8" y="0"/>
                  </a:lnTo>
                  <a:lnTo>
                    <a:pt x="96" y="0"/>
                  </a:lnTo>
                  <a:lnTo>
                    <a:pt x="95" y="0"/>
                  </a:lnTo>
                  <a:lnTo>
                    <a:pt x="93" y="1"/>
                  </a:lnTo>
                  <a:lnTo>
                    <a:pt x="91" y="1"/>
                  </a:lnTo>
                  <a:lnTo>
                    <a:pt x="90" y="1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4" y="2"/>
                  </a:lnTo>
                  <a:lnTo>
                    <a:pt x="83" y="2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7" y="3"/>
                  </a:lnTo>
                  <a:lnTo>
                    <a:pt x="76" y="3"/>
                  </a:lnTo>
                  <a:lnTo>
                    <a:pt x="74" y="4"/>
                  </a:lnTo>
                  <a:lnTo>
                    <a:pt x="72" y="4"/>
                  </a:lnTo>
                  <a:lnTo>
                    <a:pt x="71" y="5"/>
                  </a:lnTo>
                  <a:lnTo>
                    <a:pt x="69" y="5"/>
                  </a:lnTo>
                  <a:lnTo>
                    <a:pt x="67" y="6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2" y="8"/>
                  </a:lnTo>
                  <a:lnTo>
                    <a:pt x="61" y="8"/>
                  </a:lnTo>
                  <a:lnTo>
                    <a:pt x="59" y="9"/>
                  </a:lnTo>
                  <a:lnTo>
                    <a:pt x="58" y="10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1" y="13"/>
                  </a:lnTo>
                  <a:lnTo>
                    <a:pt x="50" y="14"/>
                  </a:lnTo>
                  <a:lnTo>
                    <a:pt x="48" y="15"/>
                  </a:lnTo>
                  <a:lnTo>
                    <a:pt x="47" y="15"/>
                  </a:lnTo>
                  <a:lnTo>
                    <a:pt x="45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8" y="22"/>
                  </a:lnTo>
                  <a:lnTo>
                    <a:pt x="37" y="23"/>
                  </a:lnTo>
                  <a:lnTo>
                    <a:pt x="36" y="24"/>
                  </a:lnTo>
                  <a:lnTo>
                    <a:pt x="34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0" y="28"/>
                  </a:lnTo>
                  <a:lnTo>
                    <a:pt x="29" y="30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4" y="35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1" y="39"/>
                  </a:lnTo>
                  <a:lnTo>
                    <a:pt x="20" y="40"/>
                  </a:lnTo>
                  <a:lnTo>
                    <a:pt x="19" y="42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3" y="50"/>
                  </a:lnTo>
                  <a:lnTo>
                    <a:pt x="12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7"/>
                  </a:lnTo>
                  <a:lnTo>
                    <a:pt x="9" y="58"/>
                  </a:lnTo>
                  <a:lnTo>
                    <a:pt x="9" y="60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5" y="68"/>
                  </a:lnTo>
                  <a:lnTo>
                    <a:pt x="5" y="69"/>
                  </a:lnTo>
                  <a:lnTo>
                    <a:pt x="4" y="71"/>
                  </a:lnTo>
                  <a:lnTo>
                    <a:pt x="4" y="73"/>
                  </a:lnTo>
                  <a:lnTo>
                    <a:pt x="3" y="75"/>
                  </a:lnTo>
                  <a:lnTo>
                    <a:pt x="3" y="76"/>
                  </a:lnTo>
                  <a:lnTo>
                    <a:pt x="2" y="78"/>
                  </a:lnTo>
                  <a:lnTo>
                    <a:pt x="2" y="80"/>
                  </a:lnTo>
                  <a:lnTo>
                    <a:pt x="2" y="81"/>
                  </a:lnTo>
                  <a:lnTo>
                    <a:pt x="1" y="83"/>
                  </a:lnTo>
                  <a:lnTo>
                    <a:pt x="1" y="85"/>
                  </a:lnTo>
                  <a:lnTo>
                    <a:pt x="1" y="87"/>
                  </a:lnTo>
                  <a:lnTo>
                    <a:pt x="1" y="88"/>
                  </a:lnTo>
                  <a:lnTo>
                    <a:pt x="0" y="90"/>
                  </a:lnTo>
                  <a:lnTo>
                    <a:pt x="0" y="92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1" y="118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3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4" y="128"/>
                  </a:lnTo>
                  <a:lnTo>
                    <a:pt x="4" y="130"/>
                  </a:lnTo>
                  <a:lnTo>
                    <a:pt x="5" y="131"/>
                  </a:lnTo>
                  <a:lnTo>
                    <a:pt x="5" y="133"/>
                  </a:lnTo>
                  <a:lnTo>
                    <a:pt x="6" y="135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40"/>
                  </a:lnTo>
                  <a:lnTo>
                    <a:pt x="9" y="141"/>
                  </a:lnTo>
                  <a:lnTo>
                    <a:pt x="9" y="143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2" y="149"/>
                  </a:lnTo>
                  <a:lnTo>
                    <a:pt x="13" y="151"/>
                  </a:lnTo>
                  <a:lnTo>
                    <a:pt x="14" y="152"/>
                  </a:lnTo>
                  <a:lnTo>
                    <a:pt x="15" y="154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1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3" y="165"/>
                  </a:lnTo>
                  <a:lnTo>
                    <a:pt x="24" y="166"/>
                  </a:lnTo>
                  <a:lnTo>
                    <a:pt x="26" y="167"/>
                  </a:lnTo>
                  <a:lnTo>
                    <a:pt x="27" y="169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0" y="173"/>
                  </a:lnTo>
                  <a:lnTo>
                    <a:pt x="32" y="174"/>
                  </a:lnTo>
                  <a:lnTo>
                    <a:pt x="33" y="175"/>
                  </a:lnTo>
                  <a:lnTo>
                    <a:pt x="34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8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3"/>
                  </a:lnTo>
                  <a:lnTo>
                    <a:pt x="44" y="183"/>
                  </a:lnTo>
                  <a:lnTo>
                    <a:pt x="45" y="184"/>
                  </a:lnTo>
                  <a:lnTo>
                    <a:pt x="47" y="185"/>
                  </a:lnTo>
                  <a:lnTo>
                    <a:pt x="48" y="186"/>
                  </a:lnTo>
                  <a:lnTo>
                    <a:pt x="50" y="187"/>
                  </a:lnTo>
                  <a:lnTo>
                    <a:pt x="51" y="188"/>
                  </a:lnTo>
                  <a:lnTo>
                    <a:pt x="53" y="189"/>
                  </a:lnTo>
                  <a:lnTo>
                    <a:pt x="55" y="190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59" y="192"/>
                  </a:lnTo>
                  <a:lnTo>
                    <a:pt x="61" y="193"/>
                  </a:lnTo>
                  <a:lnTo>
                    <a:pt x="62" y="193"/>
                  </a:lnTo>
                  <a:lnTo>
                    <a:pt x="64" y="194"/>
                  </a:lnTo>
                  <a:lnTo>
                    <a:pt x="66" y="195"/>
                  </a:lnTo>
                  <a:lnTo>
                    <a:pt x="67" y="195"/>
                  </a:lnTo>
                  <a:lnTo>
                    <a:pt x="69" y="196"/>
                  </a:lnTo>
                  <a:lnTo>
                    <a:pt x="71" y="196"/>
                  </a:lnTo>
                  <a:lnTo>
                    <a:pt x="72" y="197"/>
                  </a:lnTo>
                  <a:lnTo>
                    <a:pt x="74" y="197"/>
                  </a:lnTo>
                  <a:lnTo>
                    <a:pt x="76" y="198"/>
                  </a:lnTo>
                  <a:lnTo>
                    <a:pt x="77" y="198"/>
                  </a:lnTo>
                  <a:lnTo>
                    <a:pt x="79" y="198"/>
                  </a:lnTo>
                  <a:lnTo>
                    <a:pt x="81" y="199"/>
                  </a:lnTo>
                  <a:lnTo>
                    <a:pt x="83" y="199"/>
                  </a:lnTo>
                  <a:lnTo>
                    <a:pt x="84" y="199"/>
                  </a:lnTo>
                  <a:lnTo>
                    <a:pt x="86" y="200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1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6" y="201"/>
                  </a:lnTo>
                  <a:lnTo>
                    <a:pt x="98" y="201"/>
                  </a:lnTo>
                  <a:lnTo>
                    <a:pt x="100" y="201"/>
                  </a:lnTo>
                  <a:lnTo>
                    <a:pt x="102" y="201"/>
                  </a:lnTo>
                  <a:lnTo>
                    <a:pt x="103" y="201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0" y="200"/>
                  </a:lnTo>
                  <a:lnTo>
                    <a:pt x="112" y="200"/>
                  </a:lnTo>
                  <a:lnTo>
                    <a:pt x="114" y="200"/>
                  </a:lnTo>
                  <a:lnTo>
                    <a:pt x="116" y="199"/>
                  </a:lnTo>
                  <a:lnTo>
                    <a:pt x="117" y="199"/>
                  </a:lnTo>
                  <a:lnTo>
                    <a:pt x="119" y="199"/>
                  </a:lnTo>
                  <a:lnTo>
                    <a:pt x="121" y="198"/>
                  </a:lnTo>
                  <a:lnTo>
                    <a:pt x="122" y="198"/>
                  </a:lnTo>
                  <a:lnTo>
                    <a:pt x="124" y="198"/>
                  </a:lnTo>
                  <a:lnTo>
                    <a:pt x="126" y="197"/>
                  </a:lnTo>
                  <a:lnTo>
                    <a:pt x="128" y="197"/>
                  </a:lnTo>
                  <a:lnTo>
                    <a:pt x="129" y="196"/>
                  </a:lnTo>
                  <a:lnTo>
                    <a:pt x="131" y="196"/>
                  </a:lnTo>
                  <a:lnTo>
                    <a:pt x="133" y="195"/>
                  </a:lnTo>
                  <a:lnTo>
                    <a:pt x="134" y="195"/>
                  </a:lnTo>
                  <a:lnTo>
                    <a:pt x="136" y="194"/>
                  </a:lnTo>
                  <a:lnTo>
                    <a:pt x="137" y="193"/>
                  </a:lnTo>
                  <a:lnTo>
                    <a:pt x="139" y="193"/>
                  </a:lnTo>
                  <a:lnTo>
                    <a:pt x="141" y="192"/>
                  </a:lnTo>
                  <a:lnTo>
                    <a:pt x="142" y="191"/>
                  </a:lnTo>
                  <a:lnTo>
                    <a:pt x="144" y="190"/>
                  </a:lnTo>
                  <a:lnTo>
                    <a:pt x="145" y="190"/>
                  </a:lnTo>
                  <a:lnTo>
                    <a:pt x="147" y="189"/>
                  </a:lnTo>
                  <a:lnTo>
                    <a:pt x="148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4" y="184"/>
                  </a:lnTo>
                  <a:lnTo>
                    <a:pt x="156" y="183"/>
                  </a:lnTo>
                  <a:lnTo>
                    <a:pt x="157" y="183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4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8" y="174"/>
                  </a:lnTo>
                  <a:lnTo>
                    <a:pt x="170" y="173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9"/>
                  </a:lnTo>
                  <a:lnTo>
                    <a:pt x="174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1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4"/>
                  </a:lnTo>
                  <a:lnTo>
                    <a:pt x="186" y="152"/>
                  </a:lnTo>
                  <a:lnTo>
                    <a:pt x="187" y="151"/>
                  </a:lnTo>
                  <a:lnTo>
                    <a:pt x="188" y="149"/>
                  </a:lnTo>
                  <a:lnTo>
                    <a:pt x="188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3"/>
                  </a:lnTo>
                  <a:lnTo>
                    <a:pt x="191" y="141"/>
                  </a:lnTo>
                  <a:lnTo>
                    <a:pt x="192" y="140"/>
                  </a:lnTo>
                  <a:lnTo>
                    <a:pt x="193" y="138"/>
                  </a:lnTo>
                  <a:lnTo>
                    <a:pt x="193" y="136"/>
                  </a:lnTo>
                  <a:lnTo>
                    <a:pt x="194" y="135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30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5"/>
                  </a:lnTo>
                  <a:lnTo>
                    <a:pt x="197" y="123"/>
                  </a:lnTo>
                  <a:lnTo>
                    <a:pt x="198" y="121"/>
                  </a:lnTo>
                  <a:lnTo>
                    <a:pt x="198" y="120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199" y="113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6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67" name="Rectangle 64"/>
            <p:cNvSpPr>
              <a:spLocks noChangeArrowheads="1"/>
            </p:cNvSpPr>
            <p:nvPr/>
          </p:nvSpPr>
          <p:spPr bwMode="auto">
            <a:xfrm>
              <a:off x="4987926" y="4209008"/>
              <a:ext cx="5397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ansbig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Freeform 65"/>
            <p:cNvSpPr>
              <a:spLocks/>
            </p:cNvSpPr>
            <p:nvPr/>
          </p:nvSpPr>
          <p:spPr bwMode="auto">
            <a:xfrm>
              <a:off x="4387851" y="4942433"/>
              <a:ext cx="966788" cy="965200"/>
            </a:xfrm>
            <a:custGeom>
              <a:avLst/>
              <a:gdLst>
                <a:gd name="T0" fmla="*/ 200 w 200"/>
                <a:gd name="T1" fmla="*/ 91 h 200"/>
                <a:gd name="T2" fmla="*/ 198 w 200"/>
                <a:gd name="T3" fmla="*/ 81 h 200"/>
                <a:gd name="T4" fmla="*/ 196 w 200"/>
                <a:gd name="T5" fmla="*/ 71 h 200"/>
                <a:gd name="T6" fmla="*/ 192 w 200"/>
                <a:gd name="T7" fmla="*/ 61 h 200"/>
                <a:gd name="T8" fmla="*/ 188 w 200"/>
                <a:gd name="T9" fmla="*/ 52 h 200"/>
                <a:gd name="T10" fmla="*/ 182 w 200"/>
                <a:gd name="T11" fmla="*/ 43 h 200"/>
                <a:gd name="T12" fmla="*/ 176 w 200"/>
                <a:gd name="T13" fmla="*/ 34 h 200"/>
                <a:gd name="T14" fmla="*/ 169 w 200"/>
                <a:gd name="T15" fmla="*/ 27 h 200"/>
                <a:gd name="T16" fmla="*/ 160 w 200"/>
                <a:gd name="T17" fmla="*/ 20 h 200"/>
                <a:gd name="T18" fmla="*/ 152 w 200"/>
                <a:gd name="T19" fmla="*/ 14 h 200"/>
                <a:gd name="T20" fmla="*/ 143 w 200"/>
                <a:gd name="T21" fmla="*/ 9 h 200"/>
                <a:gd name="T22" fmla="*/ 133 w 200"/>
                <a:gd name="T23" fmla="*/ 5 h 200"/>
                <a:gd name="T24" fmla="*/ 123 w 200"/>
                <a:gd name="T25" fmla="*/ 3 h 200"/>
                <a:gd name="T26" fmla="*/ 112 w 200"/>
                <a:gd name="T27" fmla="*/ 1 h 200"/>
                <a:gd name="T28" fmla="*/ 102 w 200"/>
                <a:gd name="T29" fmla="*/ 0 h 200"/>
                <a:gd name="T30" fmla="*/ 92 w 200"/>
                <a:gd name="T31" fmla="*/ 0 h 200"/>
                <a:gd name="T32" fmla="*/ 81 w 200"/>
                <a:gd name="T33" fmla="*/ 2 h 200"/>
                <a:gd name="T34" fmla="*/ 71 w 200"/>
                <a:gd name="T35" fmla="*/ 4 h 200"/>
                <a:gd name="T36" fmla="*/ 61 w 200"/>
                <a:gd name="T37" fmla="*/ 8 h 200"/>
                <a:gd name="T38" fmla="*/ 52 w 200"/>
                <a:gd name="T39" fmla="*/ 12 h 200"/>
                <a:gd name="T40" fmla="*/ 43 w 200"/>
                <a:gd name="T41" fmla="*/ 18 h 200"/>
                <a:gd name="T42" fmla="*/ 35 w 200"/>
                <a:gd name="T43" fmla="*/ 25 h 200"/>
                <a:gd name="T44" fmla="*/ 27 w 200"/>
                <a:gd name="T45" fmla="*/ 32 h 200"/>
                <a:gd name="T46" fmla="*/ 20 w 200"/>
                <a:gd name="T47" fmla="*/ 40 h 200"/>
                <a:gd name="T48" fmla="*/ 14 w 200"/>
                <a:gd name="T49" fmla="*/ 49 h 200"/>
                <a:gd name="T50" fmla="*/ 10 w 200"/>
                <a:gd name="T51" fmla="*/ 58 h 200"/>
                <a:gd name="T52" fmla="*/ 6 w 200"/>
                <a:gd name="T53" fmla="*/ 68 h 200"/>
                <a:gd name="T54" fmla="*/ 3 w 200"/>
                <a:gd name="T55" fmla="*/ 78 h 200"/>
                <a:gd name="T56" fmla="*/ 1 w 200"/>
                <a:gd name="T57" fmla="*/ 88 h 200"/>
                <a:gd name="T58" fmla="*/ 0 w 200"/>
                <a:gd name="T59" fmla="*/ 98 h 200"/>
                <a:gd name="T60" fmla="*/ 1 w 200"/>
                <a:gd name="T61" fmla="*/ 109 h 200"/>
                <a:gd name="T62" fmla="*/ 2 w 200"/>
                <a:gd name="T63" fmla="*/ 119 h 200"/>
                <a:gd name="T64" fmla="*/ 5 w 200"/>
                <a:gd name="T65" fmla="*/ 129 h 200"/>
                <a:gd name="T66" fmla="*/ 8 w 200"/>
                <a:gd name="T67" fmla="*/ 139 h 200"/>
                <a:gd name="T68" fmla="*/ 13 w 200"/>
                <a:gd name="T69" fmla="*/ 149 h 200"/>
                <a:gd name="T70" fmla="*/ 18 w 200"/>
                <a:gd name="T71" fmla="*/ 158 h 200"/>
                <a:gd name="T72" fmla="*/ 25 w 200"/>
                <a:gd name="T73" fmla="*/ 166 h 200"/>
                <a:gd name="T74" fmla="*/ 32 w 200"/>
                <a:gd name="T75" fmla="*/ 173 h 200"/>
                <a:gd name="T76" fmla="*/ 40 w 200"/>
                <a:gd name="T77" fmla="*/ 180 h 200"/>
                <a:gd name="T78" fmla="*/ 49 w 200"/>
                <a:gd name="T79" fmla="*/ 186 h 200"/>
                <a:gd name="T80" fmla="*/ 58 w 200"/>
                <a:gd name="T81" fmla="*/ 191 h 200"/>
                <a:gd name="T82" fmla="*/ 68 w 200"/>
                <a:gd name="T83" fmla="*/ 195 h 200"/>
                <a:gd name="T84" fmla="*/ 78 w 200"/>
                <a:gd name="T85" fmla="*/ 198 h 200"/>
                <a:gd name="T86" fmla="*/ 88 w 200"/>
                <a:gd name="T87" fmla="*/ 200 h 200"/>
                <a:gd name="T88" fmla="*/ 99 w 200"/>
                <a:gd name="T89" fmla="*/ 200 h 200"/>
                <a:gd name="T90" fmla="*/ 109 w 200"/>
                <a:gd name="T91" fmla="*/ 200 h 200"/>
                <a:gd name="T92" fmla="*/ 119 w 200"/>
                <a:gd name="T93" fmla="*/ 198 h 200"/>
                <a:gd name="T94" fmla="*/ 130 w 200"/>
                <a:gd name="T95" fmla="*/ 196 h 200"/>
                <a:gd name="T96" fmla="*/ 139 w 200"/>
                <a:gd name="T97" fmla="*/ 192 h 200"/>
                <a:gd name="T98" fmla="*/ 149 w 200"/>
                <a:gd name="T99" fmla="*/ 188 h 200"/>
                <a:gd name="T100" fmla="*/ 158 w 200"/>
                <a:gd name="T101" fmla="*/ 182 h 200"/>
                <a:gd name="T102" fmla="*/ 166 w 200"/>
                <a:gd name="T103" fmla="*/ 176 h 200"/>
                <a:gd name="T104" fmla="*/ 173 w 200"/>
                <a:gd name="T105" fmla="*/ 168 h 200"/>
                <a:gd name="T106" fmla="*/ 180 w 200"/>
                <a:gd name="T107" fmla="*/ 160 h 200"/>
                <a:gd name="T108" fmla="*/ 186 w 200"/>
                <a:gd name="T109" fmla="*/ 152 h 200"/>
                <a:gd name="T110" fmla="*/ 191 w 200"/>
                <a:gd name="T111" fmla="*/ 142 h 200"/>
                <a:gd name="T112" fmla="*/ 195 w 200"/>
                <a:gd name="T113" fmla="*/ 133 h 200"/>
                <a:gd name="T114" fmla="*/ 198 w 200"/>
                <a:gd name="T115" fmla="*/ 123 h 200"/>
                <a:gd name="T116" fmla="*/ 200 w 200"/>
                <a:gd name="T117" fmla="*/ 112 h 200"/>
                <a:gd name="T118" fmla="*/ 200 w 200"/>
                <a:gd name="T119" fmla="*/ 102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00" h="200">
                  <a:moveTo>
                    <a:pt x="200" y="100"/>
                  </a:moveTo>
                  <a:lnTo>
                    <a:pt x="200" y="98"/>
                  </a:lnTo>
                  <a:lnTo>
                    <a:pt x="200" y="97"/>
                  </a:lnTo>
                  <a:lnTo>
                    <a:pt x="200" y="95"/>
                  </a:lnTo>
                  <a:lnTo>
                    <a:pt x="200" y="93"/>
                  </a:lnTo>
                  <a:lnTo>
                    <a:pt x="200" y="91"/>
                  </a:lnTo>
                  <a:lnTo>
                    <a:pt x="200" y="90"/>
                  </a:lnTo>
                  <a:lnTo>
                    <a:pt x="200" y="88"/>
                  </a:lnTo>
                  <a:lnTo>
                    <a:pt x="199" y="86"/>
                  </a:lnTo>
                  <a:lnTo>
                    <a:pt x="199" y="84"/>
                  </a:lnTo>
                  <a:lnTo>
                    <a:pt x="199" y="83"/>
                  </a:lnTo>
                  <a:lnTo>
                    <a:pt x="198" y="81"/>
                  </a:lnTo>
                  <a:lnTo>
                    <a:pt x="198" y="79"/>
                  </a:lnTo>
                  <a:lnTo>
                    <a:pt x="198" y="78"/>
                  </a:lnTo>
                  <a:lnTo>
                    <a:pt x="197" y="76"/>
                  </a:lnTo>
                  <a:lnTo>
                    <a:pt x="197" y="74"/>
                  </a:lnTo>
                  <a:lnTo>
                    <a:pt x="196" y="73"/>
                  </a:lnTo>
                  <a:lnTo>
                    <a:pt x="196" y="71"/>
                  </a:lnTo>
                  <a:lnTo>
                    <a:pt x="195" y="69"/>
                  </a:lnTo>
                  <a:lnTo>
                    <a:pt x="195" y="68"/>
                  </a:lnTo>
                  <a:lnTo>
                    <a:pt x="194" y="66"/>
                  </a:lnTo>
                  <a:lnTo>
                    <a:pt x="194" y="64"/>
                  </a:lnTo>
                  <a:lnTo>
                    <a:pt x="193" y="63"/>
                  </a:lnTo>
                  <a:lnTo>
                    <a:pt x="192" y="61"/>
                  </a:lnTo>
                  <a:lnTo>
                    <a:pt x="192" y="59"/>
                  </a:lnTo>
                  <a:lnTo>
                    <a:pt x="191" y="58"/>
                  </a:lnTo>
                  <a:lnTo>
                    <a:pt x="190" y="56"/>
                  </a:lnTo>
                  <a:lnTo>
                    <a:pt x="189" y="55"/>
                  </a:lnTo>
                  <a:lnTo>
                    <a:pt x="189" y="53"/>
                  </a:lnTo>
                  <a:lnTo>
                    <a:pt x="188" y="52"/>
                  </a:lnTo>
                  <a:lnTo>
                    <a:pt x="187" y="50"/>
                  </a:lnTo>
                  <a:lnTo>
                    <a:pt x="186" y="49"/>
                  </a:lnTo>
                  <a:lnTo>
                    <a:pt x="185" y="47"/>
                  </a:lnTo>
                  <a:lnTo>
                    <a:pt x="184" y="46"/>
                  </a:lnTo>
                  <a:lnTo>
                    <a:pt x="183" y="44"/>
                  </a:lnTo>
                  <a:lnTo>
                    <a:pt x="182" y="43"/>
                  </a:lnTo>
                  <a:lnTo>
                    <a:pt x="181" y="41"/>
                  </a:lnTo>
                  <a:lnTo>
                    <a:pt x="180" y="40"/>
                  </a:lnTo>
                  <a:lnTo>
                    <a:pt x="179" y="38"/>
                  </a:lnTo>
                  <a:lnTo>
                    <a:pt x="178" y="37"/>
                  </a:lnTo>
                  <a:lnTo>
                    <a:pt x="177" y="36"/>
                  </a:lnTo>
                  <a:lnTo>
                    <a:pt x="176" y="34"/>
                  </a:lnTo>
                  <a:lnTo>
                    <a:pt x="175" y="33"/>
                  </a:lnTo>
                  <a:lnTo>
                    <a:pt x="173" y="32"/>
                  </a:lnTo>
                  <a:lnTo>
                    <a:pt x="172" y="31"/>
                  </a:lnTo>
                  <a:lnTo>
                    <a:pt x="171" y="29"/>
                  </a:lnTo>
                  <a:lnTo>
                    <a:pt x="170" y="28"/>
                  </a:lnTo>
                  <a:lnTo>
                    <a:pt x="169" y="27"/>
                  </a:lnTo>
                  <a:lnTo>
                    <a:pt x="167" y="26"/>
                  </a:lnTo>
                  <a:lnTo>
                    <a:pt x="166" y="25"/>
                  </a:lnTo>
                  <a:lnTo>
                    <a:pt x="165" y="23"/>
                  </a:lnTo>
                  <a:lnTo>
                    <a:pt x="163" y="22"/>
                  </a:lnTo>
                  <a:lnTo>
                    <a:pt x="162" y="21"/>
                  </a:lnTo>
                  <a:lnTo>
                    <a:pt x="160" y="20"/>
                  </a:lnTo>
                  <a:lnTo>
                    <a:pt x="159" y="19"/>
                  </a:lnTo>
                  <a:lnTo>
                    <a:pt x="158" y="18"/>
                  </a:lnTo>
                  <a:lnTo>
                    <a:pt x="156" y="17"/>
                  </a:lnTo>
                  <a:lnTo>
                    <a:pt x="155" y="16"/>
                  </a:lnTo>
                  <a:lnTo>
                    <a:pt x="153" y="15"/>
                  </a:lnTo>
                  <a:lnTo>
                    <a:pt x="152" y="14"/>
                  </a:lnTo>
                  <a:lnTo>
                    <a:pt x="150" y="13"/>
                  </a:lnTo>
                  <a:lnTo>
                    <a:pt x="149" y="12"/>
                  </a:lnTo>
                  <a:lnTo>
                    <a:pt x="147" y="12"/>
                  </a:lnTo>
                  <a:lnTo>
                    <a:pt x="146" y="11"/>
                  </a:lnTo>
                  <a:lnTo>
                    <a:pt x="144" y="10"/>
                  </a:lnTo>
                  <a:lnTo>
                    <a:pt x="143" y="9"/>
                  </a:lnTo>
                  <a:lnTo>
                    <a:pt x="141" y="9"/>
                  </a:lnTo>
                  <a:lnTo>
                    <a:pt x="139" y="8"/>
                  </a:lnTo>
                  <a:lnTo>
                    <a:pt x="138" y="7"/>
                  </a:lnTo>
                  <a:lnTo>
                    <a:pt x="136" y="7"/>
                  </a:lnTo>
                  <a:lnTo>
                    <a:pt x="134" y="6"/>
                  </a:lnTo>
                  <a:lnTo>
                    <a:pt x="133" y="5"/>
                  </a:lnTo>
                  <a:lnTo>
                    <a:pt x="131" y="5"/>
                  </a:lnTo>
                  <a:lnTo>
                    <a:pt x="130" y="4"/>
                  </a:lnTo>
                  <a:lnTo>
                    <a:pt x="128" y="4"/>
                  </a:lnTo>
                  <a:lnTo>
                    <a:pt x="126" y="3"/>
                  </a:lnTo>
                  <a:lnTo>
                    <a:pt x="124" y="3"/>
                  </a:lnTo>
                  <a:lnTo>
                    <a:pt x="123" y="3"/>
                  </a:lnTo>
                  <a:lnTo>
                    <a:pt x="121" y="2"/>
                  </a:lnTo>
                  <a:lnTo>
                    <a:pt x="119" y="2"/>
                  </a:lnTo>
                  <a:lnTo>
                    <a:pt x="118" y="1"/>
                  </a:lnTo>
                  <a:lnTo>
                    <a:pt x="116" y="1"/>
                  </a:lnTo>
                  <a:lnTo>
                    <a:pt x="114" y="1"/>
                  </a:lnTo>
                  <a:lnTo>
                    <a:pt x="112" y="1"/>
                  </a:lnTo>
                  <a:lnTo>
                    <a:pt x="111" y="0"/>
                  </a:lnTo>
                  <a:lnTo>
                    <a:pt x="109" y="0"/>
                  </a:lnTo>
                  <a:lnTo>
                    <a:pt x="107" y="0"/>
                  </a:lnTo>
                  <a:lnTo>
                    <a:pt x="105" y="0"/>
                  </a:lnTo>
                  <a:lnTo>
                    <a:pt x="104" y="0"/>
                  </a:lnTo>
                  <a:lnTo>
                    <a:pt x="102" y="0"/>
                  </a:lnTo>
                  <a:lnTo>
                    <a:pt x="100" y="0"/>
                  </a:lnTo>
                  <a:lnTo>
                    <a:pt x="99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3" y="0"/>
                  </a:lnTo>
                  <a:lnTo>
                    <a:pt x="92" y="0"/>
                  </a:lnTo>
                  <a:lnTo>
                    <a:pt x="90" y="0"/>
                  </a:lnTo>
                  <a:lnTo>
                    <a:pt x="88" y="1"/>
                  </a:lnTo>
                  <a:lnTo>
                    <a:pt x="86" y="1"/>
                  </a:lnTo>
                  <a:lnTo>
                    <a:pt x="85" y="1"/>
                  </a:lnTo>
                  <a:lnTo>
                    <a:pt x="83" y="1"/>
                  </a:lnTo>
                  <a:lnTo>
                    <a:pt x="81" y="2"/>
                  </a:lnTo>
                  <a:lnTo>
                    <a:pt x="79" y="2"/>
                  </a:lnTo>
                  <a:lnTo>
                    <a:pt x="78" y="3"/>
                  </a:lnTo>
                  <a:lnTo>
                    <a:pt x="76" y="3"/>
                  </a:lnTo>
                  <a:lnTo>
                    <a:pt x="74" y="3"/>
                  </a:lnTo>
                  <a:lnTo>
                    <a:pt x="73" y="4"/>
                  </a:lnTo>
                  <a:lnTo>
                    <a:pt x="71" y="4"/>
                  </a:lnTo>
                  <a:lnTo>
                    <a:pt x="69" y="5"/>
                  </a:lnTo>
                  <a:lnTo>
                    <a:pt x="68" y="5"/>
                  </a:lnTo>
                  <a:lnTo>
                    <a:pt x="66" y="6"/>
                  </a:lnTo>
                  <a:lnTo>
                    <a:pt x="64" y="7"/>
                  </a:lnTo>
                  <a:lnTo>
                    <a:pt x="63" y="7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8" y="9"/>
                  </a:lnTo>
                  <a:lnTo>
                    <a:pt x="56" y="10"/>
                  </a:lnTo>
                  <a:lnTo>
                    <a:pt x="55" y="11"/>
                  </a:lnTo>
                  <a:lnTo>
                    <a:pt x="53" y="12"/>
                  </a:lnTo>
                  <a:lnTo>
                    <a:pt x="52" y="12"/>
                  </a:lnTo>
                  <a:lnTo>
                    <a:pt x="50" y="13"/>
                  </a:lnTo>
                  <a:lnTo>
                    <a:pt x="49" y="14"/>
                  </a:lnTo>
                  <a:lnTo>
                    <a:pt x="47" y="15"/>
                  </a:lnTo>
                  <a:lnTo>
                    <a:pt x="46" y="16"/>
                  </a:lnTo>
                  <a:lnTo>
                    <a:pt x="44" y="17"/>
                  </a:lnTo>
                  <a:lnTo>
                    <a:pt x="43" y="18"/>
                  </a:lnTo>
                  <a:lnTo>
                    <a:pt x="41" y="19"/>
                  </a:lnTo>
                  <a:lnTo>
                    <a:pt x="40" y="20"/>
                  </a:lnTo>
                  <a:lnTo>
                    <a:pt x="39" y="21"/>
                  </a:lnTo>
                  <a:lnTo>
                    <a:pt x="37" y="22"/>
                  </a:lnTo>
                  <a:lnTo>
                    <a:pt x="36" y="23"/>
                  </a:lnTo>
                  <a:lnTo>
                    <a:pt x="35" y="25"/>
                  </a:lnTo>
                  <a:lnTo>
                    <a:pt x="33" y="26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29" y="29"/>
                  </a:lnTo>
                  <a:lnTo>
                    <a:pt x="28" y="31"/>
                  </a:lnTo>
                  <a:lnTo>
                    <a:pt x="27" y="32"/>
                  </a:lnTo>
                  <a:lnTo>
                    <a:pt x="26" y="33"/>
                  </a:lnTo>
                  <a:lnTo>
                    <a:pt x="25" y="34"/>
                  </a:lnTo>
                  <a:lnTo>
                    <a:pt x="24" y="36"/>
                  </a:lnTo>
                  <a:lnTo>
                    <a:pt x="22" y="37"/>
                  </a:lnTo>
                  <a:lnTo>
                    <a:pt x="21" y="38"/>
                  </a:lnTo>
                  <a:lnTo>
                    <a:pt x="20" y="40"/>
                  </a:lnTo>
                  <a:lnTo>
                    <a:pt x="19" y="41"/>
                  </a:lnTo>
                  <a:lnTo>
                    <a:pt x="18" y="43"/>
                  </a:lnTo>
                  <a:lnTo>
                    <a:pt x="17" y="44"/>
                  </a:lnTo>
                  <a:lnTo>
                    <a:pt x="16" y="46"/>
                  </a:lnTo>
                  <a:lnTo>
                    <a:pt x="15" y="47"/>
                  </a:lnTo>
                  <a:lnTo>
                    <a:pt x="14" y="49"/>
                  </a:lnTo>
                  <a:lnTo>
                    <a:pt x="14" y="50"/>
                  </a:lnTo>
                  <a:lnTo>
                    <a:pt x="13" y="52"/>
                  </a:lnTo>
                  <a:lnTo>
                    <a:pt x="12" y="53"/>
                  </a:lnTo>
                  <a:lnTo>
                    <a:pt x="11" y="55"/>
                  </a:lnTo>
                  <a:lnTo>
                    <a:pt x="10" y="56"/>
                  </a:lnTo>
                  <a:lnTo>
                    <a:pt x="10" y="58"/>
                  </a:lnTo>
                  <a:lnTo>
                    <a:pt x="9" y="59"/>
                  </a:lnTo>
                  <a:lnTo>
                    <a:pt x="8" y="61"/>
                  </a:lnTo>
                  <a:lnTo>
                    <a:pt x="7" y="63"/>
                  </a:lnTo>
                  <a:lnTo>
                    <a:pt x="7" y="64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5" y="69"/>
                  </a:lnTo>
                  <a:lnTo>
                    <a:pt x="5" y="71"/>
                  </a:lnTo>
                  <a:lnTo>
                    <a:pt x="4" y="73"/>
                  </a:lnTo>
                  <a:lnTo>
                    <a:pt x="4" y="74"/>
                  </a:lnTo>
                  <a:lnTo>
                    <a:pt x="3" y="76"/>
                  </a:lnTo>
                  <a:lnTo>
                    <a:pt x="3" y="78"/>
                  </a:lnTo>
                  <a:lnTo>
                    <a:pt x="2" y="79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1" y="84"/>
                  </a:lnTo>
                  <a:lnTo>
                    <a:pt x="1" y="86"/>
                  </a:lnTo>
                  <a:lnTo>
                    <a:pt x="1" y="88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0" y="93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2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7"/>
                  </a:lnTo>
                  <a:lnTo>
                    <a:pt x="1" y="109"/>
                  </a:lnTo>
                  <a:lnTo>
                    <a:pt x="1" y="111"/>
                  </a:lnTo>
                  <a:lnTo>
                    <a:pt x="1" y="112"/>
                  </a:lnTo>
                  <a:lnTo>
                    <a:pt x="1" y="114"/>
                  </a:lnTo>
                  <a:lnTo>
                    <a:pt x="1" y="116"/>
                  </a:lnTo>
                  <a:lnTo>
                    <a:pt x="2" y="118"/>
                  </a:lnTo>
                  <a:lnTo>
                    <a:pt x="2" y="119"/>
                  </a:lnTo>
                  <a:lnTo>
                    <a:pt x="2" y="121"/>
                  </a:lnTo>
                  <a:lnTo>
                    <a:pt x="3" y="123"/>
                  </a:lnTo>
                  <a:lnTo>
                    <a:pt x="3" y="124"/>
                  </a:lnTo>
                  <a:lnTo>
                    <a:pt x="4" y="126"/>
                  </a:lnTo>
                  <a:lnTo>
                    <a:pt x="4" y="128"/>
                  </a:lnTo>
                  <a:lnTo>
                    <a:pt x="5" y="129"/>
                  </a:lnTo>
                  <a:lnTo>
                    <a:pt x="5" y="131"/>
                  </a:lnTo>
                  <a:lnTo>
                    <a:pt x="6" y="133"/>
                  </a:lnTo>
                  <a:lnTo>
                    <a:pt x="6" y="134"/>
                  </a:lnTo>
                  <a:lnTo>
                    <a:pt x="7" y="136"/>
                  </a:lnTo>
                  <a:lnTo>
                    <a:pt x="7" y="138"/>
                  </a:lnTo>
                  <a:lnTo>
                    <a:pt x="8" y="139"/>
                  </a:lnTo>
                  <a:lnTo>
                    <a:pt x="9" y="141"/>
                  </a:lnTo>
                  <a:lnTo>
                    <a:pt x="10" y="142"/>
                  </a:lnTo>
                  <a:lnTo>
                    <a:pt x="10" y="144"/>
                  </a:lnTo>
                  <a:lnTo>
                    <a:pt x="11" y="146"/>
                  </a:lnTo>
                  <a:lnTo>
                    <a:pt x="12" y="147"/>
                  </a:lnTo>
                  <a:lnTo>
                    <a:pt x="13" y="149"/>
                  </a:lnTo>
                  <a:lnTo>
                    <a:pt x="14" y="150"/>
                  </a:lnTo>
                  <a:lnTo>
                    <a:pt x="14" y="152"/>
                  </a:lnTo>
                  <a:lnTo>
                    <a:pt x="15" y="153"/>
                  </a:lnTo>
                  <a:lnTo>
                    <a:pt x="16" y="155"/>
                  </a:lnTo>
                  <a:lnTo>
                    <a:pt x="17" y="156"/>
                  </a:lnTo>
                  <a:lnTo>
                    <a:pt x="18" y="158"/>
                  </a:lnTo>
                  <a:lnTo>
                    <a:pt x="19" y="159"/>
                  </a:lnTo>
                  <a:lnTo>
                    <a:pt x="20" y="160"/>
                  </a:lnTo>
                  <a:lnTo>
                    <a:pt x="21" y="162"/>
                  </a:lnTo>
                  <a:lnTo>
                    <a:pt x="22" y="163"/>
                  </a:lnTo>
                  <a:lnTo>
                    <a:pt x="24" y="165"/>
                  </a:lnTo>
                  <a:lnTo>
                    <a:pt x="25" y="166"/>
                  </a:lnTo>
                  <a:lnTo>
                    <a:pt x="26" y="167"/>
                  </a:lnTo>
                  <a:lnTo>
                    <a:pt x="27" y="168"/>
                  </a:lnTo>
                  <a:lnTo>
                    <a:pt x="28" y="170"/>
                  </a:lnTo>
                  <a:lnTo>
                    <a:pt x="29" y="171"/>
                  </a:lnTo>
                  <a:lnTo>
                    <a:pt x="31" y="172"/>
                  </a:lnTo>
                  <a:lnTo>
                    <a:pt x="32" y="173"/>
                  </a:lnTo>
                  <a:lnTo>
                    <a:pt x="33" y="175"/>
                  </a:lnTo>
                  <a:lnTo>
                    <a:pt x="35" y="176"/>
                  </a:lnTo>
                  <a:lnTo>
                    <a:pt x="36" y="177"/>
                  </a:lnTo>
                  <a:lnTo>
                    <a:pt x="37" y="178"/>
                  </a:lnTo>
                  <a:lnTo>
                    <a:pt x="39" y="179"/>
                  </a:lnTo>
                  <a:lnTo>
                    <a:pt x="40" y="180"/>
                  </a:lnTo>
                  <a:lnTo>
                    <a:pt x="41" y="181"/>
                  </a:lnTo>
                  <a:lnTo>
                    <a:pt x="43" y="182"/>
                  </a:lnTo>
                  <a:lnTo>
                    <a:pt x="44" y="183"/>
                  </a:lnTo>
                  <a:lnTo>
                    <a:pt x="46" y="184"/>
                  </a:lnTo>
                  <a:lnTo>
                    <a:pt x="47" y="185"/>
                  </a:lnTo>
                  <a:lnTo>
                    <a:pt x="49" y="186"/>
                  </a:lnTo>
                  <a:lnTo>
                    <a:pt x="50" y="187"/>
                  </a:lnTo>
                  <a:lnTo>
                    <a:pt x="52" y="188"/>
                  </a:lnTo>
                  <a:lnTo>
                    <a:pt x="53" y="189"/>
                  </a:lnTo>
                  <a:lnTo>
                    <a:pt x="55" y="189"/>
                  </a:lnTo>
                  <a:lnTo>
                    <a:pt x="56" y="190"/>
                  </a:lnTo>
                  <a:lnTo>
                    <a:pt x="58" y="191"/>
                  </a:lnTo>
                  <a:lnTo>
                    <a:pt x="60" y="192"/>
                  </a:lnTo>
                  <a:lnTo>
                    <a:pt x="61" y="192"/>
                  </a:lnTo>
                  <a:lnTo>
                    <a:pt x="63" y="193"/>
                  </a:lnTo>
                  <a:lnTo>
                    <a:pt x="64" y="194"/>
                  </a:lnTo>
                  <a:lnTo>
                    <a:pt x="66" y="194"/>
                  </a:lnTo>
                  <a:lnTo>
                    <a:pt x="68" y="195"/>
                  </a:lnTo>
                  <a:lnTo>
                    <a:pt x="69" y="195"/>
                  </a:lnTo>
                  <a:lnTo>
                    <a:pt x="71" y="196"/>
                  </a:lnTo>
                  <a:lnTo>
                    <a:pt x="73" y="196"/>
                  </a:lnTo>
                  <a:lnTo>
                    <a:pt x="74" y="197"/>
                  </a:lnTo>
                  <a:lnTo>
                    <a:pt x="76" y="197"/>
                  </a:lnTo>
                  <a:lnTo>
                    <a:pt x="78" y="198"/>
                  </a:lnTo>
                  <a:lnTo>
                    <a:pt x="79" y="198"/>
                  </a:lnTo>
                  <a:lnTo>
                    <a:pt x="81" y="198"/>
                  </a:lnTo>
                  <a:lnTo>
                    <a:pt x="83" y="199"/>
                  </a:lnTo>
                  <a:lnTo>
                    <a:pt x="85" y="199"/>
                  </a:lnTo>
                  <a:lnTo>
                    <a:pt x="86" y="199"/>
                  </a:lnTo>
                  <a:lnTo>
                    <a:pt x="88" y="200"/>
                  </a:lnTo>
                  <a:lnTo>
                    <a:pt x="90" y="200"/>
                  </a:lnTo>
                  <a:lnTo>
                    <a:pt x="92" y="200"/>
                  </a:lnTo>
                  <a:lnTo>
                    <a:pt x="93" y="200"/>
                  </a:lnTo>
                  <a:lnTo>
                    <a:pt x="95" y="200"/>
                  </a:lnTo>
                  <a:lnTo>
                    <a:pt x="97" y="200"/>
                  </a:lnTo>
                  <a:lnTo>
                    <a:pt x="99" y="200"/>
                  </a:lnTo>
                  <a:lnTo>
                    <a:pt x="100" y="200"/>
                  </a:lnTo>
                  <a:lnTo>
                    <a:pt x="102" y="200"/>
                  </a:lnTo>
                  <a:lnTo>
                    <a:pt x="104" y="200"/>
                  </a:lnTo>
                  <a:lnTo>
                    <a:pt x="105" y="200"/>
                  </a:lnTo>
                  <a:lnTo>
                    <a:pt x="107" y="200"/>
                  </a:lnTo>
                  <a:lnTo>
                    <a:pt x="109" y="200"/>
                  </a:lnTo>
                  <a:lnTo>
                    <a:pt x="111" y="200"/>
                  </a:lnTo>
                  <a:lnTo>
                    <a:pt x="112" y="200"/>
                  </a:lnTo>
                  <a:lnTo>
                    <a:pt x="114" y="199"/>
                  </a:lnTo>
                  <a:lnTo>
                    <a:pt x="116" y="199"/>
                  </a:lnTo>
                  <a:lnTo>
                    <a:pt x="118" y="199"/>
                  </a:lnTo>
                  <a:lnTo>
                    <a:pt x="119" y="198"/>
                  </a:lnTo>
                  <a:lnTo>
                    <a:pt x="121" y="198"/>
                  </a:lnTo>
                  <a:lnTo>
                    <a:pt x="123" y="198"/>
                  </a:lnTo>
                  <a:lnTo>
                    <a:pt x="124" y="197"/>
                  </a:lnTo>
                  <a:lnTo>
                    <a:pt x="126" y="197"/>
                  </a:lnTo>
                  <a:lnTo>
                    <a:pt x="128" y="196"/>
                  </a:lnTo>
                  <a:lnTo>
                    <a:pt x="130" y="196"/>
                  </a:lnTo>
                  <a:lnTo>
                    <a:pt x="131" y="195"/>
                  </a:lnTo>
                  <a:lnTo>
                    <a:pt x="133" y="195"/>
                  </a:lnTo>
                  <a:lnTo>
                    <a:pt x="134" y="194"/>
                  </a:lnTo>
                  <a:lnTo>
                    <a:pt x="136" y="194"/>
                  </a:lnTo>
                  <a:lnTo>
                    <a:pt x="138" y="193"/>
                  </a:lnTo>
                  <a:lnTo>
                    <a:pt x="139" y="192"/>
                  </a:lnTo>
                  <a:lnTo>
                    <a:pt x="141" y="192"/>
                  </a:lnTo>
                  <a:lnTo>
                    <a:pt x="143" y="191"/>
                  </a:lnTo>
                  <a:lnTo>
                    <a:pt x="144" y="190"/>
                  </a:lnTo>
                  <a:lnTo>
                    <a:pt x="146" y="189"/>
                  </a:lnTo>
                  <a:lnTo>
                    <a:pt x="147" y="189"/>
                  </a:lnTo>
                  <a:lnTo>
                    <a:pt x="149" y="188"/>
                  </a:lnTo>
                  <a:lnTo>
                    <a:pt x="150" y="187"/>
                  </a:lnTo>
                  <a:lnTo>
                    <a:pt x="152" y="186"/>
                  </a:lnTo>
                  <a:lnTo>
                    <a:pt x="153" y="185"/>
                  </a:lnTo>
                  <a:lnTo>
                    <a:pt x="155" y="184"/>
                  </a:lnTo>
                  <a:lnTo>
                    <a:pt x="156" y="183"/>
                  </a:lnTo>
                  <a:lnTo>
                    <a:pt x="158" y="182"/>
                  </a:lnTo>
                  <a:lnTo>
                    <a:pt x="159" y="181"/>
                  </a:lnTo>
                  <a:lnTo>
                    <a:pt x="160" y="180"/>
                  </a:lnTo>
                  <a:lnTo>
                    <a:pt x="162" y="179"/>
                  </a:lnTo>
                  <a:lnTo>
                    <a:pt x="163" y="178"/>
                  </a:lnTo>
                  <a:lnTo>
                    <a:pt x="165" y="177"/>
                  </a:lnTo>
                  <a:lnTo>
                    <a:pt x="166" y="176"/>
                  </a:lnTo>
                  <a:lnTo>
                    <a:pt x="167" y="175"/>
                  </a:lnTo>
                  <a:lnTo>
                    <a:pt x="169" y="173"/>
                  </a:lnTo>
                  <a:lnTo>
                    <a:pt x="170" y="172"/>
                  </a:lnTo>
                  <a:lnTo>
                    <a:pt x="171" y="171"/>
                  </a:lnTo>
                  <a:lnTo>
                    <a:pt x="172" y="170"/>
                  </a:lnTo>
                  <a:lnTo>
                    <a:pt x="173" y="168"/>
                  </a:lnTo>
                  <a:lnTo>
                    <a:pt x="175" y="167"/>
                  </a:lnTo>
                  <a:lnTo>
                    <a:pt x="176" y="166"/>
                  </a:lnTo>
                  <a:lnTo>
                    <a:pt x="177" y="165"/>
                  </a:lnTo>
                  <a:lnTo>
                    <a:pt x="178" y="163"/>
                  </a:lnTo>
                  <a:lnTo>
                    <a:pt x="179" y="162"/>
                  </a:lnTo>
                  <a:lnTo>
                    <a:pt x="180" y="160"/>
                  </a:lnTo>
                  <a:lnTo>
                    <a:pt x="181" y="159"/>
                  </a:lnTo>
                  <a:lnTo>
                    <a:pt x="182" y="158"/>
                  </a:lnTo>
                  <a:lnTo>
                    <a:pt x="183" y="156"/>
                  </a:lnTo>
                  <a:lnTo>
                    <a:pt x="184" y="155"/>
                  </a:lnTo>
                  <a:lnTo>
                    <a:pt x="185" y="153"/>
                  </a:lnTo>
                  <a:lnTo>
                    <a:pt x="186" y="152"/>
                  </a:lnTo>
                  <a:lnTo>
                    <a:pt x="187" y="150"/>
                  </a:lnTo>
                  <a:lnTo>
                    <a:pt x="188" y="149"/>
                  </a:lnTo>
                  <a:lnTo>
                    <a:pt x="189" y="147"/>
                  </a:lnTo>
                  <a:lnTo>
                    <a:pt x="189" y="146"/>
                  </a:lnTo>
                  <a:lnTo>
                    <a:pt x="190" y="144"/>
                  </a:lnTo>
                  <a:lnTo>
                    <a:pt x="191" y="142"/>
                  </a:lnTo>
                  <a:lnTo>
                    <a:pt x="192" y="141"/>
                  </a:lnTo>
                  <a:lnTo>
                    <a:pt x="192" y="139"/>
                  </a:lnTo>
                  <a:lnTo>
                    <a:pt x="193" y="138"/>
                  </a:lnTo>
                  <a:lnTo>
                    <a:pt x="194" y="136"/>
                  </a:lnTo>
                  <a:lnTo>
                    <a:pt x="194" y="134"/>
                  </a:lnTo>
                  <a:lnTo>
                    <a:pt x="195" y="133"/>
                  </a:lnTo>
                  <a:lnTo>
                    <a:pt x="195" y="131"/>
                  </a:lnTo>
                  <a:lnTo>
                    <a:pt x="196" y="129"/>
                  </a:lnTo>
                  <a:lnTo>
                    <a:pt x="196" y="128"/>
                  </a:lnTo>
                  <a:lnTo>
                    <a:pt x="197" y="126"/>
                  </a:lnTo>
                  <a:lnTo>
                    <a:pt x="197" y="124"/>
                  </a:lnTo>
                  <a:lnTo>
                    <a:pt x="198" y="123"/>
                  </a:lnTo>
                  <a:lnTo>
                    <a:pt x="198" y="121"/>
                  </a:lnTo>
                  <a:lnTo>
                    <a:pt x="198" y="119"/>
                  </a:lnTo>
                  <a:lnTo>
                    <a:pt x="199" y="118"/>
                  </a:lnTo>
                  <a:lnTo>
                    <a:pt x="199" y="116"/>
                  </a:lnTo>
                  <a:lnTo>
                    <a:pt x="199" y="114"/>
                  </a:lnTo>
                  <a:lnTo>
                    <a:pt x="200" y="112"/>
                  </a:lnTo>
                  <a:lnTo>
                    <a:pt x="200" y="111"/>
                  </a:lnTo>
                  <a:lnTo>
                    <a:pt x="200" y="109"/>
                  </a:lnTo>
                  <a:lnTo>
                    <a:pt x="200" y="107"/>
                  </a:lnTo>
                  <a:lnTo>
                    <a:pt x="200" y="105"/>
                  </a:lnTo>
                  <a:lnTo>
                    <a:pt x="200" y="104"/>
                  </a:lnTo>
                  <a:lnTo>
                    <a:pt x="200" y="102"/>
                  </a:lnTo>
                  <a:lnTo>
                    <a:pt x="200" y="10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69" name="Rectangle 66"/>
            <p:cNvSpPr>
              <a:spLocks noChangeArrowheads="1"/>
            </p:cNvSpPr>
            <p:nvPr/>
          </p:nvSpPr>
          <p:spPr bwMode="auto">
            <a:xfrm>
              <a:off x="4676776" y="5961608"/>
              <a:ext cx="3873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inz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69"/>
            <p:cNvSpPr>
              <a:spLocks noChangeArrowheads="1"/>
            </p:cNvSpPr>
            <p:nvPr/>
          </p:nvSpPr>
          <p:spPr bwMode="auto">
            <a:xfrm>
              <a:off x="4703763" y="5502821"/>
              <a:ext cx="3333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165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70"/>
            <p:cNvSpPr>
              <a:spLocks noChangeArrowheads="1"/>
            </p:cNvSpPr>
            <p:nvPr/>
          </p:nvSpPr>
          <p:spPr bwMode="auto">
            <a:xfrm>
              <a:off x="5224463" y="462810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57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71"/>
            <p:cNvSpPr>
              <a:spLocks noChangeArrowheads="1"/>
            </p:cNvSpPr>
            <p:nvPr/>
          </p:nvSpPr>
          <p:spPr bwMode="auto">
            <a:xfrm>
              <a:off x="5014913" y="5063083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5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72"/>
            <p:cNvSpPr>
              <a:spLocks noChangeArrowheads="1"/>
            </p:cNvSpPr>
            <p:nvPr/>
          </p:nvSpPr>
          <p:spPr bwMode="auto">
            <a:xfrm>
              <a:off x="4257676" y="4628108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86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ctangle 73"/>
            <p:cNvSpPr>
              <a:spLocks noChangeArrowheads="1"/>
            </p:cNvSpPr>
            <p:nvPr/>
          </p:nvSpPr>
          <p:spPr bwMode="auto">
            <a:xfrm>
              <a:off x="4532313" y="506308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78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ctangle 74"/>
            <p:cNvSpPr>
              <a:spLocks noChangeArrowheads="1"/>
            </p:cNvSpPr>
            <p:nvPr/>
          </p:nvSpPr>
          <p:spPr bwMode="auto">
            <a:xfrm>
              <a:off x="4773613" y="4663033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41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ctangle 75"/>
            <p:cNvSpPr>
              <a:spLocks noChangeArrowheads="1"/>
            </p:cNvSpPr>
            <p:nvPr/>
          </p:nvSpPr>
          <p:spPr bwMode="auto">
            <a:xfrm>
              <a:off x="4810126" y="4951958"/>
              <a:ext cx="120650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77"/>
            <p:cNvSpPr>
              <a:spLocks noChangeArrowheads="1"/>
            </p:cNvSpPr>
            <p:nvPr/>
          </p:nvSpPr>
          <p:spPr bwMode="auto">
            <a:xfrm>
              <a:off x="4703763" y="5590133"/>
              <a:ext cx="25648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122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Rectangle 78"/>
            <p:cNvSpPr>
              <a:spLocks noChangeArrowheads="1"/>
            </p:cNvSpPr>
            <p:nvPr/>
          </p:nvSpPr>
          <p:spPr bwMode="auto">
            <a:xfrm>
              <a:off x="5224463" y="4715421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sv-SE" altLang="sv-SE" sz="900" dirty="0" smtClean="0">
                  <a:solidFill>
                    <a:srgbClr val="0000FF"/>
                  </a:solidFill>
                </a:rPr>
                <a:t>40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Rectangle 79"/>
            <p:cNvSpPr>
              <a:spLocks noChangeArrowheads="1"/>
            </p:cNvSpPr>
            <p:nvPr/>
          </p:nvSpPr>
          <p:spPr bwMode="auto">
            <a:xfrm>
              <a:off x="5014913" y="5150396"/>
              <a:ext cx="1936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3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Rectangle 80"/>
            <p:cNvSpPr>
              <a:spLocks noChangeArrowheads="1"/>
            </p:cNvSpPr>
            <p:nvPr/>
          </p:nvSpPr>
          <p:spPr bwMode="auto">
            <a:xfrm>
              <a:off x="4257676" y="4715421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688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Rectangle 81"/>
            <p:cNvSpPr>
              <a:spLocks noChangeArrowheads="1"/>
            </p:cNvSpPr>
            <p:nvPr/>
          </p:nvSpPr>
          <p:spPr bwMode="auto">
            <a:xfrm>
              <a:off x="4532313" y="5150396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89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Rectangle 82"/>
            <p:cNvSpPr>
              <a:spLocks noChangeArrowheads="1"/>
            </p:cNvSpPr>
            <p:nvPr/>
          </p:nvSpPr>
          <p:spPr bwMode="auto">
            <a:xfrm>
              <a:off x="4773613" y="4748758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sv-SE" altLang="sv-SE" sz="900" dirty="0" smtClean="0">
                  <a:solidFill>
                    <a:srgbClr val="0000FF"/>
                  </a:solidFill>
                </a:rPr>
                <a:t>3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Rectangle 83"/>
            <p:cNvSpPr>
              <a:spLocks noChangeArrowheads="1"/>
            </p:cNvSpPr>
            <p:nvPr/>
          </p:nvSpPr>
          <p:spPr bwMode="auto">
            <a:xfrm>
              <a:off x="4773613" y="5039271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1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" name="Rechteck 4"/>
          <p:cNvSpPr/>
          <p:nvPr/>
        </p:nvSpPr>
        <p:spPr>
          <a:xfrm>
            <a:off x="767452" y="467543"/>
            <a:ext cx="532837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r>
              <a:rPr lang="en-US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Venn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rams for the number of probe sets significantly associated with MFS in the early </a:t>
            </a:r>
            <a:r>
              <a:rPr lang="en-US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late </a:t>
            </a:r>
            <a:r>
              <a:rPr lang="en-US" sz="10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iod </a:t>
            </a:r>
            <a:r>
              <a:rPr lang="en-US" sz="100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three analyzed node-negative, untreated breast cancer cohorts (p&lt;0.05). On the left hand side the number is given regardless of the hazard ratio in the three cohorts. On the right hand side the hazard ratio was considered;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number of probe sets significantly associated with MFS with hazard ratios &gt;1 in the respective cohort(s); </a:t>
            </a:r>
            <a:r>
              <a:rPr lang="en-US" sz="1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number of probe sets significantly associated with MFS with hazard ratios &lt;1 in the respective cohort(s). Therefore the overlap is smaller. In total 22283 probe sets were included in the analysis.</a:t>
            </a:r>
          </a:p>
        </p:txBody>
      </p:sp>
    </p:spTree>
    <p:extLst>
      <p:ext uri="{BB962C8B-B14F-4D97-AF65-F5344CB8AC3E}">
        <p14:creationId xmlns:p14="http://schemas.microsoft.com/office/powerpoint/2010/main" val="4232786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7</Words>
  <Application>Microsoft Office PowerPoint</Application>
  <PresentationFormat>Bildschirmpräsentation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Fakultät Statistik, TU Dortmu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irte Hellwig</dc:creator>
  <cp:lastModifiedBy>Birte Hellwig</cp:lastModifiedBy>
  <cp:revision>37</cp:revision>
  <dcterms:created xsi:type="dcterms:W3CDTF">2013-08-27T13:10:30Z</dcterms:created>
  <dcterms:modified xsi:type="dcterms:W3CDTF">2016-06-28T11:49:26Z</dcterms:modified>
</cp:coreProperties>
</file>